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57" r:id="rId3"/>
  </p:sldIdLst>
  <p:sldSz cx="12192000" cy="6858000"/>
  <p:notesSz cx="6858000" cy="9144000"/>
  <p:defaultTextStyle>
    <a:defPPr>
      <a:defRPr lang="es-EC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CC"/>
    <a:srgbClr val="FFFF00"/>
    <a:srgbClr val="FFFF66"/>
    <a:srgbClr val="FFFFCC"/>
    <a:srgbClr val="99CCFF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78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olina Clausell Terol" userId="8948be60-51bd-4f7e-9b21-feae715bf301" providerId="ADAL" clId="{0D0AA73B-4819-408B-9335-6D60281C0AED}"/>
    <pc:docChg chg="delSld">
      <pc:chgData name="Carolina Clausell Terol" userId="8948be60-51bd-4f7e-9b21-feae715bf301" providerId="ADAL" clId="{0D0AA73B-4819-408B-9335-6D60281C0AED}" dt="2023-04-27T15:14:00.329" v="3" actId="47"/>
      <pc:docMkLst>
        <pc:docMk/>
      </pc:docMkLst>
      <pc:sldChg chg="del">
        <pc:chgData name="Carolina Clausell Terol" userId="8948be60-51bd-4f7e-9b21-feae715bf301" providerId="ADAL" clId="{0D0AA73B-4819-408B-9335-6D60281C0AED}" dt="2023-04-27T15:13:59.699" v="2" actId="47"/>
        <pc:sldMkLst>
          <pc:docMk/>
          <pc:sldMk cId="1286981832" sldId="260"/>
        </pc:sldMkLst>
      </pc:sldChg>
      <pc:sldChg chg="del">
        <pc:chgData name="Carolina Clausell Terol" userId="8948be60-51bd-4f7e-9b21-feae715bf301" providerId="ADAL" clId="{0D0AA73B-4819-408B-9335-6D60281C0AED}" dt="2023-04-27T15:14:00.329" v="3" actId="47"/>
        <pc:sldMkLst>
          <pc:docMk/>
          <pc:sldMk cId="3656017910" sldId="265"/>
        </pc:sldMkLst>
      </pc:sldChg>
      <pc:sldChg chg="del">
        <pc:chgData name="Carolina Clausell Terol" userId="8948be60-51bd-4f7e-9b21-feae715bf301" providerId="ADAL" clId="{0D0AA73B-4819-408B-9335-6D60281C0AED}" dt="2023-04-27T15:13:58.481" v="0" actId="47"/>
        <pc:sldMkLst>
          <pc:docMk/>
          <pc:sldMk cId="2904532602" sldId="268"/>
        </pc:sldMkLst>
      </pc:sldChg>
      <pc:sldChg chg="del">
        <pc:chgData name="Carolina Clausell Terol" userId="8948be60-51bd-4f7e-9b21-feae715bf301" providerId="ADAL" clId="{0D0AA73B-4819-408B-9335-6D60281C0AED}" dt="2023-04-27T15:13:59.069" v="1" actId="47"/>
        <pc:sldMkLst>
          <pc:docMk/>
          <pc:sldMk cId="3181051673" sldId="270"/>
        </pc:sldMkLst>
      </pc:sldChg>
    </pc:docChg>
  </pc:docChgLst>
  <pc:docChgLst>
    <pc:chgData name="Carolina Clausell Terol" userId="8948be60-51bd-4f7e-9b21-feae715bf301" providerId="ADAL" clId="{5B82EBD8-B7AE-48E4-B581-99CDDBB3B2D8}"/>
    <pc:docChg chg="modSld">
      <pc:chgData name="Carolina Clausell Terol" userId="8948be60-51bd-4f7e-9b21-feae715bf301" providerId="ADAL" clId="{5B82EBD8-B7AE-48E4-B581-99CDDBB3B2D8}" dt="2023-04-27T15:09:16.365" v="0" actId="207"/>
      <pc:docMkLst>
        <pc:docMk/>
      </pc:docMkLst>
      <pc:sldChg chg="modSp mod">
        <pc:chgData name="Carolina Clausell Terol" userId="8948be60-51bd-4f7e-9b21-feae715bf301" providerId="ADAL" clId="{5B82EBD8-B7AE-48E4-B581-99CDDBB3B2D8}" dt="2023-04-27T15:09:16.365" v="0" actId="207"/>
        <pc:sldMkLst>
          <pc:docMk/>
          <pc:sldMk cId="1286981832" sldId="260"/>
        </pc:sldMkLst>
        <pc:spChg chg="mod">
          <ac:chgData name="Carolina Clausell Terol" userId="8948be60-51bd-4f7e-9b21-feae715bf301" providerId="ADAL" clId="{5B82EBD8-B7AE-48E4-B581-99CDDBB3B2D8}" dt="2023-04-27T15:09:16.365" v="0" actId="207"/>
          <ac:spMkLst>
            <pc:docMk/>
            <pc:sldMk cId="1286981832" sldId="260"/>
            <ac:spMk id="4" creationId="{00000000-0000-0000-0000-000000000000}"/>
          </ac:spMkLst>
        </pc:spChg>
      </pc:sldChg>
    </pc:docChg>
  </pc:docChgLst>
  <pc:docChgLst>
    <pc:chgData name="Aurelio Gómez Cadenas" userId="cdf62aad-1077-43dc-8b69-e6882d6d0aab" providerId="ADAL" clId="{3AAFB721-F51E-4504-8CF2-322126BFA205}"/>
    <pc:docChg chg="custSel modSld">
      <pc:chgData name="Aurelio Gómez Cadenas" userId="cdf62aad-1077-43dc-8b69-e6882d6d0aab" providerId="ADAL" clId="{3AAFB721-F51E-4504-8CF2-322126BFA205}" dt="2023-04-27T11:13:27.068" v="109" actId="207"/>
      <pc:docMkLst>
        <pc:docMk/>
      </pc:docMkLst>
      <pc:sldChg chg="modSp mod">
        <pc:chgData name="Aurelio Gómez Cadenas" userId="cdf62aad-1077-43dc-8b69-e6882d6d0aab" providerId="ADAL" clId="{3AAFB721-F51E-4504-8CF2-322126BFA205}" dt="2023-04-27T11:13:27.068" v="109" actId="207"/>
        <pc:sldMkLst>
          <pc:docMk/>
          <pc:sldMk cId="2904532602" sldId="268"/>
        </pc:sldMkLst>
        <pc:spChg chg="mod">
          <ac:chgData name="Aurelio Gómez Cadenas" userId="cdf62aad-1077-43dc-8b69-e6882d6d0aab" providerId="ADAL" clId="{3AAFB721-F51E-4504-8CF2-322126BFA205}" dt="2023-04-27T11:13:27.068" v="109" actId="207"/>
          <ac:spMkLst>
            <pc:docMk/>
            <pc:sldMk cId="2904532602" sldId="268"/>
            <ac:spMk id="4" creationId="{00000000-0000-0000-0000-000000000000}"/>
          </ac:spMkLst>
        </pc:spChg>
      </pc:sldChg>
      <pc:sldChg chg="modSp mod">
        <pc:chgData name="Aurelio Gómez Cadenas" userId="cdf62aad-1077-43dc-8b69-e6882d6d0aab" providerId="ADAL" clId="{3AAFB721-F51E-4504-8CF2-322126BFA205}" dt="2023-04-27T11:08:59.410" v="53" actId="6549"/>
        <pc:sldMkLst>
          <pc:docMk/>
          <pc:sldMk cId="3181051673" sldId="270"/>
        </pc:sldMkLst>
        <pc:spChg chg="mod">
          <ac:chgData name="Aurelio Gómez Cadenas" userId="cdf62aad-1077-43dc-8b69-e6882d6d0aab" providerId="ADAL" clId="{3AAFB721-F51E-4504-8CF2-322126BFA205}" dt="2023-04-27T11:08:59.410" v="53" actId="6549"/>
          <ac:spMkLst>
            <pc:docMk/>
            <pc:sldMk cId="3181051673" sldId="270"/>
            <ac:spMk id="112" creationId="{00000000-0000-0000-0000-000000000000}"/>
          </ac:spMkLst>
        </pc:spChg>
      </pc:sldChg>
    </pc:docChg>
  </pc:docChgLst>
</pc:chgInfo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ax="1920" units="cm"/>
          <inkml:channel name="Y" type="integer" max="1080" units="cm"/>
          <inkml:channel name="T" type="integer" max="2.14748E9" units="dev"/>
        </inkml:traceFormat>
        <inkml:channelProperties>
          <inkml:channelProperty channel="X" name="resolution" value="55.81395" units="1/cm"/>
          <inkml:channelProperty channel="Y" name="resolution" value="55.6701" units="1/cm"/>
          <inkml:channelProperty channel="T" name="resolution" value="1" units="1/dev"/>
        </inkml:channelProperties>
      </inkml:inkSource>
      <inkml:timestamp xml:id="ts0" timeString="2022-11-21T15:12:51.327"/>
    </inkml:context>
    <inkml:brush xml:id="br0">
      <inkml:brushProperty name="width" value="0.15875" units="cm"/>
      <inkml:brushProperty name="height" value="0.15875" units="cm"/>
      <inkml:brushProperty name="color" value="#FFD966"/>
      <inkml:brushProperty name="fitToCurve" value="1"/>
    </inkml:brush>
  </inkml:definitions>
  <inkml:trace contextRef="#ctx0" brushRef="#br0">-1102-907 0</inkml:trace>
  <inkml:trace contextRef="#ctx0" brushRef="#br0" timeOffset="1">-1397-858 0</inkml:trace>
  <inkml:trace contextRef="#ctx0" brushRef="#br0" timeOffset="2">-1358-583 0</inkml:trace>
  <inkml:trace contextRef="#ctx0" brushRef="#br0" timeOffset="3">-1346-1086 0</inkml:trace>
  <inkml:trace contextRef="#ctx0" brushRef="#br0" timeOffset="4">-1256-907 0</inkml:trace>
  <inkml:trace contextRef="#ctx0" brushRef="#br0" timeOffset="5">-1217-485 0</inkml:trace>
  <inkml:trace contextRef="#ctx0" brushRef="#br0" timeOffset="6">-1205-728 0</inkml:trace>
  <inkml:trace contextRef="#ctx0" brushRef="#br0" timeOffset="7">-1167-1134 0</inkml:trace>
  <inkml:trace contextRef="#ctx0" brushRef="#br0" timeOffset="8">-1115-372 0</inkml:trace>
  <inkml:trace contextRef="#ctx0" brushRef="#br0" timeOffset="9">-1077-696 0</inkml:trace>
  <inkml:trace contextRef="#ctx0" brushRef="#br0" timeOffset="10">-718-355 0</inkml:trace>
  <inkml:trace contextRef="#ctx0" brushRef="#br0" timeOffset="11">-718-1281 0</inkml:trace>
  <inkml:trace contextRef="#ctx0" brushRef="#br0" timeOffset="12">-1038-518 0</inkml:trace>
  <inkml:trace contextRef="#ctx0" brushRef="#br0" timeOffset="13">-1026-1167 0</inkml:trace>
  <inkml:trace contextRef="#ctx0" brushRef="#br0" timeOffset="14">-1000-307 0</inkml:trace>
  <inkml:trace contextRef="#ctx0" brushRef="#br0" timeOffset="15">-949-1297 0</inkml:trace>
  <inkml:trace contextRef="#ctx0" brushRef="#br0" timeOffset="16">-872-355 0</inkml:trace>
  <inkml:trace contextRef="#ctx0" brushRef="#br0" timeOffset="17">-859-1183 0</inkml:trace>
  <inkml:trace contextRef="#ctx0" brushRef="#br0" timeOffset="18">-551-306 0</inkml:trace>
  <inkml:trace contextRef="#ctx0" brushRef="#br0" timeOffset="19">-551-1313 0</inkml:trace>
  <inkml:trace contextRef="#ctx0" brushRef="#br0" timeOffset="20">-512-436 0</inkml:trace>
  <inkml:trace contextRef="#ctx0" brushRef="#br0" timeOffset="21">-410-1199 0</inkml:trace>
  <inkml:trace contextRef="#ctx0" brushRef="#br0" timeOffset="22">-385-323 0</inkml:trace>
  <inkml:trace contextRef="#ctx0" brushRef="#br0" timeOffset="23">-346-518 0</inkml:trace>
  <inkml:trace contextRef="#ctx0" brushRef="#br0" timeOffset="24">-269-1118 0</inkml:trace>
  <inkml:trace contextRef="#ctx0" brushRef="#br0" timeOffset="25">-257-923 0</inkml:trace>
  <inkml:trace contextRef="#ctx0" brushRef="#br0" timeOffset="26">-231-485 0</inkml:trace>
  <inkml:trace contextRef="#ctx0" brushRef="#br0" timeOffset="27">-219-696 0</inkml:trace>
  <inkml:trace contextRef="#ctx0" brushRef="#br0" timeOffset="28">-167-1102 0</inkml:trace>
  <inkml:trace contextRef="#ctx0" brushRef="#br0" timeOffset="29">-103-550 0</inkml:trace>
  <inkml:trace contextRef="#ctx0" brushRef="#br0" timeOffset="30">-90-858 0</inkml:trace>
  <inkml:trace contextRef="#ctx0" brushRef="#br0" timeOffset="31">-14-728 0</inkml:trace>
  <inkml:trace contextRef="#ctx0" brushRef="#br0" timeOffset="32">-14-1005 0</inkml:trace>
  <inkml:trace contextRef="#ctx0" brushRef="#br0" timeOffset="33">115-842 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ax="1920" units="cm"/>
          <inkml:channel name="Y" type="integer" max="1080" units="cm"/>
          <inkml:channel name="T" type="integer" max="2.14748E9" units="dev"/>
        </inkml:traceFormat>
        <inkml:channelProperties>
          <inkml:channelProperty channel="X" name="resolution" value="55.81395" units="1/cm"/>
          <inkml:channelProperty channel="Y" name="resolution" value="55.6701" units="1/cm"/>
          <inkml:channelProperty channel="T" name="resolution" value="1" units="1/dev"/>
        </inkml:channelProperties>
      </inkml:inkSource>
      <inkml:timestamp xml:id="ts0" timeString="2022-11-21T15:24:56.785"/>
    </inkml:context>
    <inkml:brush xml:id="br0">
      <inkml:brushProperty name="width" value="0.15875" units="cm"/>
      <inkml:brushProperty name="height" value="0.15875" units="cm"/>
      <inkml:brushProperty name="color" value="#FFD966"/>
      <inkml:brushProperty name="fitToCurve" value="1"/>
    </inkml:brush>
  </inkml:definitions>
  <inkml:trace contextRef="#ctx0" brushRef="#br0">-1102-907 0</inkml:trace>
  <inkml:trace contextRef="#ctx0" brushRef="#br0" timeOffset="1">-1397-858 0</inkml:trace>
  <inkml:trace contextRef="#ctx0" brushRef="#br0" timeOffset="2">-1358-583 0</inkml:trace>
  <inkml:trace contextRef="#ctx0" brushRef="#br0" timeOffset="3">-1346-1086 0</inkml:trace>
  <inkml:trace contextRef="#ctx0" brushRef="#br0" timeOffset="4">-1256-907 0</inkml:trace>
  <inkml:trace contextRef="#ctx0" brushRef="#br0" timeOffset="5">-1217-485 0</inkml:trace>
  <inkml:trace contextRef="#ctx0" brushRef="#br0" timeOffset="6">-1205-728 0</inkml:trace>
  <inkml:trace contextRef="#ctx0" brushRef="#br0" timeOffset="7">-1167-1134 0</inkml:trace>
  <inkml:trace contextRef="#ctx0" brushRef="#br0" timeOffset="8">-1115-372 0</inkml:trace>
  <inkml:trace contextRef="#ctx0" brushRef="#br0" timeOffset="9">-1077-696 0</inkml:trace>
  <inkml:trace contextRef="#ctx0" brushRef="#br0" timeOffset="10">-718-355 0</inkml:trace>
  <inkml:trace contextRef="#ctx0" brushRef="#br0" timeOffset="11">-718-1281 0</inkml:trace>
  <inkml:trace contextRef="#ctx0" brushRef="#br0" timeOffset="12">-1038-518 0</inkml:trace>
  <inkml:trace contextRef="#ctx0" brushRef="#br0" timeOffset="13">-1026-1167 0</inkml:trace>
  <inkml:trace contextRef="#ctx0" brushRef="#br0" timeOffset="14">-1000-307 0</inkml:trace>
  <inkml:trace contextRef="#ctx0" brushRef="#br0" timeOffset="15">-949-1297 0</inkml:trace>
  <inkml:trace contextRef="#ctx0" brushRef="#br0" timeOffset="16">-872-355 0</inkml:trace>
  <inkml:trace contextRef="#ctx0" brushRef="#br0" timeOffset="17">-859-1183 0</inkml:trace>
  <inkml:trace contextRef="#ctx0" brushRef="#br0" timeOffset="18">-552-306 0</inkml:trace>
  <inkml:trace contextRef="#ctx0" brushRef="#br0" timeOffset="19">-552-1313 0</inkml:trace>
  <inkml:trace contextRef="#ctx0" brushRef="#br0" timeOffset="20">-513-436 0</inkml:trace>
  <inkml:trace contextRef="#ctx0" brushRef="#br0" timeOffset="21">-411-1199 0</inkml:trace>
  <inkml:trace contextRef="#ctx0" brushRef="#br0" timeOffset="22">-386-323 0</inkml:trace>
  <inkml:trace contextRef="#ctx0" brushRef="#br0" timeOffset="23">-347-518 0</inkml:trace>
  <inkml:trace contextRef="#ctx0" brushRef="#br0" timeOffset="24">-270-1118 0</inkml:trace>
  <inkml:trace contextRef="#ctx0" brushRef="#br0" timeOffset="25">-258-923 0</inkml:trace>
  <inkml:trace contextRef="#ctx0" brushRef="#br0" timeOffset="26">-232-485 0</inkml:trace>
  <inkml:trace contextRef="#ctx0" brushRef="#br0" timeOffset="27">-220-696 0</inkml:trace>
  <inkml:trace contextRef="#ctx0" brushRef="#br0" timeOffset="28">-168-1102 0</inkml:trace>
  <inkml:trace contextRef="#ctx0" brushRef="#br0" timeOffset="29">-104-550 0</inkml:trace>
  <inkml:trace contextRef="#ctx0" brushRef="#br0" timeOffset="30">-91-858 0</inkml:trace>
  <inkml:trace contextRef="#ctx0" brushRef="#br0" timeOffset="31">-15-728 0</inkml:trace>
  <inkml:trace contextRef="#ctx0" brushRef="#br0" timeOffset="32">-15-1005 0</inkml:trace>
  <inkml:trace contextRef="#ctx0" brushRef="#br0" timeOffset="33">114-842 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ax="1920" units="cm"/>
          <inkml:channel name="Y" type="integer" max="1080" units="cm"/>
          <inkml:channel name="T" type="integer" max="2.14748E9" units="dev"/>
        </inkml:traceFormat>
        <inkml:channelProperties>
          <inkml:channelProperty channel="X" name="resolution" value="55.81395" units="1/cm"/>
          <inkml:channelProperty channel="Y" name="resolution" value="55.6701" units="1/cm"/>
          <inkml:channelProperty channel="T" name="resolution" value="1" units="1/dev"/>
        </inkml:channelProperties>
      </inkml:inkSource>
      <inkml:timestamp xml:id="ts0" timeString="2022-11-21T15:25:03.324"/>
    </inkml:context>
    <inkml:brush xml:id="br0">
      <inkml:brushProperty name="width" value="0.15875" units="cm"/>
      <inkml:brushProperty name="height" value="0.15875" units="cm"/>
      <inkml:brushProperty name="color" value="#FFD966"/>
      <inkml:brushProperty name="fitToCurve" value="1"/>
    </inkml:brush>
  </inkml:definitions>
  <inkml:trace contextRef="#ctx0" brushRef="#br0">-1102-907 0</inkml:trace>
  <inkml:trace contextRef="#ctx0" brushRef="#br0" timeOffset="1">-1397-858 0</inkml:trace>
  <inkml:trace contextRef="#ctx0" brushRef="#br0" timeOffset="2">-1358-583 0</inkml:trace>
  <inkml:trace contextRef="#ctx0" brushRef="#br0" timeOffset="3">-1346-1086 0</inkml:trace>
  <inkml:trace contextRef="#ctx0" brushRef="#br0" timeOffset="4">-1256-907 0</inkml:trace>
  <inkml:trace contextRef="#ctx0" brushRef="#br0" timeOffset="5">-1217-485 0</inkml:trace>
  <inkml:trace contextRef="#ctx0" brushRef="#br0" timeOffset="6">-1205-728 0</inkml:trace>
  <inkml:trace contextRef="#ctx0" brushRef="#br0" timeOffset="7">-1166-1134 0</inkml:trace>
  <inkml:trace contextRef="#ctx0" brushRef="#br0" timeOffset="8">-1115-372 0</inkml:trace>
  <inkml:trace contextRef="#ctx0" brushRef="#br0" timeOffset="9">-1077-696 0</inkml:trace>
  <inkml:trace contextRef="#ctx0" brushRef="#br0" timeOffset="10">-718-355 0</inkml:trace>
  <inkml:trace contextRef="#ctx0" brushRef="#br0" timeOffset="11">-718-1281 0</inkml:trace>
  <inkml:trace contextRef="#ctx0" brushRef="#br0" timeOffset="12">-1038-518 0</inkml:trace>
  <inkml:trace contextRef="#ctx0" brushRef="#br0" timeOffset="13">-1025-1167 0</inkml:trace>
  <inkml:trace contextRef="#ctx0" brushRef="#br0" timeOffset="14">-1000-307 0</inkml:trace>
  <inkml:trace contextRef="#ctx0" brushRef="#br0" timeOffset="15">-949-1297 0</inkml:trace>
  <inkml:trace contextRef="#ctx0" brushRef="#br0" timeOffset="16">-872-355 0</inkml:trace>
  <inkml:trace contextRef="#ctx0" brushRef="#br0" timeOffset="17">-859-1183 0</inkml:trace>
  <inkml:trace contextRef="#ctx0" brushRef="#br0" timeOffset="18">-553-306 0</inkml:trace>
  <inkml:trace contextRef="#ctx0" brushRef="#br0" timeOffset="19">-553-1313 0</inkml:trace>
  <inkml:trace contextRef="#ctx0" brushRef="#br0" timeOffset="20">-514-436 0</inkml:trace>
  <inkml:trace contextRef="#ctx0" brushRef="#br0" timeOffset="21">-412-1199 0</inkml:trace>
  <inkml:trace contextRef="#ctx0" brushRef="#br0" timeOffset="22">-386-323 0</inkml:trace>
  <inkml:trace contextRef="#ctx0" brushRef="#br0" timeOffset="23">-347-518 0</inkml:trace>
  <inkml:trace contextRef="#ctx0" brushRef="#br0" timeOffset="24">-271-1118 0</inkml:trace>
  <inkml:trace contextRef="#ctx0" brushRef="#br0" timeOffset="25">-258-923 0</inkml:trace>
  <inkml:trace contextRef="#ctx0" brushRef="#br0" timeOffset="26">-232-485 0</inkml:trace>
  <inkml:trace contextRef="#ctx0" brushRef="#br0" timeOffset="27">-220-696 0</inkml:trace>
  <inkml:trace contextRef="#ctx0" brushRef="#br0" timeOffset="28">-168-1102 0</inkml:trace>
  <inkml:trace contextRef="#ctx0" brushRef="#br0" timeOffset="29">-104-550 0</inkml:trace>
  <inkml:trace contextRef="#ctx0" brushRef="#br0" timeOffset="30">-91-858 0</inkml:trace>
  <inkml:trace contextRef="#ctx0" brushRef="#br0" timeOffset="31">-15-728 0</inkml:trace>
  <inkml:trace contextRef="#ctx0" brushRef="#br0" timeOffset="32">-15-1005 0</inkml:trace>
  <inkml:trace contextRef="#ctx0" brushRef="#br0" timeOffset="33">114-842 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ax="1920" units="cm"/>
          <inkml:channel name="Y" type="integer" max="1080" units="cm"/>
          <inkml:channel name="T" type="integer" max="2.14748E9" units="dev"/>
        </inkml:traceFormat>
        <inkml:channelProperties>
          <inkml:channelProperty channel="X" name="resolution" value="55.81395" units="1/cm"/>
          <inkml:channelProperty channel="Y" name="resolution" value="55.6701" units="1/cm"/>
          <inkml:channelProperty channel="T" name="resolution" value="1" units="1/dev"/>
        </inkml:channelProperties>
      </inkml:inkSource>
      <inkml:timestamp xml:id="ts0" timeString="2022-11-21T15:25:09.135"/>
    </inkml:context>
    <inkml:brush xml:id="br0">
      <inkml:brushProperty name="width" value="0.15875" units="cm"/>
      <inkml:brushProperty name="height" value="0.15875" units="cm"/>
      <inkml:brushProperty name="color" value="#FFD966"/>
      <inkml:brushProperty name="fitToCurve" value="1"/>
    </inkml:brush>
  </inkml:definitions>
  <inkml:trace contextRef="#ctx0" brushRef="#br0">-1102-907 0</inkml:trace>
  <inkml:trace contextRef="#ctx0" brushRef="#br0" timeOffset="1">-1397-858 0</inkml:trace>
  <inkml:trace contextRef="#ctx0" brushRef="#br0" timeOffset="2">-1358-583 0</inkml:trace>
  <inkml:trace contextRef="#ctx0" brushRef="#br0" timeOffset="3">-1346-1086 0</inkml:trace>
  <inkml:trace contextRef="#ctx0" brushRef="#br0" timeOffset="4">-1256-907 0</inkml:trace>
  <inkml:trace contextRef="#ctx0" brushRef="#br0" timeOffset="5">-1217-485 0</inkml:trace>
  <inkml:trace contextRef="#ctx0" brushRef="#br0" timeOffset="6">-1205-728 0</inkml:trace>
  <inkml:trace contextRef="#ctx0" brushRef="#br0" timeOffset="7">-1167-1134 0</inkml:trace>
  <inkml:trace contextRef="#ctx0" brushRef="#br0" timeOffset="8">-1115-372 0</inkml:trace>
  <inkml:trace contextRef="#ctx0" brushRef="#br0" timeOffset="9">-1077-696 0</inkml:trace>
  <inkml:trace contextRef="#ctx0" brushRef="#br0" timeOffset="10">-718-355 0</inkml:trace>
  <inkml:trace contextRef="#ctx0" brushRef="#br0" timeOffset="11">-718-1281 0</inkml:trace>
  <inkml:trace contextRef="#ctx0" brushRef="#br0" timeOffset="12">-1038-518 0</inkml:trace>
  <inkml:trace contextRef="#ctx0" brushRef="#br0" timeOffset="13">-1026-1167 0</inkml:trace>
  <inkml:trace contextRef="#ctx0" brushRef="#br0" timeOffset="14">-1000-307 0</inkml:trace>
  <inkml:trace contextRef="#ctx0" brushRef="#br0" timeOffset="15">-949-1297 0</inkml:trace>
  <inkml:trace contextRef="#ctx0" brushRef="#br0" timeOffset="16">-872-355 0</inkml:trace>
  <inkml:trace contextRef="#ctx0" brushRef="#br0" timeOffset="17">-859-1183 0</inkml:trace>
  <inkml:trace contextRef="#ctx0" brushRef="#br0" timeOffset="18">-552-306 0</inkml:trace>
  <inkml:trace contextRef="#ctx0" brushRef="#br0" timeOffset="19">-552-1313 0</inkml:trace>
  <inkml:trace contextRef="#ctx0" brushRef="#br0" timeOffset="20">-513-436 0</inkml:trace>
  <inkml:trace contextRef="#ctx0" brushRef="#br0" timeOffset="21">-411-1199 0</inkml:trace>
  <inkml:trace contextRef="#ctx0" brushRef="#br0" timeOffset="22">-386-323 0</inkml:trace>
  <inkml:trace contextRef="#ctx0" brushRef="#br0" timeOffset="23">-347-518 0</inkml:trace>
  <inkml:trace contextRef="#ctx0" brushRef="#br0" timeOffset="24">-270-1118 0</inkml:trace>
  <inkml:trace contextRef="#ctx0" brushRef="#br0" timeOffset="25">-258-923 0</inkml:trace>
  <inkml:trace contextRef="#ctx0" brushRef="#br0" timeOffset="26">-232-485 0</inkml:trace>
  <inkml:trace contextRef="#ctx0" brushRef="#br0" timeOffset="27">-220-696 0</inkml:trace>
  <inkml:trace contextRef="#ctx0" brushRef="#br0" timeOffset="28">-168-1102 0</inkml:trace>
  <inkml:trace contextRef="#ctx0" brushRef="#br0" timeOffset="29">-104-550 0</inkml:trace>
  <inkml:trace contextRef="#ctx0" brushRef="#br0" timeOffset="30">-91-858 0</inkml:trace>
  <inkml:trace contextRef="#ctx0" brushRef="#br0" timeOffset="31">-15-728 0</inkml:trace>
  <inkml:trace contextRef="#ctx0" brushRef="#br0" timeOffset="32">-15-1005 0</inkml:trace>
  <inkml:trace contextRef="#ctx0" brushRef="#br0" timeOffset="33">114-842 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ax="1920" units="cm"/>
          <inkml:channel name="Y" type="integer" max="1080" units="cm"/>
          <inkml:channel name="T" type="integer" max="2.14748E9" units="dev"/>
        </inkml:traceFormat>
        <inkml:channelProperties>
          <inkml:channelProperty channel="X" name="resolution" value="55.81395" units="1/cm"/>
          <inkml:channelProperty channel="Y" name="resolution" value="55.6701" units="1/cm"/>
          <inkml:channelProperty channel="T" name="resolution" value="1" units="1/dev"/>
        </inkml:channelProperties>
      </inkml:inkSource>
      <inkml:timestamp xml:id="ts0" timeString="2022-11-21T15:25:14.471"/>
    </inkml:context>
    <inkml:brush xml:id="br0">
      <inkml:brushProperty name="width" value="0.15875" units="cm"/>
      <inkml:brushProperty name="height" value="0.15875" units="cm"/>
      <inkml:brushProperty name="color" value="#FFD966"/>
      <inkml:brushProperty name="fitToCurve" value="1"/>
    </inkml:brush>
  </inkml:definitions>
  <inkml:trace contextRef="#ctx0" brushRef="#br0">-1102-907 0</inkml:trace>
  <inkml:trace contextRef="#ctx0" brushRef="#br0" timeOffset="1">-1397-858 0</inkml:trace>
  <inkml:trace contextRef="#ctx0" brushRef="#br0" timeOffset="2">-1358-583 0</inkml:trace>
  <inkml:trace contextRef="#ctx0" brushRef="#br0" timeOffset="3">-1346-1086 0</inkml:trace>
  <inkml:trace contextRef="#ctx0" brushRef="#br0" timeOffset="4">-1256-907 0</inkml:trace>
  <inkml:trace contextRef="#ctx0" brushRef="#br0" timeOffset="5">-1217-485 0</inkml:trace>
  <inkml:trace contextRef="#ctx0" brushRef="#br0" timeOffset="6">-1205-728 0</inkml:trace>
  <inkml:trace contextRef="#ctx0" brushRef="#br0" timeOffset="7">-1167-1134 0</inkml:trace>
  <inkml:trace contextRef="#ctx0" brushRef="#br0" timeOffset="8">-1115-372 0</inkml:trace>
  <inkml:trace contextRef="#ctx0" brushRef="#br0" timeOffset="9">-1077-696 0</inkml:trace>
  <inkml:trace contextRef="#ctx0" brushRef="#br0" timeOffset="10">-718-355 0</inkml:trace>
  <inkml:trace contextRef="#ctx0" brushRef="#br0" timeOffset="11">-718-1281 0</inkml:trace>
  <inkml:trace contextRef="#ctx0" brushRef="#br0" timeOffset="12">-1038-518 0</inkml:trace>
  <inkml:trace contextRef="#ctx0" brushRef="#br0" timeOffset="13">-1026-1167 0</inkml:trace>
  <inkml:trace contextRef="#ctx0" brushRef="#br0" timeOffset="14">-1000-307 0</inkml:trace>
  <inkml:trace contextRef="#ctx0" brushRef="#br0" timeOffset="15">-949-1297 0</inkml:trace>
  <inkml:trace contextRef="#ctx0" brushRef="#br0" timeOffset="16">-872-355 0</inkml:trace>
  <inkml:trace contextRef="#ctx0" brushRef="#br0" timeOffset="17">-859-1183 0</inkml:trace>
  <inkml:trace contextRef="#ctx0" brushRef="#br0" timeOffset="18">-551-306 0</inkml:trace>
  <inkml:trace contextRef="#ctx0" brushRef="#br0" timeOffset="19">-551-1313 0</inkml:trace>
  <inkml:trace contextRef="#ctx0" brushRef="#br0" timeOffset="20">-512-436 0</inkml:trace>
  <inkml:trace contextRef="#ctx0" brushRef="#br0" timeOffset="21">-410-1199 0</inkml:trace>
  <inkml:trace contextRef="#ctx0" brushRef="#br0" timeOffset="22">-385-323 0</inkml:trace>
  <inkml:trace contextRef="#ctx0" brushRef="#br0" timeOffset="23">-346-518 0</inkml:trace>
  <inkml:trace contextRef="#ctx0" brushRef="#br0" timeOffset="24">-269-1118 0</inkml:trace>
  <inkml:trace contextRef="#ctx0" brushRef="#br0" timeOffset="25">-257-923 0</inkml:trace>
  <inkml:trace contextRef="#ctx0" brushRef="#br0" timeOffset="26">-231-485 0</inkml:trace>
  <inkml:trace contextRef="#ctx0" brushRef="#br0" timeOffset="27">-219-696 0</inkml:trace>
  <inkml:trace contextRef="#ctx0" brushRef="#br0" timeOffset="28">-167-1102 0</inkml:trace>
  <inkml:trace contextRef="#ctx0" brushRef="#br0" timeOffset="29">-103-550 0</inkml:trace>
  <inkml:trace contextRef="#ctx0" brushRef="#br0" timeOffset="30">-90-858 0</inkml:trace>
  <inkml:trace contextRef="#ctx0" brushRef="#br0" timeOffset="31">-14-728 0</inkml:trace>
  <inkml:trace contextRef="#ctx0" brushRef="#br0" timeOffset="32">-14-1005 0</inkml:trace>
  <inkml:trace contextRef="#ctx0" brushRef="#br0" timeOffset="33">115-842 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ax="1920" units="cm"/>
          <inkml:channel name="Y" type="integer" max="1080" units="cm"/>
          <inkml:channel name="T" type="integer" max="2.14748E9" units="dev"/>
        </inkml:traceFormat>
        <inkml:channelProperties>
          <inkml:channelProperty channel="X" name="resolution" value="55.81395" units="1/cm"/>
          <inkml:channelProperty channel="Y" name="resolution" value="55.6701" units="1/cm"/>
          <inkml:channelProperty channel="T" name="resolution" value="1" units="1/dev"/>
        </inkml:channelProperties>
      </inkml:inkSource>
      <inkml:timestamp xml:id="ts0" timeString="2022-11-21T15:25:19.424"/>
    </inkml:context>
    <inkml:brush xml:id="br0">
      <inkml:brushProperty name="width" value="0.15875" units="cm"/>
      <inkml:brushProperty name="height" value="0.15875" units="cm"/>
      <inkml:brushProperty name="color" value="#FFD966"/>
      <inkml:brushProperty name="fitToCurve" value="1"/>
    </inkml:brush>
  </inkml:definitions>
  <inkml:trace contextRef="#ctx0" brushRef="#br0">-1102-907 0</inkml:trace>
  <inkml:trace contextRef="#ctx0" brushRef="#br0" timeOffset="1">-1397-858 0</inkml:trace>
  <inkml:trace contextRef="#ctx0" brushRef="#br0" timeOffset="2">-1358-583 0</inkml:trace>
  <inkml:trace contextRef="#ctx0" brushRef="#br0" timeOffset="3">-1346-1086 0</inkml:trace>
  <inkml:trace contextRef="#ctx0" brushRef="#br0" timeOffset="4">-1256-907 0</inkml:trace>
  <inkml:trace contextRef="#ctx0" brushRef="#br0" timeOffset="5">-1217-485 0</inkml:trace>
  <inkml:trace contextRef="#ctx0" brushRef="#br0" timeOffset="6">-1205-728 0</inkml:trace>
  <inkml:trace contextRef="#ctx0" brushRef="#br0" timeOffset="7">-1166-1134 0</inkml:trace>
  <inkml:trace contextRef="#ctx0" brushRef="#br0" timeOffset="8">-1115-372 0</inkml:trace>
  <inkml:trace contextRef="#ctx0" brushRef="#br0" timeOffset="9">-1077-696 0</inkml:trace>
  <inkml:trace contextRef="#ctx0" brushRef="#br0" timeOffset="10">-718-355 0</inkml:trace>
  <inkml:trace contextRef="#ctx0" brushRef="#br0" timeOffset="11">-718-1281 0</inkml:trace>
  <inkml:trace contextRef="#ctx0" brushRef="#br0" timeOffset="12">-1038-518 0</inkml:trace>
  <inkml:trace contextRef="#ctx0" brushRef="#br0" timeOffset="13">-1025-1167 0</inkml:trace>
  <inkml:trace contextRef="#ctx0" brushRef="#br0" timeOffset="14">-1000-307 0</inkml:trace>
  <inkml:trace contextRef="#ctx0" brushRef="#br0" timeOffset="15">-949-1297 0</inkml:trace>
  <inkml:trace contextRef="#ctx0" brushRef="#br0" timeOffset="16">-872-355 0</inkml:trace>
  <inkml:trace contextRef="#ctx0" brushRef="#br0" timeOffset="17">-859-1183 0</inkml:trace>
  <inkml:trace contextRef="#ctx0" brushRef="#br0" timeOffset="18">-553-306 0</inkml:trace>
  <inkml:trace contextRef="#ctx0" brushRef="#br0" timeOffset="19">-553-1313 0</inkml:trace>
  <inkml:trace contextRef="#ctx0" brushRef="#br0" timeOffset="20">-514-436 0</inkml:trace>
  <inkml:trace contextRef="#ctx0" brushRef="#br0" timeOffset="21">-412-1199 0</inkml:trace>
  <inkml:trace contextRef="#ctx0" brushRef="#br0" timeOffset="22">-386-323 0</inkml:trace>
  <inkml:trace contextRef="#ctx0" brushRef="#br0" timeOffset="23">-347-518 0</inkml:trace>
  <inkml:trace contextRef="#ctx0" brushRef="#br0" timeOffset="24">-271-1118 0</inkml:trace>
  <inkml:trace contextRef="#ctx0" brushRef="#br0" timeOffset="25">-258-923 0</inkml:trace>
  <inkml:trace contextRef="#ctx0" brushRef="#br0" timeOffset="26">-232-485 0</inkml:trace>
  <inkml:trace contextRef="#ctx0" brushRef="#br0" timeOffset="27">-220-696 0</inkml:trace>
  <inkml:trace contextRef="#ctx0" brushRef="#br0" timeOffset="28">-168-1102 0</inkml:trace>
  <inkml:trace contextRef="#ctx0" brushRef="#br0" timeOffset="29">-104-550 0</inkml:trace>
  <inkml:trace contextRef="#ctx0" brushRef="#br0" timeOffset="30">-91-858 0</inkml:trace>
  <inkml:trace contextRef="#ctx0" brushRef="#br0" timeOffset="31">-15-728 0</inkml:trace>
  <inkml:trace contextRef="#ctx0" brushRef="#br0" timeOffset="32">-15-1005 0</inkml:trace>
  <inkml:trace contextRef="#ctx0" brushRef="#br0" timeOffset="33">114-842 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C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6EA8C2-3DF5-4F9E-B89A-B13079388910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C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C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F1534F-6F64-44D4-8A5A-A124AAF9D674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29485933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EC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2241285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1359682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202474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1798664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773880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454064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3144340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4216448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1480177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329408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C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C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3423186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EC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C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A7F97-B32D-4578-8604-83923AEA4E66}" type="datetimeFigureOut">
              <a:rPr lang="es-EC" smtClean="0"/>
              <a:t>8/5/2023</a:t>
            </a:fld>
            <a:endParaRPr lang="es-EC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C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635C7-D1E8-4B52-BE7E-50E127C5EC0D}" type="slidenum">
              <a:rPr lang="es-EC" smtClean="0"/>
              <a:t>‹#›</a:t>
            </a:fld>
            <a:endParaRPr lang="es-EC"/>
          </a:p>
        </p:txBody>
      </p:sp>
    </p:spTree>
    <p:extLst>
      <p:ext uri="{BB962C8B-B14F-4D97-AF65-F5344CB8AC3E}">
        <p14:creationId xmlns:p14="http://schemas.microsoft.com/office/powerpoint/2010/main" val="3716025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C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7" Type="http://schemas.openxmlformats.org/officeDocument/2006/relationships/customXml" Target="../ink/ink3.xml"/><Relationship Id="rId2" Type="http://schemas.openxmlformats.org/officeDocument/2006/relationships/customXml" Target="../ink/ink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11" Type="http://schemas.openxmlformats.org/officeDocument/2006/relationships/customXml" Target="../ink/ink6.xml"/><Relationship Id="rId5" Type="http://schemas.openxmlformats.org/officeDocument/2006/relationships/customXml" Target="../ink/ink2.xml"/><Relationship Id="rId10" Type="http://schemas.openxmlformats.org/officeDocument/2006/relationships/customXml" Target="../ink/ink5.xml"/><Relationship Id="rId4" Type="http://schemas.openxmlformats.org/officeDocument/2006/relationships/image" Target="../media/image2.emf"/><Relationship Id="rId9" Type="http://schemas.openxmlformats.org/officeDocument/2006/relationships/customXml" Target="../ink/ink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1271450" y="775063"/>
            <a:ext cx="9727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</a:t>
            </a:r>
            <a:r>
              <a:rPr lang="es-EC" dirty="0"/>
              <a:t>. </a:t>
            </a:r>
            <a:r>
              <a:rPr lang="en-US" dirty="0"/>
              <a:t>General plant-derived compounds used in treatments   </a:t>
            </a:r>
            <a:endParaRPr lang="es-EC" dirty="0"/>
          </a:p>
        </p:txBody>
      </p:sp>
    </p:spTree>
    <p:extLst>
      <p:ext uri="{BB962C8B-B14F-4D97-AF65-F5344CB8AC3E}">
        <p14:creationId xmlns:p14="http://schemas.microsoft.com/office/powerpoint/2010/main" val="3372326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upo 37"/>
          <p:cNvGrpSpPr/>
          <p:nvPr/>
        </p:nvGrpSpPr>
        <p:grpSpPr>
          <a:xfrm>
            <a:off x="1824045" y="81862"/>
            <a:ext cx="8514770" cy="6726984"/>
            <a:chOff x="1824045" y="81862"/>
            <a:chExt cx="8514770" cy="6726984"/>
          </a:xfrm>
        </p:grpSpPr>
        <p:grpSp>
          <p:nvGrpSpPr>
            <p:cNvPr id="2" name="Grupo 1"/>
            <p:cNvGrpSpPr/>
            <p:nvPr/>
          </p:nvGrpSpPr>
          <p:grpSpPr>
            <a:xfrm>
              <a:off x="1824045" y="81862"/>
              <a:ext cx="8514770" cy="6726984"/>
              <a:chOff x="1824045" y="81862"/>
              <a:chExt cx="8514770" cy="6726984"/>
            </a:xfrm>
          </p:grpSpPr>
          <p:sp>
            <p:nvSpPr>
              <p:cNvPr id="126" name="Elipse 125"/>
              <p:cNvSpPr/>
              <p:nvPr/>
            </p:nvSpPr>
            <p:spPr>
              <a:xfrm>
                <a:off x="2513442" y="4828846"/>
                <a:ext cx="1980000" cy="1980000"/>
              </a:xfrm>
              <a:prstGeom prst="ellipse">
                <a:avLst/>
              </a:prstGeom>
              <a:ln/>
            </p:spPr>
            <p:style>
              <a:lnRef idx="1">
                <a:schemeClr val="accent2"/>
              </a:lnRef>
              <a:fillRef idx="2">
                <a:schemeClr val="accent2"/>
              </a:fillRef>
              <a:effectRef idx="1">
                <a:schemeClr val="accent2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grpSp>
            <p:nvGrpSpPr>
              <p:cNvPr id="77" name="Group 153"/>
              <p:cNvGrpSpPr>
                <a:grpSpLocks/>
              </p:cNvGrpSpPr>
              <p:nvPr/>
            </p:nvGrpSpPr>
            <p:grpSpPr bwMode="auto">
              <a:xfrm>
                <a:off x="2586833" y="5204715"/>
                <a:ext cx="1682757" cy="835026"/>
                <a:chOff x="792" y="884"/>
                <a:chExt cx="1060" cy="526"/>
              </a:xfrm>
            </p:grpSpPr>
            <p:sp>
              <p:nvSpPr>
                <p:cNvPr id="78" name="Rectangle 154"/>
                <p:cNvSpPr>
                  <a:spLocks noChangeAspect="1" noChangeArrowheads="1"/>
                </p:cNvSpPr>
                <p:nvPr/>
              </p:nvSpPr>
              <p:spPr bwMode="auto">
                <a:xfrm>
                  <a:off x="792" y="1290"/>
                  <a:ext cx="53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>
                      <a:ea typeface="Arial" charset="0"/>
                      <a:cs typeface="Arial" charset="0"/>
                    </a:rPr>
                    <a:t>O</a:t>
                  </a:r>
                  <a:endParaRPr lang="en-US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79" name="Rectangle 155"/>
                <p:cNvSpPr>
                  <a:spLocks noChangeAspect="1" noChangeArrowheads="1"/>
                </p:cNvSpPr>
                <p:nvPr/>
              </p:nvSpPr>
              <p:spPr bwMode="auto">
                <a:xfrm>
                  <a:off x="1228" y="960"/>
                  <a:ext cx="53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>
                      <a:ea typeface="Arial" charset="0"/>
                      <a:cs typeface="Arial" charset="0"/>
                    </a:rPr>
                    <a:t>O</a:t>
                  </a:r>
                  <a:endParaRPr lang="en-US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0" name="Rectangle 156"/>
                <p:cNvSpPr>
                  <a:spLocks noChangeAspect="1" noChangeArrowheads="1"/>
                </p:cNvSpPr>
                <p:nvPr/>
              </p:nvSpPr>
              <p:spPr bwMode="auto">
                <a:xfrm>
                  <a:off x="1296" y="960"/>
                  <a:ext cx="50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>
                      <a:ea typeface="Arial" charset="0"/>
                      <a:cs typeface="Arial" charset="0"/>
                    </a:rPr>
                    <a:t>H</a:t>
                  </a:r>
                  <a:endParaRPr lang="en-US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1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1738" y="896"/>
                  <a:ext cx="53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2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1802" y="896"/>
                  <a:ext cx="50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3" name="Rectangle 159"/>
                <p:cNvSpPr>
                  <a:spLocks noChangeAspect="1" noChangeArrowheads="1"/>
                </p:cNvSpPr>
                <p:nvPr/>
              </p:nvSpPr>
              <p:spPr bwMode="auto">
                <a:xfrm>
                  <a:off x="1487" y="884"/>
                  <a:ext cx="53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4" name="Rectangle 160"/>
                <p:cNvSpPr>
                  <a:spLocks noChangeAspect="1" noChangeArrowheads="1"/>
                </p:cNvSpPr>
                <p:nvPr/>
              </p:nvSpPr>
              <p:spPr bwMode="auto">
                <a:xfrm>
                  <a:off x="1510" y="1310"/>
                  <a:ext cx="43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>
                      <a:ea typeface="Arial" charset="0"/>
                      <a:cs typeface="Arial" charset="0"/>
                    </a:rPr>
                    <a:t>C</a:t>
                  </a:r>
                  <a:endParaRPr lang="en-US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5" name="Rectangle 161"/>
                <p:cNvSpPr>
                  <a:spLocks noChangeAspect="1" noChangeArrowheads="1"/>
                </p:cNvSpPr>
                <p:nvPr/>
              </p:nvSpPr>
              <p:spPr bwMode="auto">
                <a:xfrm>
                  <a:off x="1563" y="1310"/>
                  <a:ext cx="50" cy="9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>
                      <a:ea typeface="Arial" charset="0"/>
                      <a:cs typeface="Arial" charset="0"/>
                    </a:rPr>
                    <a:t>H</a:t>
                  </a:r>
                  <a:endParaRPr lang="en-US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6" name="Rectangle 162"/>
                <p:cNvSpPr>
                  <a:spLocks noChangeAspect="1" noChangeArrowheads="1"/>
                </p:cNvSpPr>
                <p:nvPr/>
              </p:nvSpPr>
              <p:spPr bwMode="auto">
                <a:xfrm>
                  <a:off x="1619" y="1332"/>
                  <a:ext cx="33" cy="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800">
                      <a:ea typeface="Arial" charset="0"/>
                      <a:cs typeface="Arial" charset="0"/>
                    </a:rPr>
                    <a:t>3</a:t>
                  </a:r>
                  <a:endParaRPr lang="en-US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87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1066" y="1265"/>
                  <a:ext cx="115" cy="6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8" name="Line 164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1066" y="1255"/>
                  <a:ext cx="100" cy="57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951" y="1264"/>
                  <a:ext cx="115" cy="67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" name="Line 16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951" y="1132"/>
                  <a:ext cx="1" cy="132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951" y="1065"/>
                  <a:ext cx="115" cy="67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2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1066" y="1065"/>
                  <a:ext cx="115" cy="67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3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181" y="1132"/>
                  <a:ext cx="1" cy="13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4" name="Line 170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988" y="945"/>
                  <a:ext cx="25" cy="14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5" name="Line 171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997" y="958"/>
                  <a:ext cx="22" cy="1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6" name="Line 172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006" y="971"/>
                  <a:ext cx="19" cy="12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7" name="Line 173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014" y="984"/>
                  <a:ext cx="17" cy="1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8" name="Line 174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022" y="998"/>
                  <a:ext cx="15" cy="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9" name="Line 175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031" y="1011"/>
                  <a:ext cx="12" cy="7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0" name="Line 17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039" y="1024"/>
                  <a:ext cx="10" cy="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1" name="Line 17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047" y="1037"/>
                  <a:ext cx="8" cy="4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2" name="Line 178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056" y="1050"/>
                  <a:ext cx="5" cy="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3" name="Line 179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1067" y="951"/>
                  <a:ext cx="65" cy="113"/>
                </a:xfrm>
                <a:prstGeom prst="line">
                  <a:avLst/>
                </a:prstGeom>
                <a:noFill/>
                <a:ln w="1588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4" name="Freeform 180"/>
                <p:cNvSpPr>
                  <a:spLocks noChangeAspect="1"/>
                </p:cNvSpPr>
                <p:nvPr/>
              </p:nvSpPr>
              <p:spPr bwMode="auto">
                <a:xfrm>
                  <a:off x="1064" y="943"/>
                  <a:ext cx="81" cy="122"/>
                </a:xfrm>
                <a:custGeom>
                  <a:avLst/>
                  <a:gdLst/>
                  <a:ahLst/>
                  <a:cxnLst>
                    <a:cxn ang="0">
                      <a:pos x="93" y="0"/>
                    </a:cxn>
                    <a:cxn ang="0">
                      <a:pos x="134" y="24"/>
                    </a:cxn>
                    <a:cxn ang="0">
                      <a:pos x="9" y="201"/>
                    </a:cxn>
                    <a:cxn ang="0">
                      <a:pos x="3" y="203"/>
                    </a:cxn>
                    <a:cxn ang="0">
                      <a:pos x="0" y="200"/>
                    </a:cxn>
                    <a:cxn ang="0">
                      <a:pos x="93" y="0"/>
                    </a:cxn>
                  </a:cxnLst>
                  <a:rect l="0" t="0" r="r" b="b"/>
                  <a:pathLst>
                    <a:path w="134" h="203">
                      <a:moveTo>
                        <a:pt x="93" y="0"/>
                      </a:moveTo>
                      <a:lnTo>
                        <a:pt x="134" y="24"/>
                      </a:lnTo>
                      <a:lnTo>
                        <a:pt x="9" y="201"/>
                      </a:lnTo>
                      <a:lnTo>
                        <a:pt x="3" y="203"/>
                      </a:lnTo>
                      <a:lnTo>
                        <a:pt x="0" y="200"/>
                      </a:lnTo>
                      <a:lnTo>
                        <a:pt x="93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5" name="Line 181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862" y="1269"/>
                  <a:ext cx="97" cy="5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6" name="Line 182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855" y="1255"/>
                  <a:ext cx="96" cy="5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7" name="Line 183"/>
                <p:cNvSpPr>
                  <a:spLocks noChangeAspect="1" noChangeShapeType="1"/>
                </p:cNvSpPr>
                <p:nvPr/>
              </p:nvSpPr>
              <p:spPr bwMode="auto">
                <a:xfrm>
                  <a:off x="1181" y="1265"/>
                  <a:ext cx="115" cy="6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8" name="Line 184"/>
                <p:cNvSpPr>
                  <a:spLocks noChangeAspect="1" noChangeShapeType="1"/>
                </p:cNvSpPr>
                <p:nvPr/>
              </p:nvSpPr>
              <p:spPr bwMode="auto">
                <a:xfrm>
                  <a:off x="1181" y="1132"/>
                  <a:ext cx="115" cy="6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09" name="Line 185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296" y="1132"/>
                  <a:ext cx="115" cy="6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0" name="Line 18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296" y="1118"/>
                  <a:ext cx="108" cy="62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1" name="Line 187"/>
                <p:cNvSpPr>
                  <a:spLocks noChangeAspect="1" noChangeShapeType="1"/>
                </p:cNvSpPr>
                <p:nvPr/>
              </p:nvSpPr>
              <p:spPr bwMode="auto">
                <a:xfrm>
                  <a:off x="1411" y="1132"/>
                  <a:ext cx="115" cy="6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2" name="Line 188"/>
                <p:cNvSpPr>
                  <a:spLocks noChangeAspect="1" noChangeShapeType="1"/>
                </p:cNvSpPr>
                <p:nvPr/>
              </p:nvSpPr>
              <p:spPr bwMode="auto">
                <a:xfrm>
                  <a:off x="1223" y="1039"/>
                  <a:ext cx="17" cy="1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3" name="Line 189"/>
                <p:cNvSpPr>
                  <a:spLocks noChangeAspect="1" noChangeShapeType="1"/>
                </p:cNvSpPr>
                <p:nvPr/>
              </p:nvSpPr>
              <p:spPr bwMode="auto">
                <a:xfrm>
                  <a:off x="1216" y="1052"/>
                  <a:ext cx="17" cy="1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4" name="Line 190"/>
                <p:cNvSpPr>
                  <a:spLocks noChangeAspect="1" noChangeShapeType="1"/>
                </p:cNvSpPr>
                <p:nvPr/>
              </p:nvSpPr>
              <p:spPr bwMode="auto">
                <a:xfrm>
                  <a:off x="1209" y="1064"/>
                  <a:ext cx="17" cy="1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5" name="Line 191"/>
                <p:cNvSpPr>
                  <a:spLocks noChangeAspect="1" noChangeShapeType="1"/>
                </p:cNvSpPr>
                <p:nvPr/>
              </p:nvSpPr>
              <p:spPr bwMode="auto">
                <a:xfrm>
                  <a:off x="1202" y="1077"/>
                  <a:ext cx="17" cy="9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6" name="Line 192"/>
                <p:cNvSpPr>
                  <a:spLocks noChangeAspect="1" noChangeShapeType="1"/>
                </p:cNvSpPr>
                <p:nvPr/>
              </p:nvSpPr>
              <p:spPr bwMode="auto">
                <a:xfrm>
                  <a:off x="1195" y="1089"/>
                  <a:ext cx="17" cy="9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7" name="Line 193"/>
                <p:cNvSpPr>
                  <a:spLocks noChangeAspect="1" noChangeShapeType="1"/>
                </p:cNvSpPr>
                <p:nvPr/>
              </p:nvSpPr>
              <p:spPr bwMode="auto">
                <a:xfrm>
                  <a:off x="1188" y="1101"/>
                  <a:ext cx="17" cy="9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8" name="Line 194"/>
                <p:cNvSpPr>
                  <a:spLocks noChangeAspect="1" noChangeShapeType="1"/>
                </p:cNvSpPr>
                <p:nvPr/>
              </p:nvSpPr>
              <p:spPr bwMode="auto">
                <a:xfrm>
                  <a:off x="1181" y="1113"/>
                  <a:ext cx="16" cy="1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19" name="Line 195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526" y="1132"/>
                  <a:ext cx="116" cy="66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0" name="Line 19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526" y="1123"/>
                  <a:ext cx="100" cy="57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1" name="Line 19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642" y="998"/>
                  <a:ext cx="0" cy="134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2" name="Line 198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1548" y="954"/>
                  <a:ext cx="94" cy="54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3" name="Line 199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1556" y="940"/>
                  <a:ext cx="94" cy="54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4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1526" y="1198"/>
                  <a:ext cx="1" cy="10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25" name="Line 201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642" y="946"/>
                  <a:ext cx="91" cy="52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127" name="Elipse 126"/>
              <p:cNvSpPr/>
              <p:nvPr/>
            </p:nvSpPr>
            <p:spPr>
              <a:xfrm>
                <a:off x="1824045" y="2764316"/>
                <a:ext cx="1732263" cy="1732263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sp>
            <p:nvSpPr>
              <p:cNvPr id="128" name="Elipse 127"/>
              <p:cNvSpPr/>
              <p:nvPr/>
            </p:nvSpPr>
            <p:spPr>
              <a:xfrm>
                <a:off x="2213073" y="83922"/>
                <a:ext cx="2162899" cy="2162899"/>
              </a:xfrm>
              <a:prstGeom prst="ellipse">
                <a:avLst/>
              </a:prstGeom>
              <a:ln/>
            </p:spPr>
            <p:style>
              <a:lnRef idx="1">
                <a:schemeClr val="accent1"/>
              </a:lnRef>
              <a:fillRef idx="2">
                <a:schemeClr val="accent1"/>
              </a:fillRef>
              <a:effectRef idx="1">
                <a:schemeClr val="accent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sp>
            <p:nvSpPr>
              <p:cNvPr id="129" name="Elipse 128"/>
              <p:cNvSpPr/>
              <p:nvPr/>
            </p:nvSpPr>
            <p:spPr>
              <a:xfrm>
                <a:off x="7921241" y="81862"/>
                <a:ext cx="2417574" cy="2417574"/>
              </a:xfrm>
              <a:prstGeom prst="ellipse">
                <a:avLst/>
              </a:prstGeom>
              <a:ln/>
            </p:spPr>
            <p:style>
              <a:lnRef idx="1">
                <a:schemeClr val="accent6"/>
              </a:lnRef>
              <a:fillRef idx="2">
                <a:schemeClr val="accent6"/>
              </a:fillRef>
              <a:effectRef idx="1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sp>
            <p:nvSpPr>
              <p:cNvPr id="130" name="Elipse 129"/>
              <p:cNvSpPr/>
              <p:nvPr/>
            </p:nvSpPr>
            <p:spPr>
              <a:xfrm>
                <a:off x="7921242" y="4644386"/>
                <a:ext cx="2162899" cy="2162899"/>
              </a:xfrm>
              <a:prstGeom prst="ellipse">
                <a:avLst/>
              </a:prstGeom>
              <a:solidFill>
                <a:srgbClr val="FF99CC"/>
              </a:solidFill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sp>
            <p:nvSpPr>
              <p:cNvPr id="131" name="Elipse 130"/>
              <p:cNvSpPr/>
              <p:nvPr/>
            </p:nvSpPr>
            <p:spPr>
              <a:xfrm>
                <a:off x="8620570" y="2804403"/>
                <a:ext cx="1689525" cy="1689525"/>
              </a:xfrm>
              <a:prstGeom prst="ellipse">
                <a:avLst/>
              </a:prstGeom>
              <a:ln/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sp>
            <p:nvSpPr>
              <p:cNvPr id="132" name="CuadroTexto 131"/>
              <p:cNvSpPr txBox="1"/>
              <p:nvPr/>
            </p:nvSpPr>
            <p:spPr>
              <a:xfrm>
                <a:off x="2881940" y="6187377"/>
                <a:ext cx="126047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C" dirty="0"/>
                  <a:t>Hormones</a:t>
                </a:r>
              </a:p>
            </p:txBody>
          </p:sp>
          <p:grpSp>
            <p:nvGrpSpPr>
              <p:cNvPr id="3" name="Grupo 2"/>
              <p:cNvGrpSpPr/>
              <p:nvPr/>
            </p:nvGrpSpPr>
            <p:grpSpPr>
              <a:xfrm>
                <a:off x="1911598" y="2936996"/>
                <a:ext cx="1320813" cy="833392"/>
                <a:chOff x="273225" y="2891321"/>
                <a:chExt cx="1320813" cy="833392"/>
              </a:xfrm>
            </p:grpSpPr>
            <p:grpSp>
              <p:nvGrpSpPr>
                <p:cNvPr id="133" name="Group 153"/>
                <p:cNvGrpSpPr>
                  <a:grpSpLocks/>
                </p:cNvGrpSpPr>
                <p:nvPr/>
              </p:nvGrpSpPr>
              <p:grpSpPr bwMode="auto">
                <a:xfrm>
                  <a:off x="273225" y="3091300"/>
                  <a:ext cx="1320813" cy="633413"/>
                  <a:chOff x="792" y="1065"/>
                  <a:chExt cx="832" cy="399"/>
                </a:xfrm>
              </p:grpSpPr>
              <p:sp>
                <p:nvSpPr>
                  <p:cNvPr id="134" name="Rectangle 154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792" y="1290"/>
                    <a:ext cx="0" cy="17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prstTxWarp prst="textNoShape">
                      <a:avLst/>
                    </a:prstTxWarp>
                    <a:spAutoFit/>
                  </a:bodyPr>
                  <a:lstStyle/>
                  <a:p>
                    <a:pPr eaLnBrk="1" hangingPunct="1"/>
                    <a:endParaRPr lang="en-US" dirty="0"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35" name="Rectangle 15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522" y="1186"/>
                    <a:ext cx="53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prstTxWarp prst="textNoShape">
                      <a:avLst/>
                    </a:prstTxWarp>
                    <a:spAutoFit/>
                  </a:bodyPr>
                  <a:lstStyle/>
                  <a:p>
                    <a:pPr eaLnBrk="1" hangingPunct="1"/>
                    <a:r>
                      <a:rPr lang="en-US" sz="1000" dirty="0">
                        <a:ea typeface="Arial" charset="0"/>
                        <a:cs typeface="Arial" charset="0"/>
                      </a:rPr>
                      <a:t>O</a:t>
                    </a:r>
                    <a:endParaRPr lang="en-US" dirty="0"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36" name="Rectangle 156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574" y="1186"/>
                    <a:ext cx="50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prstTxWarp prst="textNoShape">
                      <a:avLst/>
                    </a:prstTxWarp>
                    <a:spAutoFit/>
                  </a:bodyPr>
                  <a:lstStyle/>
                  <a:p>
                    <a:pPr eaLnBrk="1" hangingPunct="1"/>
                    <a:r>
                      <a:rPr lang="en-US" sz="1000" dirty="0">
                        <a:ea typeface="Arial" charset="0"/>
                        <a:cs typeface="Arial" charset="0"/>
                      </a:rPr>
                      <a:t>H</a:t>
                    </a:r>
                    <a:endParaRPr lang="en-US" dirty="0"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40" name="Rectangle 160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272" y="1294"/>
                    <a:ext cx="53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prstTxWarp prst="textNoShape">
                      <a:avLst/>
                    </a:prstTxWarp>
                    <a:spAutoFit/>
                  </a:bodyPr>
                  <a:lstStyle/>
                  <a:p>
                    <a:pPr eaLnBrk="1" hangingPunct="1"/>
                    <a:r>
                      <a:rPr lang="en-US" sz="1000" dirty="0">
                        <a:ea typeface="Arial" charset="0"/>
                        <a:cs typeface="Arial" charset="0"/>
                      </a:rPr>
                      <a:t>N</a:t>
                    </a:r>
                    <a:endParaRPr lang="en-US" dirty="0"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41" name="Rectangle 16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325" y="1294"/>
                    <a:ext cx="50" cy="9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prstTxWarp prst="textNoShape">
                      <a:avLst/>
                    </a:prstTxWarp>
                    <a:spAutoFit/>
                  </a:bodyPr>
                  <a:lstStyle/>
                  <a:p>
                    <a:pPr eaLnBrk="1" hangingPunct="1"/>
                    <a:r>
                      <a:rPr lang="en-US" sz="1000" dirty="0">
                        <a:ea typeface="Arial" charset="0"/>
                        <a:cs typeface="Arial" charset="0"/>
                      </a:rPr>
                      <a:t>H</a:t>
                    </a:r>
                    <a:endParaRPr lang="en-US" dirty="0"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42" name="Rectangle 162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1381" y="1316"/>
                    <a:ext cx="32" cy="78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prstTxWarp prst="textNoShape">
                      <a:avLst/>
                    </a:prstTxWarp>
                    <a:spAutoFit/>
                  </a:bodyPr>
                  <a:lstStyle/>
                  <a:p>
                    <a:pPr eaLnBrk="1" hangingPunct="1"/>
                    <a:r>
                      <a:rPr lang="en-US" sz="800" dirty="0">
                        <a:ea typeface="Arial" charset="0"/>
                        <a:cs typeface="Arial" charset="0"/>
                      </a:rPr>
                      <a:t>2</a:t>
                    </a:r>
                    <a:endParaRPr lang="en-US" dirty="0">
                      <a:ea typeface="Arial" charset="0"/>
                      <a:cs typeface="Arial" charset="0"/>
                    </a:endParaRPr>
                  </a:p>
                </p:txBody>
              </p:sp>
              <p:sp>
                <p:nvSpPr>
                  <p:cNvPr id="143" name="Line 163"/>
                  <p:cNvSpPr>
                    <a:spLocks noChangeAspect="1" noChangeShapeType="1"/>
                  </p:cNvSpPr>
                  <p:nvPr/>
                </p:nvSpPr>
                <p:spPr bwMode="auto">
                  <a:xfrm flipH="1">
                    <a:off x="1066" y="1265"/>
                    <a:ext cx="115" cy="66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4" name="Line 164"/>
                  <p:cNvSpPr>
                    <a:spLocks noChangeAspect="1" noChangeShapeType="1"/>
                  </p:cNvSpPr>
                  <p:nvPr/>
                </p:nvSpPr>
                <p:spPr bwMode="auto">
                  <a:xfrm flipH="1">
                    <a:off x="1066" y="1255"/>
                    <a:ext cx="100" cy="57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5" name="Line 165"/>
                  <p:cNvSpPr>
                    <a:spLocks noChangeAspect="1" noChangeShapeType="1"/>
                  </p:cNvSpPr>
                  <p:nvPr/>
                </p:nvSpPr>
                <p:spPr bwMode="auto">
                  <a:xfrm flipH="1" flipV="1">
                    <a:off x="951" y="1264"/>
                    <a:ext cx="115" cy="67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6" name="Line 166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951" y="1132"/>
                    <a:ext cx="1" cy="132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7" name="Line 167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951" y="1065"/>
                    <a:ext cx="115" cy="67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8" name="Line 168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1066" y="1065"/>
                    <a:ext cx="115" cy="67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49" name="Line 169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1181" y="1132"/>
                    <a:ext cx="1" cy="133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64" name="Line 184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1181" y="1132"/>
                    <a:ext cx="115" cy="66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65" name="Line 185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1296" y="1132"/>
                    <a:ext cx="115" cy="66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67" name="Line 187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1411" y="1132"/>
                    <a:ext cx="115" cy="66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180" name="Line 200"/>
                  <p:cNvSpPr>
                    <a:spLocks noChangeAspect="1" noChangeShapeType="1"/>
                  </p:cNvSpPr>
                  <p:nvPr/>
                </p:nvSpPr>
                <p:spPr bwMode="auto">
                  <a:xfrm>
                    <a:off x="1298" y="1198"/>
                    <a:ext cx="1" cy="108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sp>
              <p:nvSpPr>
                <p:cNvPr id="182" name="Line 199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710855" y="3124442"/>
                  <a:ext cx="149226" cy="8572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3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555437" y="3218860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7" name="Rectangle 159"/>
                <p:cNvSpPr>
                  <a:spLocks noChangeAspect="1" noChangeArrowheads="1"/>
                </p:cNvSpPr>
                <p:nvPr/>
              </p:nvSpPr>
              <p:spPr bwMode="auto">
                <a:xfrm>
                  <a:off x="1212872" y="2891321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90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1241248" y="3033637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1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1269548" y="3033637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192" name="CuadroTexto 191"/>
              <p:cNvSpPr txBox="1"/>
              <p:nvPr/>
            </p:nvSpPr>
            <p:spPr>
              <a:xfrm>
                <a:off x="2005481" y="3855413"/>
                <a:ext cx="135129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C" dirty="0"/>
                  <a:t>Amino acids</a:t>
                </a:r>
              </a:p>
            </p:txBody>
          </p:sp>
          <p:grpSp>
            <p:nvGrpSpPr>
              <p:cNvPr id="17" name="Grupo 16"/>
              <p:cNvGrpSpPr/>
              <p:nvPr/>
            </p:nvGrpSpPr>
            <p:grpSpPr>
              <a:xfrm>
                <a:off x="2685720" y="389653"/>
                <a:ext cx="1344876" cy="1239004"/>
                <a:chOff x="1473548" y="355765"/>
                <a:chExt cx="1344876" cy="1239004"/>
              </a:xfrm>
            </p:grpSpPr>
            <p:sp>
              <p:nvSpPr>
                <p:cNvPr id="248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1656111" y="987128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49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1473548" y="985541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0" name="Line 16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473548" y="775990"/>
                  <a:ext cx="1588" cy="2095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1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473548" y="669628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2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1656111" y="669628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3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838674" y="775990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4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2022296" y="990294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5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1839733" y="988707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7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1839733" y="677874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8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2018486" y="681684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59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2204859" y="784236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0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2021498" y="461501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1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2208930" y="679615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3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2026367" y="355765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4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2212740" y="355765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5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2395303" y="465937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6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2398263" y="674698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67" name="Rectangle 160"/>
                <p:cNvSpPr>
                  <a:spLocks noChangeAspect="1" noChangeArrowheads="1"/>
                </p:cNvSpPr>
                <p:nvPr/>
              </p:nvSpPr>
              <p:spPr bwMode="auto">
                <a:xfrm>
                  <a:off x="2592998" y="713291"/>
                  <a:ext cx="68263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C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68" name="Rectangle 161"/>
                <p:cNvSpPr>
                  <a:spLocks noChangeAspect="1" noChangeArrowheads="1"/>
                </p:cNvSpPr>
                <p:nvPr/>
              </p:nvSpPr>
              <p:spPr bwMode="auto">
                <a:xfrm>
                  <a:off x="2677136" y="713291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69" name="Rectangle 162"/>
                <p:cNvSpPr>
                  <a:spLocks noChangeAspect="1" noChangeArrowheads="1"/>
                </p:cNvSpPr>
                <p:nvPr/>
              </p:nvSpPr>
              <p:spPr bwMode="auto">
                <a:xfrm>
                  <a:off x="2766036" y="748216"/>
                  <a:ext cx="52388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800" dirty="0">
                      <a:ea typeface="Arial" charset="0"/>
                      <a:cs typeface="Arial" charset="0"/>
                    </a:rPr>
                    <a:t>3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70" name="Freeform 180"/>
                <p:cNvSpPr>
                  <a:spLocks noChangeAspect="1"/>
                </p:cNvSpPr>
                <p:nvPr/>
              </p:nvSpPr>
              <p:spPr bwMode="auto">
                <a:xfrm rot="19800000">
                  <a:off x="1784880" y="562348"/>
                  <a:ext cx="128588" cy="193675"/>
                </a:xfrm>
                <a:custGeom>
                  <a:avLst/>
                  <a:gdLst/>
                  <a:ahLst/>
                  <a:cxnLst>
                    <a:cxn ang="0">
                      <a:pos x="93" y="0"/>
                    </a:cxn>
                    <a:cxn ang="0">
                      <a:pos x="134" y="24"/>
                    </a:cxn>
                    <a:cxn ang="0">
                      <a:pos x="9" y="201"/>
                    </a:cxn>
                    <a:cxn ang="0">
                      <a:pos x="3" y="203"/>
                    </a:cxn>
                    <a:cxn ang="0">
                      <a:pos x="0" y="200"/>
                    </a:cxn>
                    <a:cxn ang="0">
                      <a:pos x="93" y="0"/>
                    </a:cxn>
                  </a:cxnLst>
                  <a:rect l="0" t="0" r="r" b="b"/>
                  <a:pathLst>
                    <a:path w="134" h="203">
                      <a:moveTo>
                        <a:pt x="93" y="0"/>
                      </a:moveTo>
                      <a:lnTo>
                        <a:pt x="134" y="24"/>
                      </a:lnTo>
                      <a:lnTo>
                        <a:pt x="9" y="201"/>
                      </a:lnTo>
                      <a:lnTo>
                        <a:pt x="3" y="203"/>
                      </a:lnTo>
                      <a:lnTo>
                        <a:pt x="0" y="200"/>
                      </a:lnTo>
                      <a:lnTo>
                        <a:pt x="93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1" name="Freeform 180"/>
                <p:cNvSpPr>
                  <a:spLocks noChangeAspect="1"/>
                </p:cNvSpPr>
                <p:nvPr/>
              </p:nvSpPr>
              <p:spPr bwMode="auto">
                <a:xfrm rot="7560000">
                  <a:off x="1633394" y="1095682"/>
                  <a:ext cx="128588" cy="193675"/>
                </a:xfrm>
                <a:custGeom>
                  <a:avLst/>
                  <a:gdLst/>
                  <a:ahLst/>
                  <a:cxnLst>
                    <a:cxn ang="0">
                      <a:pos x="93" y="0"/>
                    </a:cxn>
                    <a:cxn ang="0">
                      <a:pos x="134" y="24"/>
                    </a:cxn>
                    <a:cxn ang="0">
                      <a:pos x="9" y="201"/>
                    </a:cxn>
                    <a:cxn ang="0">
                      <a:pos x="3" y="203"/>
                    </a:cxn>
                    <a:cxn ang="0">
                      <a:pos x="0" y="200"/>
                    </a:cxn>
                    <a:cxn ang="0">
                      <a:pos x="93" y="0"/>
                    </a:cxn>
                  </a:cxnLst>
                  <a:rect l="0" t="0" r="r" b="b"/>
                  <a:pathLst>
                    <a:path w="134" h="203">
                      <a:moveTo>
                        <a:pt x="93" y="0"/>
                      </a:moveTo>
                      <a:lnTo>
                        <a:pt x="134" y="24"/>
                      </a:lnTo>
                      <a:lnTo>
                        <a:pt x="9" y="201"/>
                      </a:lnTo>
                      <a:lnTo>
                        <a:pt x="3" y="203"/>
                      </a:lnTo>
                      <a:lnTo>
                        <a:pt x="0" y="200"/>
                      </a:lnTo>
                      <a:lnTo>
                        <a:pt x="93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2" name="Freeform 180"/>
                <p:cNvSpPr>
                  <a:spLocks noChangeAspect="1"/>
                </p:cNvSpPr>
                <p:nvPr/>
              </p:nvSpPr>
              <p:spPr bwMode="auto">
                <a:xfrm rot="8100000">
                  <a:off x="1986763" y="1117613"/>
                  <a:ext cx="128588" cy="193675"/>
                </a:xfrm>
                <a:custGeom>
                  <a:avLst/>
                  <a:gdLst/>
                  <a:ahLst/>
                  <a:cxnLst>
                    <a:cxn ang="0">
                      <a:pos x="93" y="0"/>
                    </a:cxn>
                    <a:cxn ang="0">
                      <a:pos x="134" y="24"/>
                    </a:cxn>
                    <a:cxn ang="0">
                      <a:pos x="9" y="201"/>
                    </a:cxn>
                    <a:cxn ang="0">
                      <a:pos x="3" y="203"/>
                    </a:cxn>
                    <a:cxn ang="0">
                      <a:pos x="0" y="200"/>
                    </a:cxn>
                    <a:cxn ang="0">
                      <a:pos x="93" y="0"/>
                    </a:cxn>
                  </a:cxnLst>
                  <a:rect l="0" t="0" r="r" b="b"/>
                  <a:pathLst>
                    <a:path w="134" h="203">
                      <a:moveTo>
                        <a:pt x="93" y="0"/>
                      </a:moveTo>
                      <a:lnTo>
                        <a:pt x="134" y="24"/>
                      </a:lnTo>
                      <a:lnTo>
                        <a:pt x="9" y="201"/>
                      </a:lnTo>
                      <a:lnTo>
                        <a:pt x="3" y="203"/>
                      </a:lnTo>
                      <a:lnTo>
                        <a:pt x="0" y="200"/>
                      </a:lnTo>
                      <a:lnTo>
                        <a:pt x="93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73" name="Rectangle 160"/>
                <p:cNvSpPr>
                  <a:spLocks noChangeAspect="1" noChangeArrowheads="1"/>
                </p:cNvSpPr>
                <p:nvPr/>
              </p:nvSpPr>
              <p:spPr bwMode="auto">
                <a:xfrm>
                  <a:off x="1718480" y="1255724"/>
                  <a:ext cx="68263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C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74" name="Rectangle 161"/>
                <p:cNvSpPr>
                  <a:spLocks noChangeAspect="1" noChangeArrowheads="1"/>
                </p:cNvSpPr>
                <p:nvPr/>
              </p:nvSpPr>
              <p:spPr bwMode="auto">
                <a:xfrm>
                  <a:off x="1802618" y="1255724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75" name="Rectangle 162"/>
                <p:cNvSpPr>
                  <a:spLocks noChangeAspect="1" noChangeArrowheads="1"/>
                </p:cNvSpPr>
                <p:nvPr/>
              </p:nvSpPr>
              <p:spPr bwMode="auto">
                <a:xfrm>
                  <a:off x="1891518" y="1290649"/>
                  <a:ext cx="52388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800" dirty="0">
                      <a:ea typeface="Arial" charset="0"/>
                      <a:cs typeface="Arial" charset="0"/>
                    </a:rPr>
                    <a:t>3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76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2053351" y="1290649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77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2154951" y="1290649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grpSp>
              <p:nvGrpSpPr>
                <p:cNvPr id="4" name="Grupo 3"/>
                <p:cNvGrpSpPr/>
                <p:nvPr/>
              </p:nvGrpSpPr>
              <p:grpSpPr>
                <a:xfrm rot="14363655">
                  <a:off x="1544545" y="1104048"/>
                  <a:ext cx="115888" cy="171450"/>
                  <a:chOff x="-458278" y="1315096"/>
                  <a:chExt cx="115888" cy="171450"/>
                </a:xfrm>
              </p:grpSpPr>
              <p:sp>
                <p:nvSpPr>
                  <p:cNvPr id="285" name="Line 170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58278" y="1315096"/>
                    <a:ext cx="39688" cy="22225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6" name="Line 171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43991" y="1335733"/>
                    <a:ext cx="34925" cy="20638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7" name="Line 172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29703" y="1356371"/>
                    <a:ext cx="30163" cy="19050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8" name="Line 173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17003" y="1377008"/>
                    <a:ext cx="26988" cy="15875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9" name="Line 174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04303" y="1399233"/>
                    <a:ext cx="23813" cy="12700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0" name="Line 175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90016" y="1419871"/>
                    <a:ext cx="19050" cy="11113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1" name="Line 176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77316" y="1440508"/>
                    <a:ext cx="15875" cy="9525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2" name="Line 177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64616" y="1461146"/>
                    <a:ext cx="12700" cy="6350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3" name="Line 178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50328" y="1481783"/>
                    <a:ext cx="7938" cy="4763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sp>
              <p:nvSpPr>
                <p:cNvPr id="294" name="Rectangle 160"/>
                <p:cNvSpPr>
                  <a:spLocks noChangeAspect="1" noChangeArrowheads="1"/>
                </p:cNvSpPr>
                <p:nvPr/>
              </p:nvSpPr>
              <p:spPr bwMode="auto">
                <a:xfrm>
                  <a:off x="1517125" y="1440881"/>
                  <a:ext cx="8496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95" name="Rectangle 161"/>
                <p:cNvSpPr>
                  <a:spLocks noChangeAspect="1" noChangeArrowheads="1"/>
                </p:cNvSpPr>
                <p:nvPr/>
              </p:nvSpPr>
              <p:spPr bwMode="auto">
                <a:xfrm>
                  <a:off x="1604697" y="1440881"/>
                  <a:ext cx="73738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A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96" name="Rectangle 161"/>
                <p:cNvSpPr>
                  <a:spLocks noChangeAspect="1" noChangeArrowheads="1"/>
                </p:cNvSpPr>
                <p:nvPr/>
              </p:nvSpPr>
              <p:spPr bwMode="auto">
                <a:xfrm>
                  <a:off x="1683062" y="1440881"/>
                  <a:ext cx="54502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c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97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1551245" y="1281918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98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2423325" y="487373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00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2397100" y="357034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01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2583473" y="357034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02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2573948" y="384979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sp>
            <p:nvSpPr>
              <p:cNvPr id="303" name="CuadroTexto 302"/>
              <p:cNvSpPr txBox="1"/>
              <p:nvPr/>
            </p:nvSpPr>
            <p:spPr>
              <a:xfrm>
                <a:off x="2618874" y="1695882"/>
                <a:ext cx="135129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C" dirty="0"/>
                  <a:t>Terpenoids</a:t>
                </a:r>
              </a:p>
            </p:txBody>
          </p:sp>
          <p:grpSp>
            <p:nvGrpSpPr>
              <p:cNvPr id="11" name="Grupo 10"/>
              <p:cNvGrpSpPr/>
              <p:nvPr/>
            </p:nvGrpSpPr>
            <p:grpSpPr>
              <a:xfrm>
                <a:off x="8052516" y="438598"/>
                <a:ext cx="2036920" cy="1412235"/>
                <a:chOff x="5965889" y="116702"/>
                <a:chExt cx="2036920" cy="1412235"/>
              </a:xfrm>
            </p:grpSpPr>
            <p:sp>
              <p:nvSpPr>
                <p:cNvPr id="314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528130" y="1101872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5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6345567" y="1100285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6" name="Line 16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343662" y="890734"/>
                  <a:ext cx="1588" cy="2095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7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345567" y="784372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8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6528130" y="784372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19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710693" y="890734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0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894315" y="1110753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1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6711752" y="1109166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2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711751" y="812850"/>
                  <a:ext cx="125589" cy="7317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3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6974409" y="805444"/>
                  <a:ext cx="104545" cy="60909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4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076878" y="866459"/>
                  <a:ext cx="0" cy="243659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5" name="Line 164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519639" y="1090354"/>
                  <a:ext cx="158752" cy="9048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6" name="Line 199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6526100" y="818061"/>
                  <a:ext cx="149226" cy="8572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27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6368777" y="914384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1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6528983" y="1212455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2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6157706" y="782026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3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6497416" y="1374949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4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6588856" y="1374949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5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6052249" y="689462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6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5965889" y="689462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7" name="Rectangle 160"/>
                <p:cNvSpPr>
                  <a:spLocks noChangeAspect="1" noChangeArrowheads="1"/>
                </p:cNvSpPr>
                <p:nvPr/>
              </p:nvSpPr>
              <p:spPr bwMode="auto">
                <a:xfrm>
                  <a:off x="6862827" y="715968"/>
                  <a:ext cx="8496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8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6878721" y="1203674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9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6910227" y="1207585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0" name="Rectangle 160"/>
                <p:cNvSpPr>
                  <a:spLocks noChangeAspect="1" noChangeArrowheads="1"/>
                </p:cNvSpPr>
                <p:nvPr/>
              </p:nvSpPr>
              <p:spPr bwMode="auto">
                <a:xfrm>
                  <a:off x="6856033" y="1360402"/>
                  <a:ext cx="8496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11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7077419" y="1112064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2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7278472" y="1170760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13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7369912" y="1170760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14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448618" y="756113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5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7266055" y="754526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6" name="Line 16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264150" y="544975"/>
                  <a:ext cx="1588" cy="2095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7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266055" y="438613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8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7448618" y="438613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19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631181" y="544975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0" name="Line 164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440127" y="744595"/>
                  <a:ext cx="158752" cy="9048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1" name="Line 199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7446588" y="472302"/>
                  <a:ext cx="149226" cy="8572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2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7289265" y="568625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3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080801" y="757882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4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7443417" y="262083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5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7405811" y="116702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26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7497251" y="116702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27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631892" y="436584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28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7831994" y="340198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29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7923434" y="340198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430" name="CuadroTexto 429"/>
              <p:cNvSpPr txBox="1"/>
              <p:nvPr/>
            </p:nvSpPr>
            <p:spPr>
              <a:xfrm>
                <a:off x="8461426" y="1968316"/>
                <a:ext cx="135129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C" dirty="0"/>
                  <a:t>Flavonoids</a:t>
                </a:r>
              </a:p>
            </p:txBody>
          </p:sp>
          <p:grpSp>
            <p:nvGrpSpPr>
              <p:cNvPr id="12" name="Grupo 11"/>
              <p:cNvGrpSpPr/>
              <p:nvPr/>
            </p:nvGrpSpPr>
            <p:grpSpPr>
              <a:xfrm>
                <a:off x="8746485" y="3219088"/>
                <a:ext cx="1425890" cy="754081"/>
                <a:chOff x="7103783" y="3012928"/>
                <a:chExt cx="1425890" cy="754081"/>
              </a:xfrm>
            </p:grpSpPr>
            <p:sp>
              <p:nvSpPr>
                <p:cNvPr id="438" name="Rectangle 154"/>
                <p:cNvSpPr>
                  <a:spLocks noChangeAspect="1" noChangeArrowheads="1"/>
                </p:cNvSpPr>
                <p:nvPr/>
              </p:nvSpPr>
              <p:spPr bwMode="auto">
                <a:xfrm>
                  <a:off x="7215303" y="3370116"/>
                  <a:ext cx="65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39" name="Rectangle 155"/>
                <p:cNvSpPr>
                  <a:spLocks noChangeAspect="1" noChangeArrowheads="1"/>
                </p:cNvSpPr>
                <p:nvPr/>
              </p:nvSpPr>
              <p:spPr bwMode="auto">
                <a:xfrm>
                  <a:off x="8367746" y="3046070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40" name="Rectangle 156"/>
                <p:cNvSpPr>
                  <a:spLocks noChangeAspect="1" noChangeArrowheads="1"/>
                </p:cNvSpPr>
                <p:nvPr/>
              </p:nvSpPr>
              <p:spPr bwMode="auto">
                <a:xfrm>
                  <a:off x="8450297" y="3046070"/>
                  <a:ext cx="79376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44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650282" y="3330428"/>
                  <a:ext cx="182564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5" name="Line 164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650282" y="3314553"/>
                  <a:ext cx="158752" cy="9048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6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7467718" y="3328841"/>
                  <a:ext cx="182564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7" name="Line 16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467718" y="3119291"/>
                  <a:ext cx="1588" cy="2095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8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467718" y="3012928"/>
                  <a:ext cx="182564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9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7650282" y="3012928"/>
                  <a:ext cx="182564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0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832847" y="3119291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2" name="Line 185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832847" y="3012928"/>
                  <a:ext cx="182564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3" name="Line 187"/>
                <p:cNvSpPr>
                  <a:spLocks noChangeAspect="1" noChangeShapeType="1"/>
                </p:cNvSpPr>
                <p:nvPr/>
              </p:nvSpPr>
              <p:spPr bwMode="auto">
                <a:xfrm>
                  <a:off x="8018586" y="3012928"/>
                  <a:ext cx="182564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3" name="Line 199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7652933" y="3046070"/>
                  <a:ext cx="149226" cy="8572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4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7497515" y="3140488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5" name="Line 185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283946" y="3327286"/>
                  <a:ext cx="182564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6" name="Line 200"/>
                <p:cNvSpPr>
                  <a:spLocks noChangeAspect="1" noChangeShapeType="1"/>
                </p:cNvSpPr>
                <p:nvPr/>
              </p:nvSpPr>
              <p:spPr bwMode="auto">
                <a:xfrm>
                  <a:off x="7651989" y="3443141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7" name="Rectangle 155"/>
                <p:cNvSpPr>
                  <a:spLocks noChangeAspect="1" noChangeArrowheads="1"/>
                </p:cNvSpPr>
                <p:nvPr/>
              </p:nvSpPr>
              <p:spPr bwMode="auto">
                <a:xfrm>
                  <a:off x="8211981" y="3046706"/>
                  <a:ext cx="6893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C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58" name="Rectangle 156"/>
                <p:cNvSpPr>
                  <a:spLocks noChangeAspect="1" noChangeArrowheads="1"/>
                </p:cNvSpPr>
                <p:nvPr/>
              </p:nvSpPr>
              <p:spPr bwMode="auto">
                <a:xfrm>
                  <a:off x="8284372" y="3046706"/>
                  <a:ext cx="8496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59" name="Rectangle 155"/>
                <p:cNvSpPr>
                  <a:spLocks noChangeAspect="1" noChangeArrowheads="1"/>
                </p:cNvSpPr>
                <p:nvPr/>
              </p:nvSpPr>
              <p:spPr bwMode="auto">
                <a:xfrm>
                  <a:off x="7178712" y="3365968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60" name="Rectangle 156"/>
                <p:cNvSpPr>
                  <a:spLocks noChangeAspect="1" noChangeArrowheads="1"/>
                </p:cNvSpPr>
                <p:nvPr/>
              </p:nvSpPr>
              <p:spPr bwMode="auto">
                <a:xfrm>
                  <a:off x="7103783" y="3365968"/>
                  <a:ext cx="79376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61" name="Rectangle 155"/>
                <p:cNvSpPr>
                  <a:spLocks noChangeAspect="1" noChangeArrowheads="1"/>
                </p:cNvSpPr>
                <p:nvPr/>
              </p:nvSpPr>
              <p:spPr bwMode="auto">
                <a:xfrm>
                  <a:off x="7697829" y="3608041"/>
                  <a:ext cx="6893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C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63" name="Rectangle 156"/>
                <p:cNvSpPr>
                  <a:spLocks noChangeAspect="1" noChangeArrowheads="1"/>
                </p:cNvSpPr>
                <p:nvPr/>
              </p:nvSpPr>
              <p:spPr bwMode="auto">
                <a:xfrm>
                  <a:off x="7614455" y="3608677"/>
                  <a:ext cx="8496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64" name="Rectangle 161"/>
                <p:cNvSpPr>
                  <a:spLocks noChangeAspect="1" noChangeArrowheads="1"/>
                </p:cNvSpPr>
                <p:nvPr/>
              </p:nvSpPr>
              <p:spPr bwMode="auto">
                <a:xfrm>
                  <a:off x="7767067" y="3608259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65" name="Rectangle 162"/>
                <p:cNvSpPr>
                  <a:spLocks noChangeAspect="1" noChangeArrowheads="1"/>
                </p:cNvSpPr>
                <p:nvPr/>
              </p:nvSpPr>
              <p:spPr bwMode="auto">
                <a:xfrm>
                  <a:off x="7855967" y="3643184"/>
                  <a:ext cx="52388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800" dirty="0">
                      <a:ea typeface="Arial" charset="0"/>
                      <a:cs typeface="Arial" charset="0"/>
                    </a:rPr>
                    <a:t>3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466" name="CuadroTexto 465"/>
              <p:cNvSpPr txBox="1"/>
              <p:nvPr/>
            </p:nvSpPr>
            <p:spPr>
              <a:xfrm>
                <a:off x="8805380" y="3999259"/>
                <a:ext cx="13512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C" sz="1400" dirty="0"/>
                  <a:t>HCA derivatives</a:t>
                </a:r>
              </a:p>
            </p:txBody>
          </p:sp>
          <p:grpSp>
            <p:nvGrpSpPr>
              <p:cNvPr id="15" name="Grupo 14"/>
              <p:cNvGrpSpPr/>
              <p:nvPr/>
            </p:nvGrpSpPr>
            <p:grpSpPr>
              <a:xfrm>
                <a:off x="8465581" y="4769128"/>
                <a:ext cx="964572" cy="1446379"/>
                <a:chOff x="6585052" y="4906330"/>
                <a:chExt cx="964572" cy="1446379"/>
              </a:xfrm>
            </p:grpSpPr>
            <p:sp>
              <p:nvSpPr>
                <p:cNvPr id="468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808844" y="5537693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0" name="Line 16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172933" y="5646866"/>
                  <a:ext cx="1588" cy="2095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1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992465" y="5858684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3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991407" y="5326555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4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175029" y="5540859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6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992466" y="5228439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8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357592" y="5334801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79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174231" y="5012066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0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361663" y="5230180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1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179100" y="4906330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2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7365473" y="4906330"/>
                  <a:ext cx="182563" cy="106363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83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548036" y="5016502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4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809988" y="5653390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5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629188" y="5879509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6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626846" y="5994255"/>
                  <a:ext cx="1588" cy="211138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7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193506" y="4935960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18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7011468" y="5252594"/>
                  <a:ext cx="182563" cy="104775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grpSp>
              <p:nvGrpSpPr>
                <p:cNvPr id="519" name="Grupo 518"/>
                <p:cNvGrpSpPr/>
                <p:nvPr/>
              </p:nvGrpSpPr>
              <p:grpSpPr>
                <a:xfrm rot="19260000">
                  <a:off x="6831065" y="5404856"/>
                  <a:ext cx="115888" cy="171450"/>
                  <a:chOff x="-458278" y="1315096"/>
                  <a:chExt cx="115888" cy="171450"/>
                </a:xfrm>
              </p:grpSpPr>
              <p:sp>
                <p:nvSpPr>
                  <p:cNvPr id="520" name="Line 170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58278" y="1315096"/>
                    <a:ext cx="39688" cy="22225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1" name="Line 171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43991" y="1335733"/>
                    <a:ext cx="34925" cy="20638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2" name="Line 172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29703" y="1356371"/>
                    <a:ext cx="30163" cy="19050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3" name="Line 173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17003" y="1377008"/>
                    <a:ext cx="26988" cy="15875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4" name="Line 174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404303" y="1399233"/>
                    <a:ext cx="23813" cy="12700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5" name="Line 175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90016" y="1419871"/>
                    <a:ext cx="19050" cy="11113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6" name="Line 176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77316" y="1440508"/>
                    <a:ext cx="15875" cy="9525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7" name="Line 177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64616" y="1461146"/>
                    <a:ext cx="12700" cy="6350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528" name="Line 178"/>
                  <p:cNvSpPr>
                    <a:spLocks noChangeAspect="1" noChangeShapeType="1"/>
                  </p:cNvSpPr>
                  <p:nvPr/>
                </p:nvSpPr>
                <p:spPr bwMode="auto">
                  <a:xfrm flipV="1">
                    <a:off x="-350328" y="1481783"/>
                    <a:ext cx="7938" cy="4763"/>
                  </a:xfrm>
                  <a:prstGeom prst="line">
                    <a:avLst/>
                  </a:prstGeom>
                  <a:noFill/>
                  <a:ln w="11113" cap="rnd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sp>
              <p:nvSpPr>
                <p:cNvPr id="529" name="Rectangle 155"/>
                <p:cNvSpPr>
                  <a:spLocks noChangeAspect="1" noChangeArrowheads="1"/>
                </p:cNvSpPr>
                <p:nvPr/>
              </p:nvSpPr>
              <p:spPr bwMode="auto">
                <a:xfrm>
                  <a:off x="6696131" y="5358455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0" name="Rectangle 156"/>
                <p:cNvSpPr>
                  <a:spLocks noChangeAspect="1" noChangeArrowheads="1"/>
                </p:cNvSpPr>
                <p:nvPr/>
              </p:nvSpPr>
              <p:spPr bwMode="auto">
                <a:xfrm>
                  <a:off x="6621202" y="5358455"/>
                  <a:ext cx="79376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1" name="Rectangle 155"/>
                <p:cNvSpPr>
                  <a:spLocks noChangeAspect="1" noChangeArrowheads="1"/>
                </p:cNvSpPr>
                <p:nvPr/>
              </p:nvSpPr>
              <p:spPr bwMode="auto">
                <a:xfrm>
                  <a:off x="6883773" y="5912559"/>
                  <a:ext cx="84138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2" name="Rectangle 156"/>
                <p:cNvSpPr>
                  <a:spLocks noChangeAspect="1" noChangeArrowheads="1"/>
                </p:cNvSpPr>
                <p:nvPr/>
              </p:nvSpPr>
              <p:spPr bwMode="auto">
                <a:xfrm>
                  <a:off x="6808844" y="5912559"/>
                  <a:ext cx="79376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3" name="Rectangle 160"/>
                <p:cNvSpPr>
                  <a:spLocks noChangeAspect="1" noChangeArrowheads="1"/>
                </p:cNvSpPr>
                <p:nvPr/>
              </p:nvSpPr>
              <p:spPr bwMode="auto">
                <a:xfrm>
                  <a:off x="6585052" y="6193959"/>
                  <a:ext cx="68263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C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4" name="Rectangle 161"/>
                <p:cNvSpPr>
                  <a:spLocks noChangeAspect="1" noChangeArrowheads="1"/>
                </p:cNvSpPr>
                <p:nvPr/>
              </p:nvSpPr>
              <p:spPr bwMode="auto">
                <a:xfrm>
                  <a:off x="6669190" y="6193959"/>
                  <a:ext cx="79375" cy="1539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5" name="Rectangle 162"/>
                <p:cNvSpPr>
                  <a:spLocks noChangeAspect="1" noChangeArrowheads="1"/>
                </p:cNvSpPr>
                <p:nvPr/>
              </p:nvSpPr>
              <p:spPr bwMode="auto">
                <a:xfrm>
                  <a:off x="6758090" y="6228884"/>
                  <a:ext cx="52388" cy="1238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800" dirty="0">
                      <a:ea typeface="Arial" charset="0"/>
                      <a:cs typeface="Arial" charset="0"/>
                    </a:rPr>
                    <a:t>3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36" name="Line 200"/>
                <p:cNvSpPr>
                  <a:spLocks noChangeAspect="1" noChangeShapeType="1"/>
                </p:cNvSpPr>
                <p:nvPr/>
              </p:nvSpPr>
              <p:spPr bwMode="auto">
                <a:xfrm rot="-1980000">
                  <a:off x="7204314" y="5867593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7" name="Line 200"/>
                <p:cNvSpPr>
                  <a:spLocks noChangeAspect="1" noChangeShapeType="1"/>
                </p:cNvSpPr>
                <p:nvPr/>
              </p:nvSpPr>
              <p:spPr bwMode="auto">
                <a:xfrm rot="-1980000">
                  <a:off x="7223484" y="5825672"/>
                  <a:ext cx="1588" cy="171450"/>
                </a:xfrm>
                <a:prstGeom prst="line">
                  <a:avLst/>
                </a:prstGeom>
                <a:no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538" name="Rectangle 160"/>
                <p:cNvSpPr>
                  <a:spLocks noChangeAspect="1" noChangeArrowheads="1"/>
                </p:cNvSpPr>
                <p:nvPr/>
              </p:nvSpPr>
              <p:spPr bwMode="auto">
                <a:xfrm rot="-1980000">
                  <a:off x="7260292" y="5969139"/>
                  <a:ext cx="84960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542" name="CuadroTexto 541"/>
              <p:cNvSpPr txBox="1"/>
              <p:nvPr/>
            </p:nvSpPr>
            <p:spPr>
              <a:xfrm>
                <a:off x="8402604" y="6272004"/>
                <a:ext cx="126047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C" dirty="0"/>
                  <a:t>Fatty acids </a:t>
                </a:r>
              </a:p>
            </p:txBody>
          </p:sp>
          <p:sp>
            <p:nvSpPr>
              <p:cNvPr id="73" name="Elipse 72"/>
              <p:cNvSpPr/>
              <p:nvPr/>
            </p:nvSpPr>
            <p:spPr>
              <a:xfrm>
                <a:off x="3839219" y="1244236"/>
                <a:ext cx="4594013" cy="4594013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grpSp>
            <p:nvGrpSpPr>
              <p:cNvPr id="58" name="Grupo 57"/>
              <p:cNvGrpSpPr/>
              <p:nvPr/>
            </p:nvGrpSpPr>
            <p:grpSpPr>
              <a:xfrm>
                <a:off x="4533089" y="1388409"/>
                <a:ext cx="3236544" cy="4197624"/>
                <a:chOff x="3101449" y="1388409"/>
                <a:chExt cx="3236544" cy="4197624"/>
              </a:xfrm>
            </p:grpSpPr>
            <p:grpSp>
              <p:nvGrpSpPr>
                <p:cNvPr id="69" name="Grupo 68"/>
                <p:cNvGrpSpPr/>
                <p:nvPr/>
              </p:nvGrpSpPr>
              <p:grpSpPr>
                <a:xfrm>
                  <a:off x="3101449" y="1388409"/>
                  <a:ext cx="3236544" cy="4197624"/>
                  <a:chOff x="2859456" y="1375478"/>
                  <a:chExt cx="3236544" cy="4197624"/>
                </a:xfrm>
              </p:grpSpPr>
              <p:sp>
                <p:nvSpPr>
                  <p:cNvPr id="13" name="Forma libre 12"/>
                  <p:cNvSpPr/>
                  <p:nvPr/>
                </p:nvSpPr>
                <p:spPr>
                  <a:xfrm>
                    <a:off x="4143782" y="1960418"/>
                    <a:ext cx="132080" cy="2208276"/>
                  </a:xfrm>
                  <a:custGeom>
                    <a:avLst/>
                    <a:gdLst>
                      <a:gd name="connsiteX0" fmla="*/ 0 w 106680"/>
                      <a:gd name="connsiteY0" fmla="*/ 0 h 2240280"/>
                      <a:gd name="connsiteX1" fmla="*/ 83820 w 106680"/>
                      <a:gd name="connsiteY1" fmla="*/ 335280 h 2240280"/>
                      <a:gd name="connsiteX2" fmla="*/ 99060 w 106680"/>
                      <a:gd name="connsiteY2" fmla="*/ 1173480 h 2240280"/>
                      <a:gd name="connsiteX3" fmla="*/ 106680 w 106680"/>
                      <a:gd name="connsiteY3" fmla="*/ 2240280 h 2240280"/>
                      <a:gd name="connsiteX0" fmla="*/ 0 w 132080"/>
                      <a:gd name="connsiteY0" fmla="*/ 0 h 2240280"/>
                      <a:gd name="connsiteX1" fmla="*/ 109220 w 132080"/>
                      <a:gd name="connsiteY1" fmla="*/ 335280 h 2240280"/>
                      <a:gd name="connsiteX2" fmla="*/ 124460 w 132080"/>
                      <a:gd name="connsiteY2" fmla="*/ 1173480 h 2240280"/>
                      <a:gd name="connsiteX3" fmla="*/ 132080 w 132080"/>
                      <a:gd name="connsiteY3" fmla="*/ 2240280 h 224028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32080" h="2240280">
                        <a:moveTo>
                          <a:pt x="0" y="0"/>
                        </a:moveTo>
                        <a:cubicBezTo>
                          <a:pt x="33655" y="69850"/>
                          <a:pt x="88477" y="139700"/>
                          <a:pt x="109220" y="335280"/>
                        </a:cubicBezTo>
                        <a:cubicBezTo>
                          <a:pt x="129963" y="530860"/>
                          <a:pt x="120650" y="855980"/>
                          <a:pt x="124460" y="1173480"/>
                        </a:cubicBezTo>
                        <a:cubicBezTo>
                          <a:pt x="128270" y="1490980"/>
                          <a:pt x="130175" y="1865630"/>
                          <a:pt x="132080" y="2240280"/>
                        </a:cubicBezTo>
                      </a:path>
                    </a:pathLst>
                  </a:custGeom>
                  <a:ln w="38100">
                    <a:solidFill>
                      <a:schemeClr val="accent6"/>
                    </a:solidFill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14" name="Forma libre 13"/>
                  <p:cNvSpPr/>
                  <p:nvPr/>
                </p:nvSpPr>
                <p:spPr>
                  <a:xfrm>
                    <a:off x="4508869" y="1966782"/>
                    <a:ext cx="89574" cy="2201912"/>
                  </a:xfrm>
                  <a:custGeom>
                    <a:avLst/>
                    <a:gdLst>
                      <a:gd name="connsiteX0" fmla="*/ 39393 w 39393"/>
                      <a:gd name="connsiteY0" fmla="*/ 39552 h 2226492"/>
                      <a:gd name="connsiteX1" fmla="*/ 1293 w 39393"/>
                      <a:gd name="connsiteY1" fmla="*/ 138612 h 2226492"/>
                      <a:gd name="connsiteX2" fmla="*/ 8913 w 39393"/>
                      <a:gd name="connsiteY2" fmla="*/ 1174932 h 2226492"/>
                      <a:gd name="connsiteX3" fmla="*/ 8913 w 39393"/>
                      <a:gd name="connsiteY3" fmla="*/ 2226492 h 2226492"/>
                      <a:gd name="connsiteX0" fmla="*/ 31330 w 31330"/>
                      <a:gd name="connsiteY0" fmla="*/ 56289 h 2202589"/>
                      <a:gd name="connsiteX1" fmla="*/ 850 w 31330"/>
                      <a:gd name="connsiteY1" fmla="*/ 114709 h 2202589"/>
                      <a:gd name="connsiteX2" fmla="*/ 8470 w 31330"/>
                      <a:gd name="connsiteY2" fmla="*/ 1151029 h 2202589"/>
                      <a:gd name="connsiteX3" fmla="*/ 8470 w 31330"/>
                      <a:gd name="connsiteY3" fmla="*/ 2202589 h 2202589"/>
                      <a:gd name="connsiteX0" fmla="*/ 38668 w 38668"/>
                      <a:gd name="connsiteY0" fmla="*/ 30151 h 2176451"/>
                      <a:gd name="connsiteX1" fmla="*/ 568 w 38668"/>
                      <a:gd name="connsiteY1" fmla="*/ 149531 h 2176451"/>
                      <a:gd name="connsiteX2" fmla="*/ 15808 w 38668"/>
                      <a:gd name="connsiteY2" fmla="*/ 1124891 h 2176451"/>
                      <a:gd name="connsiteX3" fmla="*/ 15808 w 38668"/>
                      <a:gd name="connsiteY3" fmla="*/ 2176451 h 2176451"/>
                      <a:gd name="connsiteX0" fmla="*/ 89574 w 89574"/>
                      <a:gd name="connsiteY0" fmla="*/ 19036 h 2218676"/>
                      <a:gd name="connsiteX1" fmla="*/ 3214 w 89574"/>
                      <a:gd name="connsiteY1" fmla="*/ 191756 h 2218676"/>
                      <a:gd name="connsiteX2" fmla="*/ 18454 w 89574"/>
                      <a:gd name="connsiteY2" fmla="*/ 1167116 h 2218676"/>
                      <a:gd name="connsiteX3" fmla="*/ 18454 w 89574"/>
                      <a:gd name="connsiteY3" fmla="*/ 2218676 h 221867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89574" h="2218676">
                        <a:moveTo>
                          <a:pt x="89574" y="19036"/>
                        </a:moveTo>
                        <a:cubicBezTo>
                          <a:pt x="73064" y="-26049"/>
                          <a:pt x="15067" y="409"/>
                          <a:pt x="3214" y="191756"/>
                        </a:cubicBezTo>
                        <a:cubicBezTo>
                          <a:pt x="-8639" y="383103"/>
                          <a:pt x="15914" y="829296"/>
                          <a:pt x="18454" y="1167116"/>
                        </a:cubicBezTo>
                        <a:cubicBezTo>
                          <a:pt x="20994" y="1504936"/>
                          <a:pt x="19089" y="1866886"/>
                          <a:pt x="18454" y="2218676"/>
                        </a:cubicBezTo>
                      </a:path>
                    </a:pathLst>
                  </a:custGeom>
                  <a:ln w="38100">
                    <a:solidFill>
                      <a:schemeClr val="accent6"/>
                    </a:solidFill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" name="Forma libre 5"/>
                  <p:cNvSpPr/>
                  <p:nvPr/>
                </p:nvSpPr>
                <p:spPr>
                  <a:xfrm>
                    <a:off x="3478163" y="1530042"/>
                    <a:ext cx="731659" cy="620893"/>
                  </a:xfrm>
                  <a:custGeom>
                    <a:avLst/>
                    <a:gdLst>
                      <a:gd name="connsiteX0" fmla="*/ 724080 w 731659"/>
                      <a:gd name="connsiteY0" fmla="*/ 537115 h 622191"/>
                      <a:gd name="connsiteX1" fmla="*/ 663120 w 731659"/>
                      <a:gd name="connsiteY1" fmla="*/ 300895 h 622191"/>
                      <a:gd name="connsiteX2" fmla="*/ 525960 w 731659"/>
                      <a:gd name="connsiteY2" fmla="*/ 171355 h 622191"/>
                      <a:gd name="connsiteX3" fmla="*/ 327840 w 731659"/>
                      <a:gd name="connsiteY3" fmla="*/ 49435 h 622191"/>
                      <a:gd name="connsiteX4" fmla="*/ 15420 w 731659"/>
                      <a:gd name="connsiteY4" fmla="*/ 18955 h 622191"/>
                      <a:gd name="connsiteX5" fmla="*/ 68760 w 731659"/>
                      <a:gd name="connsiteY5" fmla="*/ 331375 h 622191"/>
                      <a:gd name="connsiteX6" fmla="*/ 251640 w 731659"/>
                      <a:gd name="connsiteY6" fmla="*/ 529495 h 622191"/>
                      <a:gd name="connsiteX7" fmla="*/ 495480 w 731659"/>
                      <a:gd name="connsiteY7" fmla="*/ 620935 h 622191"/>
                      <a:gd name="connsiteX8" fmla="*/ 724080 w 731659"/>
                      <a:gd name="connsiteY8" fmla="*/ 537115 h 622191"/>
                      <a:gd name="connsiteX0" fmla="*/ 724080 w 731659"/>
                      <a:gd name="connsiteY0" fmla="*/ 535817 h 620893"/>
                      <a:gd name="connsiteX1" fmla="*/ 663120 w 731659"/>
                      <a:gd name="connsiteY1" fmla="*/ 299597 h 620893"/>
                      <a:gd name="connsiteX2" fmla="*/ 525960 w 731659"/>
                      <a:gd name="connsiteY2" fmla="*/ 124337 h 620893"/>
                      <a:gd name="connsiteX3" fmla="*/ 327840 w 731659"/>
                      <a:gd name="connsiteY3" fmla="*/ 48137 h 620893"/>
                      <a:gd name="connsiteX4" fmla="*/ 15420 w 731659"/>
                      <a:gd name="connsiteY4" fmla="*/ 17657 h 620893"/>
                      <a:gd name="connsiteX5" fmla="*/ 68760 w 731659"/>
                      <a:gd name="connsiteY5" fmla="*/ 330077 h 620893"/>
                      <a:gd name="connsiteX6" fmla="*/ 251640 w 731659"/>
                      <a:gd name="connsiteY6" fmla="*/ 528197 h 620893"/>
                      <a:gd name="connsiteX7" fmla="*/ 495480 w 731659"/>
                      <a:gd name="connsiteY7" fmla="*/ 619637 h 620893"/>
                      <a:gd name="connsiteX8" fmla="*/ 724080 w 731659"/>
                      <a:gd name="connsiteY8" fmla="*/ 535817 h 62089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731659" h="620893">
                        <a:moveTo>
                          <a:pt x="724080" y="535817"/>
                        </a:moveTo>
                        <a:cubicBezTo>
                          <a:pt x="752020" y="482477"/>
                          <a:pt x="696140" y="368177"/>
                          <a:pt x="663120" y="299597"/>
                        </a:cubicBezTo>
                        <a:cubicBezTo>
                          <a:pt x="630100" y="231017"/>
                          <a:pt x="581840" y="166247"/>
                          <a:pt x="525960" y="124337"/>
                        </a:cubicBezTo>
                        <a:cubicBezTo>
                          <a:pt x="470080" y="82427"/>
                          <a:pt x="412930" y="65917"/>
                          <a:pt x="327840" y="48137"/>
                        </a:cubicBezTo>
                        <a:cubicBezTo>
                          <a:pt x="242750" y="30357"/>
                          <a:pt x="58600" y="-29333"/>
                          <a:pt x="15420" y="17657"/>
                        </a:cubicBezTo>
                        <a:cubicBezTo>
                          <a:pt x="-27760" y="64647"/>
                          <a:pt x="29390" y="244987"/>
                          <a:pt x="68760" y="330077"/>
                        </a:cubicBezTo>
                        <a:cubicBezTo>
                          <a:pt x="108130" y="415167"/>
                          <a:pt x="180520" y="479937"/>
                          <a:pt x="251640" y="528197"/>
                        </a:cubicBezTo>
                        <a:cubicBezTo>
                          <a:pt x="322760" y="576457"/>
                          <a:pt x="415470" y="610747"/>
                          <a:pt x="495480" y="619637"/>
                        </a:cubicBezTo>
                        <a:cubicBezTo>
                          <a:pt x="575490" y="628527"/>
                          <a:pt x="696140" y="589157"/>
                          <a:pt x="724080" y="535817"/>
                        </a:cubicBezTo>
                        <a:close/>
                      </a:path>
                    </a:pathLst>
                  </a:custGeom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6">
                      <a:shade val="50000"/>
                    </a:schemeClr>
                  </a:lnRef>
                  <a:fillRef idx="1">
                    <a:schemeClr val="accent6"/>
                  </a:fillRef>
                  <a:effectRef idx="0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8" name="Forma libre 7"/>
                  <p:cNvSpPr/>
                  <p:nvPr/>
                </p:nvSpPr>
                <p:spPr>
                  <a:xfrm>
                    <a:off x="3732512" y="2323357"/>
                    <a:ext cx="536649" cy="437455"/>
                  </a:xfrm>
                  <a:custGeom>
                    <a:avLst/>
                    <a:gdLst>
                      <a:gd name="connsiteX0" fmla="*/ 529933 w 532054"/>
                      <a:gd name="connsiteY0" fmla="*/ 417214 h 437455"/>
                      <a:gd name="connsiteX1" fmla="*/ 468973 w 532054"/>
                      <a:gd name="connsiteY1" fmla="*/ 196234 h 437455"/>
                      <a:gd name="connsiteX2" fmla="*/ 316573 w 532054"/>
                      <a:gd name="connsiteY2" fmla="*/ 74314 h 437455"/>
                      <a:gd name="connsiteX3" fmla="*/ 126073 w 532054"/>
                      <a:gd name="connsiteY3" fmla="*/ 13354 h 437455"/>
                      <a:gd name="connsiteX4" fmla="*/ 4153 w 532054"/>
                      <a:gd name="connsiteY4" fmla="*/ 13354 h 437455"/>
                      <a:gd name="connsiteX5" fmla="*/ 34633 w 532054"/>
                      <a:gd name="connsiteY5" fmla="*/ 158134 h 437455"/>
                      <a:gd name="connsiteX6" fmla="*/ 95593 w 532054"/>
                      <a:gd name="connsiteY6" fmla="*/ 272434 h 437455"/>
                      <a:gd name="connsiteX7" fmla="*/ 194653 w 532054"/>
                      <a:gd name="connsiteY7" fmla="*/ 401974 h 437455"/>
                      <a:gd name="connsiteX8" fmla="*/ 400393 w 532054"/>
                      <a:gd name="connsiteY8" fmla="*/ 424834 h 437455"/>
                      <a:gd name="connsiteX9" fmla="*/ 529933 w 532054"/>
                      <a:gd name="connsiteY9" fmla="*/ 417214 h 437455"/>
                      <a:gd name="connsiteX0" fmla="*/ 529523 w 531644"/>
                      <a:gd name="connsiteY0" fmla="*/ 417214 h 437455"/>
                      <a:gd name="connsiteX1" fmla="*/ 468563 w 531644"/>
                      <a:gd name="connsiteY1" fmla="*/ 196234 h 437455"/>
                      <a:gd name="connsiteX2" fmla="*/ 316163 w 531644"/>
                      <a:gd name="connsiteY2" fmla="*/ 74314 h 437455"/>
                      <a:gd name="connsiteX3" fmla="*/ 125663 w 531644"/>
                      <a:gd name="connsiteY3" fmla="*/ 13354 h 437455"/>
                      <a:gd name="connsiteX4" fmla="*/ 3743 w 531644"/>
                      <a:gd name="connsiteY4" fmla="*/ 13354 h 437455"/>
                      <a:gd name="connsiteX5" fmla="*/ 34223 w 531644"/>
                      <a:gd name="connsiteY5" fmla="*/ 158134 h 437455"/>
                      <a:gd name="connsiteX6" fmla="*/ 64703 w 531644"/>
                      <a:gd name="connsiteY6" fmla="*/ 257194 h 437455"/>
                      <a:gd name="connsiteX7" fmla="*/ 194243 w 531644"/>
                      <a:gd name="connsiteY7" fmla="*/ 401974 h 437455"/>
                      <a:gd name="connsiteX8" fmla="*/ 399983 w 531644"/>
                      <a:gd name="connsiteY8" fmla="*/ 424834 h 437455"/>
                      <a:gd name="connsiteX9" fmla="*/ 529523 w 531644"/>
                      <a:gd name="connsiteY9" fmla="*/ 417214 h 437455"/>
                      <a:gd name="connsiteX0" fmla="*/ 534528 w 536649"/>
                      <a:gd name="connsiteY0" fmla="*/ 417214 h 437455"/>
                      <a:gd name="connsiteX1" fmla="*/ 473568 w 536649"/>
                      <a:gd name="connsiteY1" fmla="*/ 196234 h 437455"/>
                      <a:gd name="connsiteX2" fmla="*/ 321168 w 536649"/>
                      <a:gd name="connsiteY2" fmla="*/ 74314 h 437455"/>
                      <a:gd name="connsiteX3" fmla="*/ 130668 w 536649"/>
                      <a:gd name="connsiteY3" fmla="*/ 13354 h 437455"/>
                      <a:gd name="connsiteX4" fmla="*/ 8748 w 536649"/>
                      <a:gd name="connsiteY4" fmla="*/ 13354 h 437455"/>
                      <a:gd name="connsiteX5" fmla="*/ 16368 w 536649"/>
                      <a:gd name="connsiteY5" fmla="*/ 158134 h 437455"/>
                      <a:gd name="connsiteX6" fmla="*/ 69708 w 536649"/>
                      <a:gd name="connsiteY6" fmla="*/ 257194 h 437455"/>
                      <a:gd name="connsiteX7" fmla="*/ 199248 w 536649"/>
                      <a:gd name="connsiteY7" fmla="*/ 401974 h 437455"/>
                      <a:gd name="connsiteX8" fmla="*/ 404988 w 536649"/>
                      <a:gd name="connsiteY8" fmla="*/ 424834 h 437455"/>
                      <a:gd name="connsiteX9" fmla="*/ 534528 w 536649"/>
                      <a:gd name="connsiteY9" fmla="*/ 417214 h 43745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536649" h="437455">
                        <a:moveTo>
                          <a:pt x="534528" y="417214"/>
                        </a:moveTo>
                        <a:cubicBezTo>
                          <a:pt x="545958" y="379114"/>
                          <a:pt x="509128" y="253384"/>
                          <a:pt x="473568" y="196234"/>
                        </a:cubicBezTo>
                        <a:cubicBezTo>
                          <a:pt x="438008" y="139084"/>
                          <a:pt x="378318" y="104794"/>
                          <a:pt x="321168" y="74314"/>
                        </a:cubicBezTo>
                        <a:cubicBezTo>
                          <a:pt x="264018" y="43834"/>
                          <a:pt x="182738" y="23514"/>
                          <a:pt x="130668" y="13354"/>
                        </a:cubicBezTo>
                        <a:cubicBezTo>
                          <a:pt x="78598" y="3194"/>
                          <a:pt x="27798" y="-10776"/>
                          <a:pt x="8748" y="13354"/>
                        </a:cubicBezTo>
                        <a:cubicBezTo>
                          <a:pt x="-10302" y="37484"/>
                          <a:pt x="6208" y="117494"/>
                          <a:pt x="16368" y="158134"/>
                        </a:cubicBezTo>
                        <a:cubicBezTo>
                          <a:pt x="26528" y="198774"/>
                          <a:pt x="39228" y="216554"/>
                          <a:pt x="69708" y="257194"/>
                        </a:cubicBezTo>
                        <a:cubicBezTo>
                          <a:pt x="100188" y="297834"/>
                          <a:pt x="148448" y="376574"/>
                          <a:pt x="199248" y="401974"/>
                        </a:cubicBezTo>
                        <a:cubicBezTo>
                          <a:pt x="250048" y="427374"/>
                          <a:pt x="354188" y="421024"/>
                          <a:pt x="404988" y="424834"/>
                        </a:cubicBezTo>
                        <a:cubicBezTo>
                          <a:pt x="455788" y="428644"/>
                          <a:pt x="523098" y="455314"/>
                          <a:pt x="534528" y="417214"/>
                        </a:cubicBezTo>
                        <a:close/>
                      </a:path>
                    </a:pathLst>
                  </a:custGeom>
                  <a:solidFill>
                    <a:schemeClr val="accent6"/>
                  </a:solidFill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9" name="Forma libre 8"/>
                  <p:cNvSpPr/>
                  <p:nvPr/>
                </p:nvSpPr>
                <p:spPr>
                  <a:xfrm rot="529660">
                    <a:off x="4536651" y="2311643"/>
                    <a:ext cx="512528" cy="460881"/>
                  </a:xfrm>
                  <a:custGeom>
                    <a:avLst/>
                    <a:gdLst>
                      <a:gd name="connsiteX0" fmla="*/ 3782 w 509725"/>
                      <a:gd name="connsiteY0" fmla="*/ 421369 h 463520"/>
                      <a:gd name="connsiteX1" fmla="*/ 34262 w 509725"/>
                      <a:gd name="connsiteY1" fmla="*/ 215629 h 463520"/>
                      <a:gd name="connsiteX2" fmla="*/ 133322 w 509725"/>
                      <a:gd name="connsiteY2" fmla="*/ 124189 h 463520"/>
                      <a:gd name="connsiteX3" fmla="*/ 323822 w 509725"/>
                      <a:gd name="connsiteY3" fmla="*/ 32749 h 463520"/>
                      <a:gd name="connsiteX4" fmla="*/ 491462 w 509725"/>
                      <a:gd name="connsiteY4" fmla="*/ 17509 h 463520"/>
                      <a:gd name="connsiteX5" fmla="*/ 483842 w 509725"/>
                      <a:gd name="connsiteY5" fmla="*/ 268969 h 463520"/>
                      <a:gd name="connsiteX6" fmla="*/ 300962 w 509725"/>
                      <a:gd name="connsiteY6" fmla="*/ 398509 h 463520"/>
                      <a:gd name="connsiteX7" fmla="*/ 110462 w 509725"/>
                      <a:gd name="connsiteY7" fmla="*/ 459469 h 463520"/>
                      <a:gd name="connsiteX8" fmla="*/ 3782 w 509725"/>
                      <a:gd name="connsiteY8" fmla="*/ 421369 h 463520"/>
                      <a:gd name="connsiteX0" fmla="*/ 3782 w 513389"/>
                      <a:gd name="connsiteY0" fmla="*/ 421369 h 463520"/>
                      <a:gd name="connsiteX1" fmla="*/ 34262 w 513389"/>
                      <a:gd name="connsiteY1" fmla="*/ 215629 h 463520"/>
                      <a:gd name="connsiteX2" fmla="*/ 133322 w 513389"/>
                      <a:gd name="connsiteY2" fmla="*/ 124189 h 463520"/>
                      <a:gd name="connsiteX3" fmla="*/ 270482 w 513389"/>
                      <a:gd name="connsiteY3" fmla="*/ 32749 h 463520"/>
                      <a:gd name="connsiteX4" fmla="*/ 491462 w 513389"/>
                      <a:gd name="connsiteY4" fmla="*/ 17509 h 463520"/>
                      <a:gd name="connsiteX5" fmla="*/ 483842 w 513389"/>
                      <a:gd name="connsiteY5" fmla="*/ 268969 h 463520"/>
                      <a:gd name="connsiteX6" fmla="*/ 300962 w 513389"/>
                      <a:gd name="connsiteY6" fmla="*/ 398509 h 463520"/>
                      <a:gd name="connsiteX7" fmla="*/ 110462 w 513389"/>
                      <a:gd name="connsiteY7" fmla="*/ 459469 h 463520"/>
                      <a:gd name="connsiteX8" fmla="*/ 3782 w 513389"/>
                      <a:gd name="connsiteY8" fmla="*/ 421369 h 463520"/>
                      <a:gd name="connsiteX0" fmla="*/ 3321 w 512928"/>
                      <a:gd name="connsiteY0" fmla="*/ 421369 h 463520"/>
                      <a:gd name="connsiteX1" fmla="*/ 33801 w 512928"/>
                      <a:gd name="connsiteY1" fmla="*/ 215629 h 463520"/>
                      <a:gd name="connsiteX2" fmla="*/ 102381 w 512928"/>
                      <a:gd name="connsiteY2" fmla="*/ 124189 h 463520"/>
                      <a:gd name="connsiteX3" fmla="*/ 270021 w 512928"/>
                      <a:gd name="connsiteY3" fmla="*/ 32749 h 463520"/>
                      <a:gd name="connsiteX4" fmla="*/ 491001 w 512928"/>
                      <a:gd name="connsiteY4" fmla="*/ 17509 h 463520"/>
                      <a:gd name="connsiteX5" fmla="*/ 483381 w 512928"/>
                      <a:gd name="connsiteY5" fmla="*/ 268969 h 463520"/>
                      <a:gd name="connsiteX6" fmla="*/ 300501 w 512928"/>
                      <a:gd name="connsiteY6" fmla="*/ 398509 h 463520"/>
                      <a:gd name="connsiteX7" fmla="*/ 110001 w 512928"/>
                      <a:gd name="connsiteY7" fmla="*/ 459469 h 463520"/>
                      <a:gd name="connsiteX8" fmla="*/ 3321 w 512928"/>
                      <a:gd name="connsiteY8" fmla="*/ 421369 h 463520"/>
                      <a:gd name="connsiteX0" fmla="*/ 3321 w 512528"/>
                      <a:gd name="connsiteY0" fmla="*/ 421369 h 460881"/>
                      <a:gd name="connsiteX1" fmla="*/ 33801 w 512528"/>
                      <a:gd name="connsiteY1" fmla="*/ 215629 h 460881"/>
                      <a:gd name="connsiteX2" fmla="*/ 102381 w 512528"/>
                      <a:gd name="connsiteY2" fmla="*/ 124189 h 460881"/>
                      <a:gd name="connsiteX3" fmla="*/ 270021 w 512528"/>
                      <a:gd name="connsiteY3" fmla="*/ 32749 h 460881"/>
                      <a:gd name="connsiteX4" fmla="*/ 491001 w 512528"/>
                      <a:gd name="connsiteY4" fmla="*/ 17509 h 460881"/>
                      <a:gd name="connsiteX5" fmla="*/ 483381 w 512528"/>
                      <a:gd name="connsiteY5" fmla="*/ 268969 h 460881"/>
                      <a:gd name="connsiteX6" fmla="*/ 308121 w 512528"/>
                      <a:gd name="connsiteY6" fmla="*/ 398509 h 460881"/>
                      <a:gd name="connsiteX7" fmla="*/ 110001 w 512528"/>
                      <a:gd name="connsiteY7" fmla="*/ 459469 h 460881"/>
                      <a:gd name="connsiteX8" fmla="*/ 3321 w 512528"/>
                      <a:gd name="connsiteY8" fmla="*/ 421369 h 46088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512528" h="460881">
                        <a:moveTo>
                          <a:pt x="3321" y="421369"/>
                        </a:moveTo>
                        <a:cubicBezTo>
                          <a:pt x="-9379" y="380729"/>
                          <a:pt x="17291" y="265159"/>
                          <a:pt x="33801" y="215629"/>
                        </a:cubicBezTo>
                        <a:cubicBezTo>
                          <a:pt x="50311" y="166099"/>
                          <a:pt x="63011" y="154669"/>
                          <a:pt x="102381" y="124189"/>
                        </a:cubicBezTo>
                        <a:cubicBezTo>
                          <a:pt x="141751" y="93709"/>
                          <a:pt x="205251" y="50529"/>
                          <a:pt x="270021" y="32749"/>
                        </a:cubicBezTo>
                        <a:cubicBezTo>
                          <a:pt x="334791" y="14969"/>
                          <a:pt x="455441" y="-21861"/>
                          <a:pt x="491001" y="17509"/>
                        </a:cubicBezTo>
                        <a:cubicBezTo>
                          <a:pt x="526561" y="56879"/>
                          <a:pt x="513861" y="205469"/>
                          <a:pt x="483381" y="268969"/>
                        </a:cubicBezTo>
                        <a:cubicBezTo>
                          <a:pt x="452901" y="332469"/>
                          <a:pt x="370351" y="366759"/>
                          <a:pt x="308121" y="398509"/>
                        </a:cubicBezTo>
                        <a:cubicBezTo>
                          <a:pt x="245891" y="430259"/>
                          <a:pt x="160801" y="455659"/>
                          <a:pt x="110001" y="459469"/>
                        </a:cubicBezTo>
                        <a:cubicBezTo>
                          <a:pt x="59201" y="463279"/>
                          <a:pt x="16021" y="462009"/>
                          <a:pt x="3321" y="421369"/>
                        </a:cubicBezTo>
                        <a:close/>
                      </a:path>
                    </a:pathLst>
                  </a:custGeom>
                  <a:solidFill>
                    <a:schemeClr val="accent6"/>
                  </a:solidFill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10" name="Forma libre 9"/>
                  <p:cNvSpPr/>
                  <p:nvPr/>
                </p:nvSpPr>
                <p:spPr>
                  <a:xfrm flipH="1">
                    <a:off x="4515612" y="1507165"/>
                    <a:ext cx="731659" cy="620893"/>
                  </a:xfrm>
                  <a:custGeom>
                    <a:avLst/>
                    <a:gdLst>
                      <a:gd name="connsiteX0" fmla="*/ 724080 w 731659"/>
                      <a:gd name="connsiteY0" fmla="*/ 537115 h 622191"/>
                      <a:gd name="connsiteX1" fmla="*/ 663120 w 731659"/>
                      <a:gd name="connsiteY1" fmla="*/ 300895 h 622191"/>
                      <a:gd name="connsiteX2" fmla="*/ 525960 w 731659"/>
                      <a:gd name="connsiteY2" fmla="*/ 171355 h 622191"/>
                      <a:gd name="connsiteX3" fmla="*/ 327840 w 731659"/>
                      <a:gd name="connsiteY3" fmla="*/ 49435 h 622191"/>
                      <a:gd name="connsiteX4" fmla="*/ 15420 w 731659"/>
                      <a:gd name="connsiteY4" fmla="*/ 18955 h 622191"/>
                      <a:gd name="connsiteX5" fmla="*/ 68760 w 731659"/>
                      <a:gd name="connsiteY5" fmla="*/ 331375 h 622191"/>
                      <a:gd name="connsiteX6" fmla="*/ 251640 w 731659"/>
                      <a:gd name="connsiteY6" fmla="*/ 529495 h 622191"/>
                      <a:gd name="connsiteX7" fmla="*/ 495480 w 731659"/>
                      <a:gd name="connsiteY7" fmla="*/ 620935 h 622191"/>
                      <a:gd name="connsiteX8" fmla="*/ 724080 w 731659"/>
                      <a:gd name="connsiteY8" fmla="*/ 537115 h 622191"/>
                      <a:gd name="connsiteX0" fmla="*/ 724080 w 731659"/>
                      <a:gd name="connsiteY0" fmla="*/ 535817 h 620893"/>
                      <a:gd name="connsiteX1" fmla="*/ 663120 w 731659"/>
                      <a:gd name="connsiteY1" fmla="*/ 299597 h 620893"/>
                      <a:gd name="connsiteX2" fmla="*/ 525960 w 731659"/>
                      <a:gd name="connsiteY2" fmla="*/ 124337 h 620893"/>
                      <a:gd name="connsiteX3" fmla="*/ 327840 w 731659"/>
                      <a:gd name="connsiteY3" fmla="*/ 48137 h 620893"/>
                      <a:gd name="connsiteX4" fmla="*/ 15420 w 731659"/>
                      <a:gd name="connsiteY4" fmla="*/ 17657 h 620893"/>
                      <a:gd name="connsiteX5" fmla="*/ 68760 w 731659"/>
                      <a:gd name="connsiteY5" fmla="*/ 330077 h 620893"/>
                      <a:gd name="connsiteX6" fmla="*/ 251640 w 731659"/>
                      <a:gd name="connsiteY6" fmla="*/ 528197 h 620893"/>
                      <a:gd name="connsiteX7" fmla="*/ 495480 w 731659"/>
                      <a:gd name="connsiteY7" fmla="*/ 619637 h 620893"/>
                      <a:gd name="connsiteX8" fmla="*/ 724080 w 731659"/>
                      <a:gd name="connsiteY8" fmla="*/ 535817 h 62089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731659" h="620893">
                        <a:moveTo>
                          <a:pt x="724080" y="535817"/>
                        </a:moveTo>
                        <a:cubicBezTo>
                          <a:pt x="752020" y="482477"/>
                          <a:pt x="696140" y="368177"/>
                          <a:pt x="663120" y="299597"/>
                        </a:cubicBezTo>
                        <a:cubicBezTo>
                          <a:pt x="630100" y="231017"/>
                          <a:pt x="581840" y="166247"/>
                          <a:pt x="525960" y="124337"/>
                        </a:cubicBezTo>
                        <a:cubicBezTo>
                          <a:pt x="470080" y="82427"/>
                          <a:pt x="412930" y="65917"/>
                          <a:pt x="327840" y="48137"/>
                        </a:cubicBezTo>
                        <a:cubicBezTo>
                          <a:pt x="242750" y="30357"/>
                          <a:pt x="58600" y="-29333"/>
                          <a:pt x="15420" y="17657"/>
                        </a:cubicBezTo>
                        <a:cubicBezTo>
                          <a:pt x="-27760" y="64647"/>
                          <a:pt x="29390" y="244987"/>
                          <a:pt x="68760" y="330077"/>
                        </a:cubicBezTo>
                        <a:cubicBezTo>
                          <a:pt x="108130" y="415167"/>
                          <a:pt x="180520" y="479937"/>
                          <a:pt x="251640" y="528197"/>
                        </a:cubicBezTo>
                        <a:cubicBezTo>
                          <a:pt x="322760" y="576457"/>
                          <a:pt x="415470" y="610747"/>
                          <a:pt x="495480" y="619637"/>
                        </a:cubicBezTo>
                        <a:cubicBezTo>
                          <a:pt x="575490" y="628527"/>
                          <a:pt x="696140" y="589157"/>
                          <a:pt x="724080" y="535817"/>
                        </a:cubicBezTo>
                        <a:close/>
                      </a:path>
                    </a:pathLst>
                  </a:custGeom>
                  <a:solidFill>
                    <a:schemeClr val="accent6"/>
                  </a:solidFill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cxnSp>
                <p:nvCxnSpPr>
                  <p:cNvPr id="16" name="Conector recto 15"/>
                  <p:cNvCxnSpPr/>
                  <p:nvPr/>
                </p:nvCxnSpPr>
                <p:spPr>
                  <a:xfrm>
                    <a:off x="3470543" y="4159458"/>
                    <a:ext cx="1909177" cy="0"/>
                  </a:xfrm>
                  <a:prstGeom prst="line">
                    <a:avLst/>
                  </a:prstGeom>
                  <a:ln w="38100"/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" name="Forma libre 17"/>
                  <p:cNvSpPr/>
                  <p:nvPr/>
                </p:nvSpPr>
                <p:spPr>
                  <a:xfrm rot="541068">
                    <a:off x="4064983" y="1389960"/>
                    <a:ext cx="376376" cy="687678"/>
                  </a:xfrm>
                  <a:custGeom>
                    <a:avLst/>
                    <a:gdLst>
                      <a:gd name="connsiteX0" fmla="*/ 204343 w 365746"/>
                      <a:gd name="connsiteY0" fmla="*/ 633727 h 687355"/>
                      <a:gd name="connsiteX1" fmla="*/ 6223 w 365746"/>
                      <a:gd name="connsiteY1" fmla="*/ 435607 h 687355"/>
                      <a:gd name="connsiteX2" fmla="*/ 59563 w 365746"/>
                      <a:gd name="connsiteY2" fmla="*/ 115567 h 687355"/>
                      <a:gd name="connsiteX3" fmla="*/ 158623 w 365746"/>
                      <a:gd name="connsiteY3" fmla="*/ 1267 h 687355"/>
                      <a:gd name="connsiteX4" fmla="*/ 303403 w 365746"/>
                      <a:gd name="connsiteY4" fmla="*/ 176527 h 687355"/>
                      <a:gd name="connsiteX5" fmla="*/ 364363 w 365746"/>
                      <a:gd name="connsiteY5" fmla="*/ 374647 h 687355"/>
                      <a:gd name="connsiteX6" fmla="*/ 250063 w 365746"/>
                      <a:gd name="connsiteY6" fmla="*/ 610867 h 687355"/>
                      <a:gd name="connsiteX7" fmla="*/ 189103 w 365746"/>
                      <a:gd name="connsiteY7" fmla="*/ 687067 h 687355"/>
                      <a:gd name="connsiteX8" fmla="*/ 204343 w 365746"/>
                      <a:gd name="connsiteY8" fmla="*/ 633727 h 687355"/>
                      <a:gd name="connsiteX0" fmla="*/ 123953 w 361556"/>
                      <a:gd name="connsiteY0" fmla="*/ 633727 h 687631"/>
                      <a:gd name="connsiteX1" fmla="*/ 2033 w 361556"/>
                      <a:gd name="connsiteY1" fmla="*/ 435607 h 687631"/>
                      <a:gd name="connsiteX2" fmla="*/ 55373 w 361556"/>
                      <a:gd name="connsiteY2" fmla="*/ 115567 h 687631"/>
                      <a:gd name="connsiteX3" fmla="*/ 154433 w 361556"/>
                      <a:gd name="connsiteY3" fmla="*/ 1267 h 687631"/>
                      <a:gd name="connsiteX4" fmla="*/ 299213 w 361556"/>
                      <a:gd name="connsiteY4" fmla="*/ 176527 h 687631"/>
                      <a:gd name="connsiteX5" fmla="*/ 360173 w 361556"/>
                      <a:gd name="connsiteY5" fmla="*/ 374647 h 687631"/>
                      <a:gd name="connsiteX6" fmla="*/ 245873 w 361556"/>
                      <a:gd name="connsiteY6" fmla="*/ 610867 h 687631"/>
                      <a:gd name="connsiteX7" fmla="*/ 184913 w 361556"/>
                      <a:gd name="connsiteY7" fmla="*/ 687067 h 687631"/>
                      <a:gd name="connsiteX8" fmla="*/ 123953 w 361556"/>
                      <a:gd name="connsiteY8" fmla="*/ 633727 h 687631"/>
                      <a:gd name="connsiteX0" fmla="*/ 138773 w 376376"/>
                      <a:gd name="connsiteY0" fmla="*/ 633658 h 687678"/>
                      <a:gd name="connsiteX1" fmla="*/ 1613 w 376376"/>
                      <a:gd name="connsiteY1" fmla="*/ 412678 h 687678"/>
                      <a:gd name="connsiteX2" fmla="*/ 70193 w 376376"/>
                      <a:gd name="connsiteY2" fmla="*/ 115498 h 687678"/>
                      <a:gd name="connsiteX3" fmla="*/ 169253 w 376376"/>
                      <a:gd name="connsiteY3" fmla="*/ 1198 h 687678"/>
                      <a:gd name="connsiteX4" fmla="*/ 314033 w 376376"/>
                      <a:gd name="connsiteY4" fmla="*/ 176458 h 687678"/>
                      <a:gd name="connsiteX5" fmla="*/ 374993 w 376376"/>
                      <a:gd name="connsiteY5" fmla="*/ 374578 h 687678"/>
                      <a:gd name="connsiteX6" fmla="*/ 260693 w 376376"/>
                      <a:gd name="connsiteY6" fmla="*/ 610798 h 687678"/>
                      <a:gd name="connsiteX7" fmla="*/ 199733 w 376376"/>
                      <a:gd name="connsiteY7" fmla="*/ 686998 h 687678"/>
                      <a:gd name="connsiteX8" fmla="*/ 138773 w 376376"/>
                      <a:gd name="connsiteY8" fmla="*/ 633658 h 68767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376376" h="687678">
                        <a:moveTo>
                          <a:pt x="138773" y="633658"/>
                        </a:moveTo>
                        <a:cubicBezTo>
                          <a:pt x="105753" y="587938"/>
                          <a:pt x="13043" y="499038"/>
                          <a:pt x="1613" y="412678"/>
                        </a:cubicBezTo>
                        <a:cubicBezTo>
                          <a:pt x="-9817" y="326318"/>
                          <a:pt x="42253" y="184078"/>
                          <a:pt x="70193" y="115498"/>
                        </a:cubicBezTo>
                        <a:cubicBezTo>
                          <a:pt x="98133" y="46918"/>
                          <a:pt x="128613" y="-8962"/>
                          <a:pt x="169253" y="1198"/>
                        </a:cubicBezTo>
                        <a:cubicBezTo>
                          <a:pt x="209893" y="11358"/>
                          <a:pt x="279743" y="114228"/>
                          <a:pt x="314033" y="176458"/>
                        </a:cubicBezTo>
                        <a:cubicBezTo>
                          <a:pt x="348323" y="238688"/>
                          <a:pt x="383883" y="302188"/>
                          <a:pt x="374993" y="374578"/>
                        </a:cubicBezTo>
                        <a:cubicBezTo>
                          <a:pt x="366103" y="446968"/>
                          <a:pt x="289903" y="558728"/>
                          <a:pt x="260693" y="610798"/>
                        </a:cubicBezTo>
                        <a:cubicBezTo>
                          <a:pt x="231483" y="662868"/>
                          <a:pt x="220053" y="683188"/>
                          <a:pt x="199733" y="686998"/>
                        </a:cubicBezTo>
                        <a:cubicBezTo>
                          <a:pt x="179413" y="690808"/>
                          <a:pt x="171793" y="679378"/>
                          <a:pt x="138773" y="633658"/>
                        </a:cubicBezTo>
                        <a:close/>
                      </a:path>
                    </a:pathLst>
                  </a:custGeom>
                  <a:solidFill>
                    <a:schemeClr val="accent6"/>
                  </a:solidFill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24" name="Forma libre 23"/>
                  <p:cNvSpPr/>
                  <p:nvPr/>
                </p:nvSpPr>
                <p:spPr>
                  <a:xfrm>
                    <a:off x="2859456" y="4173834"/>
                    <a:ext cx="1421135" cy="946404"/>
                  </a:xfrm>
                  <a:custGeom>
                    <a:avLst/>
                    <a:gdLst>
                      <a:gd name="connsiteX0" fmla="*/ 1828800 w 1828800"/>
                      <a:gd name="connsiteY0" fmla="*/ 0 h 1059180"/>
                      <a:gd name="connsiteX1" fmla="*/ 1630680 w 1828800"/>
                      <a:gd name="connsiteY1" fmla="*/ 76200 h 1059180"/>
                      <a:gd name="connsiteX2" fmla="*/ 1417320 w 1828800"/>
                      <a:gd name="connsiteY2" fmla="*/ 281940 h 1059180"/>
                      <a:gd name="connsiteX3" fmla="*/ 1219200 w 1828800"/>
                      <a:gd name="connsiteY3" fmla="*/ 441960 h 1059180"/>
                      <a:gd name="connsiteX4" fmla="*/ 937260 w 1828800"/>
                      <a:gd name="connsiteY4" fmla="*/ 525780 h 1059180"/>
                      <a:gd name="connsiteX5" fmla="*/ 510540 w 1828800"/>
                      <a:gd name="connsiteY5" fmla="*/ 609600 h 1059180"/>
                      <a:gd name="connsiteX6" fmla="*/ 388620 w 1828800"/>
                      <a:gd name="connsiteY6" fmla="*/ 708660 h 1059180"/>
                      <a:gd name="connsiteX7" fmla="*/ 121920 w 1828800"/>
                      <a:gd name="connsiteY7" fmla="*/ 815340 h 1059180"/>
                      <a:gd name="connsiteX8" fmla="*/ 0 w 1828800"/>
                      <a:gd name="connsiteY8" fmla="*/ 1059180 h 105918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1828800" h="1059180">
                        <a:moveTo>
                          <a:pt x="1828800" y="0"/>
                        </a:moveTo>
                        <a:cubicBezTo>
                          <a:pt x="1764030" y="14605"/>
                          <a:pt x="1699260" y="29210"/>
                          <a:pt x="1630680" y="76200"/>
                        </a:cubicBezTo>
                        <a:cubicBezTo>
                          <a:pt x="1562100" y="123190"/>
                          <a:pt x="1485900" y="220980"/>
                          <a:pt x="1417320" y="281940"/>
                        </a:cubicBezTo>
                        <a:cubicBezTo>
                          <a:pt x="1348740" y="342900"/>
                          <a:pt x="1299210" y="401320"/>
                          <a:pt x="1219200" y="441960"/>
                        </a:cubicBezTo>
                        <a:cubicBezTo>
                          <a:pt x="1139190" y="482600"/>
                          <a:pt x="1055370" y="497840"/>
                          <a:pt x="937260" y="525780"/>
                        </a:cubicBezTo>
                        <a:cubicBezTo>
                          <a:pt x="819150" y="553720"/>
                          <a:pt x="601980" y="579120"/>
                          <a:pt x="510540" y="609600"/>
                        </a:cubicBezTo>
                        <a:cubicBezTo>
                          <a:pt x="419100" y="640080"/>
                          <a:pt x="453390" y="674370"/>
                          <a:pt x="388620" y="708660"/>
                        </a:cubicBezTo>
                        <a:cubicBezTo>
                          <a:pt x="323850" y="742950"/>
                          <a:pt x="186690" y="756920"/>
                          <a:pt x="121920" y="815340"/>
                        </a:cubicBezTo>
                        <a:cubicBezTo>
                          <a:pt x="57150" y="873760"/>
                          <a:pt x="28575" y="966470"/>
                          <a:pt x="0" y="1059180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25" name="Forma libre 24"/>
                  <p:cNvSpPr/>
                  <p:nvPr/>
                </p:nvSpPr>
                <p:spPr>
                  <a:xfrm>
                    <a:off x="4507992" y="4168041"/>
                    <a:ext cx="1588008" cy="615115"/>
                  </a:xfrm>
                  <a:custGeom>
                    <a:avLst/>
                    <a:gdLst>
                      <a:gd name="connsiteX0" fmla="*/ 0 w 2034540"/>
                      <a:gd name="connsiteY0" fmla="*/ 0 h 541020"/>
                      <a:gd name="connsiteX1" fmla="*/ 251460 w 2034540"/>
                      <a:gd name="connsiteY1" fmla="*/ 91440 h 541020"/>
                      <a:gd name="connsiteX2" fmla="*/ 441960 w 2034540"/>
                      <a:gd name="connsiteY2" fmla="*/ 190500 h 541020"/>
                      <a:gd name="connsiteX3" fmla="*/ 731520 w 2034540"/>
                      <a:gd name="connsiteY3" fmla="*/ 297180 h 541020"/>
                      <a:gd name="connsiteX4" fmla="*/ 990600 w 2034540"/>
                      <a:gd name="connsiteY4" fmla="*/ 274320 h 541020"/>
                      <a:gd name="connsiteX5" fmla="*/ 1257300 w 2034540"/>
                      <a:gd name="connsiteY5" fmla="*/ 243840 h 541020"/>
                      <a:gd name="connsiteX6" fmla="*/ 1531620 w 2034540"/>
                      <a:gd name="connsiteY6" fmla="*/ 281940 h 541020"/>
                      <a:gd name="connsiteX7" fmla="*/ 1729740 w 2034540"/>
                      <a:gd name="connsiteY7" fmla="*/ 335280 h 541020"/>
                      <a:gd name="connsiteX8" fmla="*/ 1897380 w 2034540"/>
                      <a:gd name="connsiteY8" fmla="*/ 373380 h 541020"/>
                      <a:gd name="connsiteX9" fmla="*/ 2034540 w 2034540"/>
                      <a:gd name="connsiteY9" fmla="*/ 541020 h 54102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</a:cxnLst>
                    <a:rect l="l" t="t" r="r" b="b"/>
                    <a:pathLst>
                      <a:path w="2034540" h="541020">
                        <a:moveTo>
                          <a:pt x="0" y="0"/>
                        </a:moveTo>
                        <a:cubicBezTo>
                          <a:pt x="88900" y="29845"/>
                          <a:pt x="177800" y="59690"/>
                          <a:pt x="251460" y="91440"/>
                        </a:cubicBezTo>
                        <a:cubicBezTo>
                          <a:pt x="325120" y="123190"/>
                          <a:pt x="361950" y="156210"/>
                          <a:pt x="441960" y="190500"/>
                        </a:cubicBezTo>
                        <a:cubicBezTo>
                          <a:pt x="521970" y="224790"/>
                          <a:pt x="640080" y="283210"/>
                          <a:pt x="731520" y="297180"/>
                        </a:cubicBezTo>
                        <a:cubicBezTo>
                          <a:pt x="822960" y="311150"/>
                          <a:pt x="902970" y="283210"/>
                          <a:pt x="990600" y="274320"/>
                        </a:cubicBezTo>
                        <a:cubicBezTo>
                          <a:pt x="1078230" y="265430"/>
                          <a:pt x="1167130" y="242570"/>
                          <a:pt x="1257300" y="243840"/>
                        </a:cubicBezTo>
                        <a:cubicBezTo>
                          <a:pt x="1347470" y="245110"/>
                          <a:pt x="1452880" y="266700"/>
                          <a:pt x="1531620" y="281940"/>
                        </a:cubicBezTo>
                        <a:cubicBezTo>
                          <a:pt x="1610360" y="297180"/>
                          <a:pt x="1668780" y="320040"/>
                          <a:pt x="1729740" y="335280"/>
                        </a:cubicBezTo>
                        <a:cubicBezTo>
                          <a:pt x="1790700" y="350520"/>
                          <a:pt x="1846580" y="339090"/>
                          <a:pt x="1897380" y="373380"/>
                        </a:cubicBezTo>
                        <a:cubicBezTo>
                          <a:pt x="1948180" y="407670"/>
                          <a:pt x="1991360" y="474345"/>
                          <a:pt x="2034540" y="541020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26" name="Forma libre 25"/>
                  <p:cNvSpPr/>
                  <p:nvPr/>
                </p:nvSpPr>
                <p:spPr>
                  <a:xfrm>
                    <a:off x="3615306" y="4168041"/>
                    <a:ext cx="734116" cy="1099127"/>
                  </a:xfrm>
                  <a:custGeom>
                    <a:avLst/>
                    <a:gdLst>
                      <a:gd name="connsiteX0" fmla="*/ 729673 w 734116"/>
                      <a:gd name="connsiteY0" fmla="*/ 0 h 1099127"/>
                      <a:gd name="connsiteX1" fmla="*/ 729673 w 734116"/>
                      <a:gd name="connsiteY1" fmla="*/ 166254 h 1099127"/>
                      <a:gd name="connsiteX2" fmla="*/ 683491 w 734116"/>
                      <a:gd name="connsiteY2" fmla="*/ 295563 h 1099127"/>
                      <a:gd name="connsiteX3" fmla="*/ 591128 w 734116"/>
                      <a:gd name="connsiteY3" fmla="*/ 397163 h 1099127"/>
                      <a:gd name="connsiteX4" fmla="*/ 508000 w 734116"/>
                      <a:gd name="connsiteY4" fmla="*/ 480291 h 1099127"/>
                      <a:gd name="connsiteX5" fmla="*/ 452582 w 734116"/>
                      <a:gd name="connsiteY5" fmla="*/ 544945 h 1099127"/>
                      <a:gd name="connsiteX6" fmla="*/ 332509 w 734116"/>
                      <a:gd name="connsiteY6" fmla="*/ 581891 h 1099127"/>
                      <a:gd name="connsiteX7" fmla="*/ 212437 w 734116"/>
                      <a:gd name="connsiteY7" fmla="*/ 692727 h 1099127"/>
                      <a:gd name="connsiteX8" fmla="*/ 193964 w 734116"/>
                      <a:gd name="connsiteY8" fmla="*/ 822036 h 1099127"/>
                      <a:gd name="connsiteX9" fmla="*/ 193964 w 734116"/>
                      <a:gd name="connsiteY9" fmla="*/ 905163 h 1099127"/>
                      <a:gd name="connsiteX10" fmla="*/ 175491 w 734116"/>
                      <a:gd name="connsiteY10" fmla="*/ 1006763 h 1099127"/>
                      <a:gd name="connsiteX11" fmla="*/ 0 w 734116"/>
                      <a:gd name="connsiteY11" fmla="*/ 1099127 h 109912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</a:cxnLst>
                    <a:rect l="l" t="t" r="r" b="b"/>
                    <a:pathLst>
                      <a:path w="734116" h="1099127">
                        <a:moveTo>
                          <a:pt x="729673" y="0"/>
                        </a:moveTo>
                        <a:cubicBezTo>
                          <a:pt x="733521" y="58497"/>
                          <a:pt x="737370" y="116994"/>
                          <a:pt x="729673" y="166254"/>
                        </a:cubicBezTo>
                        <a:cubicBezTo>
                          <a:pt x="721976" y="215514"/>
                          <a:pt x="706582" y="257078"/>
                          <a:pt x="683491" y="295563"/>
                        </a:cubicBezTo>
                        <a:cubicBezTo>
                          <a:pt x="660400" y="334048"/>
                          <a:pt x="620376" y="366375"/>
                          <a:pt x="591128" y="397163"/>
                        </a:cubicBezTo>
                        <a:cubicBezTo>
                          <a:pt x="561879" y="427951"/>
                          <a:pt x="531091" y="455661"/>
                          <a:pt x="508000" y="480291"/>
                        </a:cubicBezTo>
                        <a:cubicBezTo>
                          <a:pt x="484909" y="504921"/>
                          <a:pt x="481830" y="528012"/>
                          <a:pt x="452582" y="544945"/>
                        </a:cubicBezTo>
                        <a:cubicBezTo>
                          <a:pt x="423334" y="561878"/>
                          <a:pt x="372533" y="557261"/>
                          <a:pt x="332509" y="581891"/>
                        </a:cubicBezTo>
                        <a:cubicBezTo>
                          <a:pt x="292485" y="606521"/>
                          <a:pt x="235528" y="652703"/>
                          <a:pt x="212437" y="692727"/>
                        </a:cubicBezTo>
                        <a:cubicBezTo>
                          <a:pt x="189346" y="732751"/>
                          <a:pt x="197043" y="786630"/>
                          <a:pt x="193964" y="822036"/>
                        </a:cubicBezTo>
                        <a:cubicBezTo>
                          <a:pt x="190885" y="857442"/>
                          <a:pt x="197043" y="874375"/>
                          <a:pt x="193964" y="905163"/>
                        </a:cubicBezTo>
                        <a:cubicBezTo>
                          <a:pt x="190885" y="935951"/>
                          <a:pt x="207818" y="974436"/>
                          <a:pt x="175491" y="1006763"/>
                        </a:cubicBezTo>
                        <a:cubicBezTo>
                          <a:pt x="143164" y="1039090"/>
                          <a:pt x="71582" y="1069108"/>
                          <a:pt x="0" y="1099127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27" name="Forma libre 26"/>
                  <p:cNvSpPr/>
                  <p:nvPr/>
                </p:nvSpPr>
                <p:spPr>
                  <a:xfrm>
                    <a:off x="4492927" y="4177644"/>
                    <a:ext cx="1016000" cy="628073"/>
                  </a:xfrm>
                  <a:custGeom>
                    <a:avLst/>
                    <a:gdLst>
                      <a:gd name="connsiteX0" fmla="*/ 0 w 1016000"/>
                      <a:gd name="connsiteY0" fmla="*/ 0 h 628073"/>
                      <a:gd name="connsiteX1" fmla="*/ 55418 w 1016000"/>
                      <a:gd name="connsiteY1" fmla="*/ 157019 h 628073"/>
                      <a:gd name="connsiteX2" fmla="*/ 157018 w 1016000"/>
                      <a:gd name="connsiteY2" fmla="*/ 230910 h 628073"/>
                      <a:gd name="connsiteX3" fmla="*/ 258618 w 1016000"/>
                      <a:gd name="connsiteY3" fmla="*/ 295564 h 628073"/>
                      <a:gd name="connsiteX4" fmla="*/ 332509 w 1016000"/>
                      <a:gd name="connsiteY4" fmla="*/ 378691 h 628073"/>
                      <a:gd name="connsiteX5" fmla="*/ 397164 w 1016000"/>
                      <a:gd name="connsiteY5" fmla="*/ 434110 h 628073"/>
                      <a:gd name="connsiteX6" fmla="*/ 517237 w 1016000"/>
                      <a:gd name="connsiteY6" fmla="*/ 434110 h 628073"/>
                      <a:gd name="connsiteX7" fmla="*/ 701964 w 1016000"/>
                      <a:gd name="connsiteY7" fmla="*/ 434110 h 628073"/>
                      <a:gd name="connsiteX8" fmla="*/ 729673 w 1016000"/>
                      <a:gd name="connsiteY8" fmla="*/ 424873 h 628073"/>
                      <a:gd name="connsiteX9" fmla="*/ 886691 w 1016000"/>
                      <a:gd name="connsiteY9" fmla="*/ 508000 h 628073"/>
                      <a:gd name="connsiteX10" fmla="*/ 1016000 w 1016000"/>
                      <a:gd name="connsiteY10" fmla="*/ 628073 h 628073"/>
                      <a:gd name="connsiteX0" fmla="*/ 0 w 1016000"/>
                      <a:gd name="connsiteY0" fmla="*/ 0 h 628073"/>
                      <a:gd name="connsiteX1" fmla="*/ 55418 w 1016000"/>
                      <a:gd name="connsiteY1" fmla="*/ 157019 h 628073"/>
                      <a:gd name="connsiteX2" fmla="*/ 157018 w 1016000"/>
                      <a:gd name="connsiteY2" fmla="*/ 230910 h 628073"/>
                      <a:gd name="connsiteX3" fmla="*/ 258618 w 1016000"/>
                      <a:gd name="connsiteY3" fmla="*/ 295564 h 628073"/>
                      <a:gd name="connsiteX4" fmla="*/ 332509 w 1016000"/>
                      <a:gd name="connsiteY4" fmla="*/ 378691 h 628073"/>
                      <a:gd name="connsiteX5" fmla="*/ 397164 w 1016000"/>
                      <a:gd name="connsiteY5" fmla="*/ 434110 h 628073"/>
                      <a:gd name="connsiteX6" fmla="*/ 517237 w 1016000"/>
                      <a:gd name="connsiteY6" fmla="*/ 434110 h 628073"/>
                      <a:gd name="connsiteX7" fmla="*/ 701964 w 1016000"/>
                      <a:gd name="connsiteY7" fmla="*/ 434110 h 628073"/>
                      <a:gd name="connsiteX8" fmla="*/ 767773 w 1016000"/>
                      <a:gd name="connsiteY8" fmla="*/ 443923 h 628073"/>
                      <a:gd name="connsiteX9" fmla="*/ 886691 w 1016000"/>
                      <a:gd name="connsiteY9" fmla="*/ 508000 h 628073"/>
                      <a:gd name="connsiteX10" fmla="*/ 1016000 w 1016000"/>
                      <a:gd name="connsiteY10" fmla="*/ 628073 h 62807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</a:cxnLst>
                    <a:rect l="l" t="t" r="r" b="b"/>
                    <a:pathLst>
                      <a:path w="1016000" h="628073">
                        <a:moveTo>
                          <a:pt x="0" y="0"/>
                        </a:moveTo>
                        <a:cubicBezTo>
                          <a:pt x="14624" y="59267"/>
                          <a:pt x="29248" y="118534"/>
                          <a:pt x="55418" y="157019"/>
                        </a:cubicBezTo>
                        <a:cubicBezTo>
                          <a:pt x="81588" y="195504"/>
                          <a:pt x="123151" y="207819"/>
                          <a:pt x="157018" y="230910"/>
                        </a:cubicBezTo>
                        <a:cubicBezTo>
                          <a:pt x="190885" y="254001"/>
                          <a:pt x="229370" y="270934"/>
                          <a:pt x="258618" y="295564"/>
                        </a:cubicBezTo>
                        <a:cubicBezTo>
                          <a:pt x="287866" y="320194"/>
                          <a:pt x="309418" y="355600"/>
                          <a:pt x="332509" y="378691"/>
                        </a:cubicBezTo>
                        <a:cubicBezTo>
                          <a:pt x="355600" y="401782"/>
                          <a:pt x="366376" y="424874"/>
                          <a:pt x="397164" y="434110"/>
                        </a:cubicBezTo>
                        <a:cubicBezTo>
                          <a:pt x="427952" y="443346"/>
                          <a:pt x="517237" y="434110"/>
                          <a:pt x="517237" y="434110"/>
                        </a:cubicBezTo>
                        <a:cubicBezTo>
                          <a:pt x="568037" y="434110"/>
                          <a:pt x="660208" y="432475"/>
                          <a:pt x="701964" y="434110"/>
                        </a:cubicBezTo>
                        <a:cubicBezTo>
                          <a:pt x="743720" y="435746"/>
                          <a:pt x="736985" y="431608"/>
                          <a:pt x="767773" y="443923"/>
                        </a:cubicBezTo>
                        <a:cubicBezTo>
                          <a:pt x="798561" y="456238"/>
                          <a:pt x="845320" y="477308"/>
                          <a:pt x="886691" y="508000"/>
                        </a:cubicBezTo>
                        <a:cubicBezTo>
                          <a:pt x="928062" y="538692"/>
                          <a:pt x="975206" y="584970"/>
                          <a:pt x="1016000" y="628073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30" name="Forma libre 29"/>
                  <p:cNvSpPr/>
                  <p:nvPr/>
                </p:nvSpPr>
                <p:spPr>
                  <a:xfrm>
                    <a:off x="3292932" y="4642755"/>
                    <a:ext cx="277091" cy="434109"/>
                  </a:xfrm>
                  <a:custGeom>
                    <a:avLst/>
                    <a:gdLst>
                      <a:gd name="connsiteX0" fmla="*/ 277091 w 277091"/>
                      <a:gd name="connsiteY0" fmla="*/ 0 h 434109"/>
                      <a:gd name="connsiteX1" fmla="*/ 175491 w 277091"/>
                      <a:gd name="connsiteY1" fmla="*/ 129309 h 434109"/>
                      <a:gd name="connsiteX2" fmla="*/ 101600 w 277091"/>
                      <a:gd name="connsiteY2" fmla="*/ 295563 h 434109"/>
                      <a:gd name="connsiteX3" fmla="*/ 0 w 277091"/>
                      <a:gd name="connsiteY3" fmla="*/ 434109 h 434109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277091" h="434109">
                        <a:moveTo>
                          <a:pt x="277091" y="0"/>
                        </a:moveTo>
                        <a:cubicBezTo>
                          <a:pt x="240915" y="40024"/>
                          <a:pt x="204739" y="80049"/>
                          <a:pt x="175491" y="129309"/>
                        </a:cubicBezTo>
                        <a:cubicBezTo>
                          <a:pt x="146242" y="178570"/>
                          <a:pt x="130848" y="244763"/>
                          <a:pt x="101600" y="295563"/>
                        </a:cubicBezTo>
                        <a:cubicBezTo>
                          <a:pt x="72352" y="346363"/>
                          <a:pt x="36176" y="390236"/>
                          <a:pt x="0" y="434109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31" name="Forma libre 30"/>
                  <p:cNvSpPr/>
                  <p:nvPr/>
                </p:nvSpPr>
                <p:spPr>
                  <a:xfrm>
                    <a:off x="3893487" y="4642755"/>
                    <a:ext cx="273164" cy="868218"/>
                  </a:xfrm>
                  <a:custGeom>
                    <a:avLst/>
                    <a:gdLst>
                      <a:gd name="connsiteX0" fmla="*/ 230909 w 273164"/>
                      <a:gd name="connsiteY0" fmla="*/ 0 h 868218"/>
                      <a:gd name="connsiteX1" fmla="*/ 258618 w 273164"/>
                      <a:gd name="connsiteY1" fmla="*/ 92364 h 868218"/>
                      <a:gd name="connsiteX2" fmla="*/ 267855 w 273164"/>
                      <a:gd name="connsiteY2" fmla="*/ 147782 h 868218"/>
                      <a:gd name="connsiteX3" fmla="*/ 175491 w 273164"/>
                      <a:gd name="connsiteY3" fmla="*/ 249382 h 868218"/>
                      <a:gd name="connsiteX4" fmla="*/ 129309 w 273164"/>
                      <a:gd name="connsiteY4" fmla="*/ 350982 h 868218"/>
                      <a:gd name="connsiteX5" fmla="*/ 92364 w 273164"/>
                      <a:gd name="connsiteY5" fmla="*/ 461818 h 868218"/>
                      <a:gd name="connsiteX6" fmla="*/ 73891 w 273164"/>
                      <a:gd name="connsiteY6" fmla="*/ 618837 h 868218"/>
                      <a:gd name="connsiteX7" fmla="*/ 73891 w 273164"/>
                      <a:gd name="connsiteY7" fmla="*/ 720437 h 868218"/>
                      <a:gd name="connsiteX8" fmla="*/ 0 w 273164"/>
                      <a:gd name="connsiteY8" fmla="*/ 868218 h 86821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273164" h="868218">
                        <a:moveTo>
                          <a:pt x="230909" y="0"/>
                        </a:moveTo>
                        <a:cubicBezTo>
                          <a:pt x="241684" y="33867"/>
                          <a:pt x="252460" y="67734"/>
                          <a:pt x="258618" y="92364"/>
                        </a:cubicBezTo>
                        <a:cubicBezTo>
                          <a:pt x="264776" y="116994"/>
                          <a:pt x="281709" y="121612"/>
                          <a:pt x="267855" y="147782"/>
                        </a:cubicBezTo>
                        <a:cubicBezTo>
                          <a:pt x="254001" y="173952"/>
                          <a:pt x="198582" y="215515"/>
                          <a:pt x="175491" y="249382"/>
                        </a:cubicBezTo>
                        <a:cubicBezTo>
                          <a:pt x="152400" y="283249"/>
                          <a:pt x="143163" y="315576"/>
                          <a:pt x="129309" y="350982"/>
                        </a:cubicBezTo>
                        <a:cubicBezTo>
                          <a:pt x="115454" y="386388"/>
                          <a:pt x="101600" y="417176"/>
                          <a:pt x="92364" y="461818"/>
                        </a:cubicBezTo>
                        <a:cubicBezTo>
                          <a:pt x="83128" y="506461"/>
                          <a:pt x="76970" y="575734"/>
                          <a:pt x="73891" y="618837"/>
                        </a:cubicBezTo>
                        <a:cubicBezTo>
                          <a:pt x="70812" y="661940"/>
                          <a:pt x="86206" y="678874"/>
                          <a:pt x="73891" y="720437"/>
                        </a:cubicBezTo>
                        <a:cubicBezTo>
                          <a:pt x="61576" y="762000"/>
                          <a:pt x="30788" y="815109"/>
                          <a:pt x="0" y="868218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32" name="Elipse 31"/>
                  <p:cNvSpPr/>
                  <p:nvPr/>
                </p:nvSpPr>
                <p:spPr>
                  <a:xfrm>
                    <a:off x="4239492" y="4138350"/>
                    <a:ext cx="314037" cy="45719"/>
                  </a:xfrm>
                  <a:prstGeom prst="ellipse">
                    <a:avLst/>
                  </a:prstGeom>
                </p:spPr>
                <p:style>
                  <a:lnRef idx="2">
                    <a:schemeClr val="dk1">
                      <a:shade val="50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39" name="Forma libre 38"/>
                  <p:cNvSpPr/>
                  <p:nvPr/>
                </p:nvSpPr>
                <p:spPr>
                  <a:xfrm>
                    <a:off x="4231594" y="4430317"/>
                    <a:ext cx="269624" cy="1089891"/>
                  </a:xfrm>
                  <a:custGeom>
                    <a:avLst/>
                    <a:gdLst>
                      <a:gd name="connsiteX0" fmla="*/ 0 w 275037"/>
                      <a:gd name="connsiteY0" fmla="*/ 905164 h 905164"/>
                      <a:gd name="connsiteX1" fmla="*/ 92363 w 275037"/>
                      <a:gd name="connsiteY1" fmla="*/ 775855 h 905164"/>
                      <a:gd name="connsiteX2" fmla="*/ 92363 w 275037"/>
                      <a:gd name="connsiteY2" fmla="*/ 637310 h 905164"/>
                      <a:gd name="connsiteX3" fmla="*/ 101600 w 275037"/>
                      <a:gd name="connsiteY3" fmla="*/ 434110 h 905164"/>
                      <a:gd name="connsiteX4" fmla="*/ 166254 w 275037"/>
                      <a:gd name="connsiteY4" fmla="*/ 267855 h 905164"/>
                      <a:gd name="connsiteX5" fmla="*/ 267854 w 275037"/>
                      <a:gd name="connsiteY5" fmla="*/ 157019 h 905164"/>
                      <a:gd name="connsiteX6" fmla="*/ 258618 w 275037"/>
                      <a:gd name="connsiteY6" fmla="*/ 0 h 905164"/>
                      <a:gd name="connsiteX0" fmla="*/ 0 w 269624"/>
                      <a:gd name="connsiteY0" fmla="*/ 1089891 h 1089891"/>
                      <a:gd name="connsiteX1" fmla="*/ 92363 w 269624"/>
                      <a:gd name="connsiteY1" fmla="*/ 960582 h 1089891"/>
                      <a:gd name="connsiteX2" fmla="*/ 92363 w 269624"/>
                      <a:gd name="connsiteY2" fmla="*/ 822037 h 1089891"/>
                      <a:gd name="connsiteX3" fmla="*/ 101600 w 269624"/>
                      <a:gd name="connsiteY3" fmla="*/ 618837 h 1089891"/>
                      <a:gd name="connsiteX4" fmla="*/ 166254 w 269624"/>
                      <a:gd name="connsiteY4" fmla="*/ 452582 h 1089891"/>
                      <a:gd name="connsiteX5" fmla="*/ 267854 w 269624"/>
                      <a:gd name="connsiteY5" fmla="*/ 341746 h 1089891"/>
                      <a:gd name="connsiteX6" fmla="*/ 73891 w 269624"/>
                      <a:gd name="connsiteY6" fmla="*/ 0 h 1089891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</a:cxnLst>
                    <a:rect l="l" t="t" r="r" b="b"/>
                    <a:pathLst>
                      <a:path w="269624" h="1089891">
                        <a:moveTo>
                          <a:pt x="0" y="1089891"/>
                        </a:moveTo>
                        <a:cubicBezTo>
                          <a:pt x="38484" y="1047557"/>
                          <a:pt x="76969" y="1005224"/>
                          <a:pt x="92363" y="960582"/>
                        </a:cubicBezTo>
                        <a:cubicBezTo>
                          <a:pt x="107757" y="915940"/>
                          <a:pt x="90824" y="878994"/>
                          <a:pt x="92363" y="822037"/>
                        </a:cubicBezTo>
                        <a:cubicBezTo>
                          <a:pt x="93903" y="765079"/>
                          <a:pt x="89285" y="680413"/>
                          <a:pt x="101600" y="618837"/>
                        </a:cubicBezTo>
                        <a:cubicBezTo>
                          <a:pt x="113915" y="557261"/>
                          <a:pt x="138545" y="498764"/>
                          <a:pt x="166254" y="452582"/>
                        </a:cubicBezTo>
                        <a:cubicBezTo>
                          <a:pt x="193963" y="406400"/>
                          <a:pt x="283248" y="417176"/>
                          <a:pt x="267854" y="341746"/>
                        </a:cubicBezTo>
                        <a:cubicBezTo>
                          <a:pt x="252460" y="266316"/>
                          <a:pt x="86206" y="56188"/>
                          <a:pt x="73891" y="0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40" name="Forma libre 39"/>
                  <p:cNvSpPr/>
                  <p:nvPr/>
                </p:nvSpPr>
                <p:spPr>
                  <a:xfrm>
                    <a:off x="4718522" y="4448790"/>
                    <a:ext cx="564810" cy="822037"/>
                  </a:xfrm>
                  <a:custGeom>
                    <a:avLst/>
                    <a:gdLst>
                      <a:gd name="connsiteX0" fmla="*/ 1392 w 564810"/>
                      <a:gd name="connsiteY0" fmla="*/ 0 h 822037"/>
                      <a:gd name="connsiteX1" fmla="*/ 19865 w 564810"/>
                      <a:gd name="connsiteY1" fmla="*/ 157018 h 822037"/>
                      <a:gd name="connsiteX2" fmla="*/ 139937 w 564810"/>
                      <a:gd name="connsiteY2" fmla="*/ 221673 h 822037"/>
                      <a:gd name="connsiteX3" fmla="*/ 241537 w 564810"/>
                      <a:gd name="connsiteY3" fmla="*/ 267855 h 822037"/>
                      <a:gd name="connsiteX4" fmla="*/ 315428 w 564810"/>
                      <a:gd name="connsiteY4" fmla="*/ 424873 h 822037"/>
                      <a:gd name="connsiteX5" fmla="*/ 370846 w 564810"/>
                      <a:gd name="connsiteY5" fmla="*/ 600364 h 822037"/>
                      <a:gd name="connsiteX6" fmla="*/ 426265 w 564810"/>
                      <a:gd name="connsiteY6" fmla="*/ 738909 h 822037"/>
                      <a:gd name="connsiteX7" fmla="*/ 564810 w 564810"/>
                      <a:gd name="connsiteY7" fmla="*/ 822037 h 82203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</a:cxnLst>
                    <a:rect l="l" t="t" r="r" b="b"/>
                    <a:pathLst>
                      <a:path w="564810" h="822037">
                        <a:moveTo>
                          <a:pt x="1392" y="0"/>
                        </a:moveTo>
                        <a:cubicBezTo>
                          <a:pt x="-917" y="60036"/>
                          <a:pt x="-3226" y="120073"/>
                          <a:pt x="19865" y="157018"/>
                        </a:cubicBezTo>
                        <a:cubicBezTo>
                          <a:pt x="42956" y="193963"/>
                          <a:pt x="102992" y="203200"/>
                          <a:pt x="139937" y="221673"/>
                        </a:cubicBezTo>
                        <a:cubicBezTo>
                          <a:pt x="176882" y="240146"/>
                          <a:pt x="212289" y="233988"/>
                          <a:pt x="241537" y="267855"/>
                        </a:cubicBezTo>
                        <a:cubicBezTo>
                          <a:pt x="270786" y="301722"/>
                          <a:pt x="293877" y="369455"/>
                          <a:pt x="315428" y="424873"/>
                        </a:cubicBezTo>
                        <a:cubicBezTo>
                          <a:pt x="336980" y="480291"/>
                          <a:pt x="352373" y="548025"/>
                          <a:pt x="370846" y="600364"/>
                        </a:cubicBezTo>
                        <a:cubicBezTo>
                          <a:pt x="389319" y="652703"/>
                          <a:pt x="393938" y="701964"/>
                          <a:pt x="426265" y="738909"/>
                        </a:cubicBezTo>
                        <a:cubicBezTo>
                          <a:pt x="458592" y="775854"/>
                          <a:pt x="511701" y="798945"/>
                          <a:pt x="564810" y="822037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41" name="Forma libre 40"/>
                  <p:cNvSpPr/>
                  <p:nvPr/>
                </p:nvSpPr>
                <p:spPr>
                  <a:xfrm>
                    <a:off x="4497895" y="4755874"/>
                    <a:ext cx="434110" cy="720437"/>
                  </a:xfrm>
                  <a:custGeom>
                    <a:avLst/>
                    <a:gdLst>
                      <a:gd name="connsiteX0" fmla="*/ 0 w 434110"/>
                      <a:gd name="connsiteY0" fmla="*/ 0 h 720437"/>
                      <a:gd name="connsiteX1" fmla="*/ 55419 w 434110"/>
                      <a:gd name="connsiteY1" fmla="*/ 120073 h 720437"/>
                      <a:gd name="connsiteX2" fmla="*/ 147782 w 434110"/>
                      <a:gd name="connsiteY2" fmla="*/ 240146 h 720437"/>
                      <a:gd name="connsiteX3" fmla="*/ 230910 w 434110"/>
                      <a:gd name="connsiteY3" fmla="*/ 378691 h 720437"/>
                      <a:gd name="connsiteX4" fmla="*/ 267855 w 434110"/>
                      <a:gd name="connsiteY4" fmla="*/ 563419 h 720437"/>
                      <a:gd name="connsiteX5" fmla="*/ 434110 w 434110"/>
                      <a:gd name="connsiteY5" fmla="*/ 701964 h 720437"/>
                      <a:gd name="connsiteX6" fmla="*/ 434110 w 434110"/>
                      <a:gd name="connsiteY6" fmla="*/ 701964 h 720437"/>
                      <a:gd name="connsiteX7" fmla="*/ 424873 w 434110"/>
                      <a:gd name="connsiteY7" fmla="*/ 720437 h 720437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</a:cxnLst>
                    <a:rect l="l" t="t" r="r" b="b"/>
                    <a:pathLst>
                      <a:path w="434110" h="720437">
                        <a:moveTo>
                          <a:pt x="0" y="0"/>
                        </a:moveTo>
                        <a:cubicBezTo>
                          <a:pt x="15394" y="40024"/>
                          <a:pt x="30789" y="80049"/>
                          <a:pt x="55419" y="120073"/>
                        </a:cubicBezTo>
                        <a:cubicBezTo>
                          <a:pt x="80049" y="160097"/>
                          <a:pt x="118533" y="197043"/>
                          <a:pt x="147782" y="240146"/>
                        </a:cubicBezTo>
                        <a:cubicBezTo>
                          <a:pt x="177031" y="283249"/>
                          <a:pt x="210898" y="324812"/>
                          <a:pt x="230910" y="378691"/>
                        </a:cubicBezTo>
                        <a:cubicBezTo>
                          <a:pt x="250922" y="432570"/>
                          <a:pt x="233988" y="509540"/>
                          <a:pt x="267855" y="563419"/>
                        </a:cubicBezTo>
                        <a:cubicBezTo>
                          <a:pt x="301722" y="617298"/>
                          <a:pt x="434110" y="701964"/>
                          <a:pt x="434110" y="701964"/>
                        </a:cubicBezTo>
                        <a:lnTo>
                          <a:pt x="434110" y="701964"/>
                        </a:lnTo>
                        <a:lnTo>
                          <a:pt x="424873" y="720437"/>
                        </a:ln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42" name="Forma libre 41"/>
                  <p:cNvSpPr/>
                  <p:nvPr/>
                </p:nvSpPr>
                <p:spPr>
                  <a:xfrm>
                    <a:off x="4416184" y="5080627"/>
                    <a:ext cx="286328" cy="406400"/>
                  </a:xfrm>
                  <a:custGeom>
                    <a:avLst/>
                    <a:gdLst>
                      <a:gd name="connsiteX0" fmla="*/ 286328 w 286328"/>
                      <a:gd name="connsiteY0" fmla="*/ 0 h 406400"/>
                      <a:gd name="connsiteX1" fmla="*/ 240146 w 286328"/>
                      <a:gd name="connsiteY1" fmla="*/ 147781 h 406400"/>
                      <a:gd name="connsiteX2" fmla="*/ 203200 w 286328"/>
                      <a:gd name="connsiteY2" fmla="*/ 221672 h 406400"/>
                      <a:gd name="connsiteX3" fmla="*/ 240146 w 286328"/>
                      <a:gd name="connsiteY3" fmla="*/ 323272 h 406400"/>
                      <a:gd name="connsiteX4" fmla="*/ 0 w 286328"/>
                      <a:gd name="connsiteY4" fmla="*/ 406400 h 40640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286328" h="406400">
                        <a:moveTo>
                          <a:pt x="286328" y="0"/>
                        </a:moveTo>
                        <a:cubicBezTo>
                          <a:pt x="270164" y="55418"/>
                          <a:pt x="254001" y="110836"/>
                          <a:pt x="240146" y="147781"/>
                        </a:cubicBezTo>
                        <a:cubicBezTo>
                          <a:pt x="226291" y="184726"/>
                          <a:pt x="203200" y="192424"/>
                          <a:pt x="203200" y="221672"/>
                        </a:cubicBezTo>
                        <a:cubicBezTo>
                          <a:pt x="203200" y="250920"/>
                          <a:pt x="274013" y="292484"/>
                          <a:pt x="240146" y="323272"/>
                        </a:cubicBezTo>
                        <a:cubicBezTo>
                          <a:pt x="206279" y="354060"/>
                          <a:pt x="103139" y="380230"/>
                          <a:pt x="0" y="406400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45" name="Forma libre 44"/>
                  <p:cNvSpPr/>
                  <p:nvPr/>
                </p:nvSpPr>
                <p:spPr>
                  <a:xfrm>
                    <a:off x="4495653" y="4294909"/>
                    <a:ext cx="649002" cy="1071418"/>
                  </a:xfrm>
                  <a:custGeom>
                    <a:avLst/>
                    <a:gdLst>
                      <a:gd name="connsiteX0" fmla="*/ 30165 w 649002"/>
                      <a:gd name="connsiteY0" fmla="*/ 0 h 1071418"/>
                      <a:gd name="connsiteX1" fmla="*/ 2456 w 649002"/>
                      <a:gd name="connsiteY1" fmla="*/ 203200 h 1071418"/>
                      <a:gd name="connsiteX2" fmla="*/ 85583 w 649002"/>
                      <a:gd name="connsiteY2" fmla="*/ 387927 h 1071418"/>
                      <a:gd name="connsiteX3" fmla="*/ 261074 w 649002"/>
                      <a:gd name="connsiteY3" fmla="*/ 471054 h 1071418"/>
                      <a:gd name="connsiteX4" fmla="*/ 371911 w 649002"/>
                      <a:gd name="connsiteY4" fmla="*/ 674254 h 1071418"/>
                      <a:gd name="connsiteX5" fmla="*/ 455038 w 649002"/>
                      <a:gd name="connsiteY5" fmla="*/ 914400 h 1071418"/>
                      <a:gd name="connsiteX6" fmla="*/ 649002 w 649002"/>
                      <a:gd name="connsiteY6" fmla="*/ 1071418 h 107141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</a:cxnLst>
                    <a:rect l="l" t="t" r="r" b="b"/>
                    <a:pathLst>
                      <a:path w="649002" h="1071418">
                        <a:moveTo>
                          <a:pt x="30165" y="0"/>
                        </a:moveTo>
                        <a:cubicBezTo>
                          <a:pt x="11692" y="69273"/>
                          <a:pt x="-6780" y="138546"/>
                          <a:pt x="2456" y="203200"/>
                        </a:cubicBezTo>
                        <a:cubicBezTo>
                          <a:pt x="11692" y="267855"/>
                          <a:pt x="42480" y="343285"/>
                          <a:pt x="85583" y="387927"/>
                        </a:cubicBezTo>
                        <a:cubicBezTo>
                          <a:pt x="128686" y="432569"/>
                          <a:pt x="213353" y="423333"/>
                          <a:pt x="261074" y="471054"/>
                        </a:cubicBezTo>
                        <a:cubicBezTo>
                          <a:pt x="308795" y="518775"/>
                          <a:pt x="339584" y="600363"/>
                          <a:pt x="371911" y="674254"/>
                        </a:cubicBezTo>
                        <a:cubicBezTo>
                          <a:pt x="404238" y="748145"/>
                          <a:pt x="408856" y="848206"/>
                          <a:pt x="455038" y="914400"/>
                        </a:cubicBezTo>
                        <a:cubicBezTo>
                          <a:pt x="501220" y="980594"/>
                          <a:pt x="575111" y="1026006"/>
                          <a:pt x="649002" y="1071418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46" name="Forma libre 45"/>
                  <p:cNvSpPr/>
                  <p:nvPr/>
                </p:nvSpPr>
                <p:spPr>
                  <a:xfrm>
                    <a:off x="4738255" y="4747491"/>
                    <a:ext cx="124721" cy="600363"/>
                  </a:xfrm>
                  <a:custGeom>
                    <a:avLst/>
                    <a:gdLst>
                      <a:gd name="connsiteX0" fmla="*/ 0 w 124721"/>
                      <a:gd name="connsiteY0" fmla="*/ 0 h 600363"/>
                      <a:gd name="connsiteX1" fmla="*/ 18472 w 124721"/>
                      <a:gd name="connsiteY1" fmla="*/ 101600 h 600363"/>
                      <a:gd name="connsiteX2" fmla="*/ 46181 w 124721"/>
                      <a:gd name="connsiteY2" fmla="*/ 323272 h 600363"/>
                      <a:gd name="connsiteX3" fmla="*/ 120072 w 124721"/>
                      <a:gd name="connsiteY3" fmla="*/ 461818 h 600363"/>
                      <a:gd name="connsiteX4" fmla="*/ 110836 w 124721"/>
                      <a:gd name="connsiteY4" fmla="*/ 600363 h 60036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124721" h="600363">
                        <a:moveTo>
                          <a:pt x="0" y="0"/>
                        </a:moveTo>
                        <a:cubicBezTo>
                          <a:pt x="5387" y="23860"/>
                          <a:pt x="10775" y="47721"/>
                          <a:pt x="18472" y="101600"/>
                        </a:cubicBezTo>
                        <a:cubicBezTo>
                          <a:pt x="26169" y="155479"/>
                          <a:pt x="29248" y="263236"/>
                          <a:pt x="46181" y="323272"/>
                        </a:cubicBezTo>
                        <a:cubicBezTo>
                          <a:pt x="63114" y="383308"/>
                          <a:pt x="109296" y="415636"/>
                          <a:pt x="120072" y="461818"/>
                        </a:cubicBezTo>
                        <a:cubicBezTo>
                          <a:pt x="130848" y="508000"/>
                          <a:pt x="120842" y="554181"/>
                          <a:pt x="110836" y="600363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47" name="Forma libre 46"/>
                  <p:cNvSpPr/>
                  <p:nvPr/>
                </p:nvSpPr>
                <p:spPr>
                  <a:xfrm>
                    <a:off x="3431833" y="4424218"/>
                    <a:ext cx="545790" cy="1006764"/>
                  </a:xfrm>
                  <a:custGeom>
                    <a:avLst/>
                    <a:gdLst>
                      <a:gd name="connsiteX0" fmla="*/ 512094 w 545790"/>
                      <a:gd name="connsiteY0" fmla="*/ 0 h 1006764"/>
                      <a:gd name="connsiteX1" fmla="*/ 530567 w 545790"/>
                      <a:gd name="connsiteY1" fmla="*/ 157018 h 1006764"/>
                      <a:gd name="connsiteX2" fmla="*/ 318131 w 545790"/>
                      <a:gd name="connsiteY2" fmla="*/ 360218 h 1006764"/>
                      <a:gd name="connsiteX3" fmla="*/ 151876 w 545790"/>
                      <a:gd name="connsiteY3" fmla="*/ 554182 h 1006764"/>
                      <a:gd name="connsiteX4" fmla="*/ 13331 w 545790"/>
                      <a:gd name="connsiteY4" fmla="*/ 849745 h 1006764"/>
                      <a:gd name="connsiteX5" fmla="*/ 13331 w 545790"/>
                      <a:gd name="connsiteY5" fmla="*/ 1006764 h 1006764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545790" h="1006764">
                        <a:moveTo>
                          <a:pt x="512094" y="0"/>
                        </a:moveTo>
                        <a:cubicBezTo>
                          <a:pt x="537494" y="48491"/>
                          <a:pt x="562894" y="96982"/>
                          <a:pt x="530567" y="157018"/>
                        </a:cubicBezTo>
                        <a:cubicBezTo>
                          <a:pt x="498240" y="217054"/>
                          <a:pt x="381246" y="294024"/>
                          <a:pt x="318131" y="360218"/>
                        </a:cubicBezTo>
                        <a:cubicBezTo>
                          <a:pt x="255016" y="426412"/>
                          <a:pt x="202676" y="472594"/>
                          <a:pt x="151876" y="554182"/>
                        </a:cubicBezTo>
                        <a:cubicBezTo>
                          <a:pt x="101076" y="635770"/>
                          <a:pt x="36422" y="774315"/>
                          <a:pt x="13331" y="849745"/>
                        </a:cubicBezTo>
                        <a:cubicBezTo>
                          <a:pt x="-9760" y="925175"/>
                          <a:pt x="1785" y="965969"/>
                          <a:pt x="13331" y="1006764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cxnSp>
                <p:nvCxnSpPr>
                  <p:cNvPr id="51" name="Conector curvado 50"/>
                  <p:cNvCxnSpPr>
                    <a:stCxn id="25" idx="4"/>
                  </p:cNvCxnSpPr>
                  <p:nvPr/>
                </p:nvCxnSpPr>
                <p:spPr>
                  <a:xfrm>
                    <a:off x="5281179" y="4479930"/>
                    <a:ext cx="657803" cy="350688"/>
                  </a:xfrm>
                  <a:prstGeom prst="curvedConnector5">
                    <a:avLst>
                      <a:gd name="adj1" fmla="val 34752"/>
                      <a:gd name="adj2" fmla="val 93233"/>
                      <a:gd name="adj3" fmla="val 65248"/>
                    </a:avLst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2" name="Forma libre 51"/>
                  <p:cNvSpPr/>
                  <p:nvPr/>
                </p:nvSpPr>
                <p:spPr>
                  <a:xfrm>
                    <a:off x="5190836" y="4618182"/>
                    <a:ext cx="159256" cy="517236"/>
                  </a:xfrm>
                  <a:custGeom>
                    <a:avLst/>
                    <a:gdLst>
                      <a:gd name="connsiteX0" fmla="*/ 0 w 159256"/>
                      <a:gd name="connsiteY0" fmla="*/ 0 h 517236"/>
                      <a:gd name="connsiteX1" fmla="*/ 110837 w 159256"/>
                      <a:gd name="connsiteY1" fmla="*/ 193963 h 517236"/>
                      <a:gd name="connsiteX2" fmla="*/ 157019 w 159256"/>
                      <a:gd name="connsiteY2" fmla="*/ 350981 h 517236"/>
                      <a:gd name="connsiteX3" fmla="*/ 147782 w 159256"/>
                      <a:gd name="connsiteY3" fmla="*/ 517236 h 517236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</a:cxnLst>
                    <a:rect l="l" t="t" r="r" b="b"/>
                    <a:pathLst>
                      <a:path w="159256" h="517236">
                        <a:moveTo>
                          <a:pt x="0" y="0"/>
                        </a:moveTo>
                        <a:cubicBezTo>
                          <a:pt x="42333" y="67733"/>
                          <a:pt x="84667" y="135466"/>
                          <a:pt x="110837" y="193963"/>
                        </a:cubicBezTo>
                        <a:cubicBezTo>
                          <a:pt x="137007" y="252460"/>
                          <a:pt x="150862" y="297102"/>
                          <a:pt x="157019" y="350981"/>
                        </a:cubicBezTo>
                        <a:cubicBezTo>
                          <a:pt x="163176" y="404860"/>
                          <a:pt x="155479" y="461048"/>
                          <a:pt x="147782" y="517236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7" name="Forma libre 56"/>
                  <p:cNvSpPr/>
                  <p:nvPr/>
                </p:nvSpPr>
                <p:spPr>
                  <a:xfrm>
                    <a:off x="3039172" y="4842721"/>
                    <a:ext cx="138690" cy="461818"/>
                  </a:xfrm>
                  <a:custGeom>
                    <a:avLst/>
                    <a:gdLst>
                      <a:gd name="connsiteX0" fmla="*/ 27709 w 138690"/>
                      <a:gd name="connsiteY0" fmla="*/ 0 h 350982"/>
                      <a:gd name="connsiteX1" fmla="*/ 110836 w 138690"/>
                      <a:gd name="connsiteY1" fmla="*/ 64655 h 350982"/>
                      <a:gd name="connsiteX2" fmla="*/ 138545 w 138690"/>
                      <a:gd name="connsiteY2" fmla="*/ 193964 h 350982"/>
                      <a:gd name="connsiteX3" fmla="*/ 101600 w 138690"/>
                      <a:gd name="connsiteY3" fmla="*/ 304800 h 350982"/>
                      <a:gd name="connsiteX4" fmla="*/ 0 w 138690"/>
                      <a:gd name="connsiteY4" fmla="*/ 350982 h 350982"/>
                      <a:gd name="connsiteX0" fmla="*/ 27709 w 138690"/>
                      <a:gd name="connsiteY0" fmla="*/ 0 h 461818"/>
                      <a:gd name="connsiteX1" fmla="*/ 110836 w 138690"/>
                      <a:gd name="connsiteY1" fmla="*/ 64655 h 461818"/>
                      <a:gd name="connsiteX2" fmla="*/ 138545 w 138690"/>
                      <a:gd name="connsiteY2" fmla="*/ 193964 h 461818"/>
                      <a:gd name="connsiteX3" fmla="*/ 101600 w 138690"/>
                      <a:gd name="connsiteY3" fmla="*/ 304800 h 461818"/>
                      <a:gd name="connsiteX4" fmla="*/ 0 w 138690"/>
                      <a:gd name="connsiteY4" fmla="*/ 461818 h 46181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</a:cxnLst>
                    <a:rect l="l" t="t" r="r" b="b"/>
                    <a:pathLst>
                      <a:path w="138690" h="461818">
                        <a:moveTo>
                          <a:pt x="27709" y="0"/>
                        </a:moveTo>
                        <a:cubicBezTo>
                          <a:pt x="60036" y="16164"/>
                          <a:pt x="92363" y="32328"/>
                          <a:pt x="110836" y="64655"/>
                        </a:cubicBezTo>
                        <a:cubicBezTo>
                          <a:pt x="129309" y="96982"/>
                          <a:pt x="140084" y="153940"/>
                          <a:pt x="138545" y="193964"/>
                        </a:cubicBezTo>
                        <a:cubicBezTo>
                          <a:pt x="137006" y="233988"/>
                          <a:pt x="124691" y="260158"/>
                          <a:pt x="101600" y="304800"/>
                        </a:cubicBezTo>
                        <a:cubicBezTo>
                          <a:pt x="78509" y="349442"/>
                          <a:pt x="39254" y="451812"/>
                          <a:pt x="0" y="461818"/>
                        </a:cubicBezTo>
                      </a:path>
                    </a:pathLst>
                  </a:cu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cxnSp>
                <p:nvCxnSpPr>
                  <p:cNvPr id="59" name="Conector curvado 58"/>
                  <p:cNvCxnSpPr/>
                  <p:nvPr/>
                </p:nvCxnSpPr>
                <p:spPr>
                  <a:xfrm>
                    <a:off x="3466176" y="5263324"/>
                    <a:ext cx="139264" cy="138545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Conector curvado 59"/>
                  <p:cNvCxnSpPr/>
                  <p:nvPr/>
                </p:nvCxnSpPr>
                <p:spPr>
                  <a:xfrm>
                    <a:off x="3129052" y="5184816"/>
                    <a:ext cx="139264" cy="138545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Conector curvado 60"/>
                  <p:cNvCxnSpPr/>
                  <p:nvPr/>
                </p:nvCxnSpPr>
                <p:spPr>
                  <a:xfrm rot="5400000">
                    <a:off x="4468318" y="5434197"/>
                    <a:ext cx="139264" cy="138545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Conector curvado 61"/>
                  <p:cNvCxnSpPr/>
                  <p:nvPr/>
                </p:nvCxnSpPr>
                <p:spPr>
                  <a:xfrm rot="5400000">
                    <a:off x="5623863" y="4836358"/>
                    <a:ext cx="139264" cy="138545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Conector curvado 62"/>
                  <p:cNvCxnSpPr/>
                  <p:nvPr/>
                </p:nvCxnSpPr>
                <p:spPr>
                  <a:xfrm>
                    <a:off x="3997265" y="5083217"/>
                    <a:ext cx="139264" cy="138545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" name="Conector curvado 63"/>
                  <p:cNvCxnSpPr/>
                  <p:nvPr/>
                </p:nvCxnSpPr>
                <p:spPr>
                  <a:xfrm>
                    <a:off x="3960319" y="5415724"/>
                    <a:ext cx="139264" cy="138545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Conector curvado 64"/>
                  <p:cNvCxnSpPr/>
                  <p:nvPr/>
                </p:nvCxnSpPr>
                <p:spPr>
                  <a:xfrm>
                    <a:off x="5058651" y="4975351"/>
                    <a:ext cx="188211" cy="41398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Conector curvado 66"/>
                  <p:cNvCxnSpPr/>
                  <p:nvPr/>
                </p:nvCxnSpPr>
                <p:spPr>
                  <a:xfrm>
                    <a:off x="5350092" y="4976755"/>
                    <a:ext cx="188211" cy="41398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8" name="Conector curvado 67"/>
                  <p:cNvCxnSpPr/>
                  <p:nvPr/>
                </p:nvCxnSpPr>
                <p:spPr>
                  <a:xfrm>
                    <a:off x="4334602" y="5130470"/>
                    <a:ext cx="188211" cy="41398"/>
                  </a:xfrm>
                  <a:prstGeom prst="curvedConnector3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" name="Forma libre 4"/>
                  <p:cNvSpPr/>
                  <p:nvPr/>
                </p:nvSpPr>
                <p:spPr>
                  <a:xfrm rot="694830">
                    <a:off x="4393236" y="1375478"/>
                    <a:ext cx="376376" cy="687678"/>
                  </a:xfrm>
                  <a:custGeom>
                    <a:avLst/>
                    <a:gdLst>
                      <a:gd name="connsiteX0" fmla="*/ 204343 w 365746"/>
                      <a:gd name="connsiteY0" fmla="*/ 633727 h 687355"/>
                      <a:gd name="connsiteX1" fmla="*/ 6223 w 365746"/>
                      <a:gd name="connsiteY1" fmla="*/ 435607 h 687355"/>
                      <a:gd name="connsiteX2" fmla="*/ 59563 w 365746"/>
                      <a:gd name="connsiteY2" fmla="*/ 115567 h 687355"/>
                      <a:gd name="connsiteX3" fmla="*/ 158623 w 365746"/>
                      <a:gd name="connsiteY3" fmla="*/ 1267 h 687355"/>
                      <a:gd name="connsiteX4" fmla="*/ 303403 w 365746"/>
                      <a:gd name="connsiteY4" fmla="*/ 176527 h 687355"/>
                      <a:gd name="connsiteX5" fmla="*/ 364363 w 365746"/>
                      <a:gd name="connsiteY5" fmla="*/ 374647 h 687355"/>
                      <a:gd name="connsiteX6" fmla="*/ 250063 w 365746"/>
                      <a:gd name="connsiteY6" fmla="*/ 610867 h 687355"/>
                      <a:gd name="connsiteX7" fmla="*/ 189103 w 365746"/>
                      <a:gd name="connsiteY7" fmla="*/ 687067 h 687355"/>
                      <a:gd name="connsiteX8" fmla="*/ 204343 w 365746"/>
                      <a:gd name="connsiteY8" fmla="*/ 633727 h 687355"/>
                      <a:gd name="connsiteX0" fmla="*/ 123953 w 361556"/>
                      <a:gd name="connsiteY0" fmla="*/ 633727 h 687631"/>
                      <a:gd name="connsiteX1" fmla="*/ 2033 w 361556"/>
                      <a:gd name="connsiteY1" fmla="*/ 435607 h 687631"/>
                      <a:gd name="connsiteX2" fmla="*/ 55373 w 361556"/>
                      <a:gd name="connsiteY2" fmla="*/ 115567 h 687631"/>
                      <a:gd name="connsiteX3" fmla="*/ 154433 w 361556"/>
                      <a:gd name="connsiteY3" fmla="*/ 1267 h 687631"/>
                      <a:gd name="connsiteX4" fmla="*/ 299213 w 361556"/>
                      <a:gd name="connsiteY4" fmla="*/ 176527 h 687631"/>
                      <a:gd name="connsiteX5" fmla="*/ 360173 w 361556"/>
                      <a:gd name="connsiteY5" fmla="*/ 374647 h 687631"/>
                      <a:gd name="connsiteX6" fmla="*/ 245873 w 361556"/>
                      <a:gd name="connsiteY6" fmla="*/ 610867 h 687631"/>
                      <a:gd name="connsiteX7" fmla="*/ 184913 w 361556"/>
                      <a:gd name="connsiteY7" fmla="*/ 687067 h 687631"/>
                      <a:gd name="connsiteX8" fmla="*/ 123953 w 361556"/>
                      <a:gd name="connsiteY8" fmla="*/ 633727 h 687631"/>
                      <a:gd name="connsiteX0" fmla="*/ 138773 w 376376"/>
                      <a:gd name="connsiteY0" fmla="*/ 633658 h 687678"/>
                      <a:gd name="connsiteX1" fmla="*/ 1613 w 376376"/>
                      <a:gd name="connsiteY1" fmla="*/ 412678 h 687678"/>
                      <a:gd name="connsiteX2" fmla="*/ 70193 w 376376"/>
                      <a:gd name="connsiteY2" fmla="*/ 115498 h 687678"/>
                      <a:gd name="connsiteX3" fmla="*/ 169253 w 376376"/>
                      <a:gd name="connsiteY3" fmla="*/ 1198 h 687678"/>
                      <a:gd name="connsiteX4" fmla="*/ 314033 w 376376"/>
                      <a:gd name="connsiteY4" fmla="*/ 176458 h 687678"/>
                      <a:gd name="connsiteX5" fmla="*/ 374993 w 376376"/>
                      <a:gd name="connsiteY5" fmla="*/ 374578 h 687678"/>
                      <a:gd name="connsiteX6" fmla="*/ 260693 w 376376"/>
                      <a:gd name="connsiteY6" fmla="*/ 610798 h 687678"/>
                      <a:gd name="connsiteX7" fmla="*/ 199733 w 376376"/>
                      <a:gd name="connsiteY7" fmla="*/ 686998 h 687678"/>
                      <a:gd name="connsiteX8" fmla="*/ 138773 w 376376"/>
                      <a:gd name="connsiteY8" fmla="*/ 633658 h 687678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376376" h="687678">
                        <a:moveTo>
                          <a:pt x="138773" y="633658"/>
                        </a:moveTo>
                        <a:cubicBezTo>
                          <a:pt x="105753" y="587938"/>
                          <a:pt x="13043" y="499038"/>
                          <a:pt x="1613" y="412678"/>
                        </a:cubicBezTo>
                        <a:cubicBezTo>
                          <a:pt x="-9817" y="326318"/>
                          <a:pt x="42253" y="184078"/>
                          <a:pt x="70193" y="115498"/>
                        </a:cubicBezTo>
                        <a:cubicBezTo>
                          <a:pt x="98133" y="46918"/>
                          <a:pt x="128613" y="-8962"/>
                          <a:pt x="169253" y="1198"/>
                        </a:cubicBezTo>
                        <a:cubicBezTo>
                          <a:pt x="209893" y="11358"/>
                          <a:pt x="279743" y="114228"/>
                          <a:pt x="314033" y="176458"/>
                        </a:cubicBezTo>
                        <a:cubicBezTo>
                          <a:pt x="348323" y="238688"/>
                          <a:pt x="383883" y="302188"/>
                          <a:pt x="374993" y="374578"/>
                        </a:cubicBezTo>
                        <a:cubicBezTo>
                          <a:pt x="366103" y="446968"/>
                          <a:pt x="289903" y="558728"/>
                          <a:pt x="260693" y="610798"/>
                        </a:cubicBezTo>
                        <a:cubicBezTo>
                          <a:pt x="231483" y="662868"/>
                          <a:pt x="220053" y="683188"/>
                          <a:pt x="199733" y="686998"/>
                        </a:cubicBezTo>
                        <a:cubicBezTo>
                          <a:pt x="179413" y="690808"/>
                          <a:pt x="171793" y="679378"/>
                          <a:pt x="138773" y="633658"/>
                        </a:cubicBezTo>
                        <a:close/>
                      </a:path>
                    </a:pathLst>
                  </a:custGeom>
                  <a:solidFill>
                    <a:schemeClr val="accent6"/>
                  </a:solidFill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</p:grpSp>
            <p:grpSp>
              <p:nvGrpSpPr>
                <p:cNvPr id="23" name="Grupo 22"/>
                <p:cNvGrpSpPr/>
                <p:nvPr/>
              </p:nvGrpSpPr>
              <p:grpSpPr>
                <a:xfrm>
                  <a:off x="3735082" y="1448529"/>
                  <a:ext cx="1996666" cy="2378330"/>
                  <a:chOff x="3735082" y="1448529"/>
                  <a:chExt cx="1996666" cy="2378330"/>
                </a:xfrm>
              </p:grpSpPr>
              <p:sp>
                <p:nvSpPr>
                  <p:cNvPr id="20" name="Forma libre 19"/>
                  <p:cNvSpPr/>
                  <p:nvPr/>
                </p:nvSpPr>
                <p:spPr>
                  <a:xfrm>
                    <a:off x="3736946" y="1563635"/>
                    <a:ext cx="712521" cy="528848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22" name="Forma libre 21"/>
                  <p:cNvSpPr/>
                  <p:nvPr/>
                </p:nvSpPr>
                <p:spPr>
                  <a:xfrm>
                    <a:off x="3754120" y="1717040"/>
                    <a:ext cx="193040" cy="66040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43" name="Forma libre 542"/>
                  <p:cNvSpPr/>
                  <p:nvPr/>
                </p:nvSpPr>
                <p:spPr>
                  <a:xfrm rot="18747120">
                    <a:off x="3941263" y="1638588"/>
                    <a:ext cx="155377" cy="85180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45" name="Forma libre 544"/>
                  <p:cNvSpPr/>
                  <p:nvPr/>
                </p:nvSpPr>
                <p:spPr>
                  <a:xfrm rot="481105">
                    <a:off x="3837568" y="1831144"/>
                    <a:ext cx="280100" cy="120152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46" name="Forma libre 545"/>
                  <p:cNvSpPr/>
                  <p:nvPr/>
                </p:nvSpPr>
                <p:spPr>
                  <a:xfrm rot="18336690">
                    <a:off x="4070979" y="1723412"/>
                    <a:ext cx="224701" cy="72500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47" name="Forma libre 546"/>
                  <p:cNvSpPr/>
                  <p:nvPr/>
                </p:nvSpPr>
                <p:spPr>
                  <a:xfrm rot="218746">
                    <a:off x="3951455" y="1948741"/>
                    <a:ext cx="306850" cy="10245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48" name="Forma libre 547"/>
                  <p:cNvSpPr/>
                  <p:nvPr/>
                </p:nvSpPr>
                <p:spPr>
                  <a:xfrm rot="20004818">
                    <a:off x="4216697" y="1858652"/>
                    <a:ext cx="104584" cy="4690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49" name="Forma libre 548"/>
                  <p:cNvSpPr/>
                  <p:nvPr/>
                </p:nvSpPr>
                <p:spPr>
                  <a:xfrm rot="442020">
                    <a:off x="4095448" y="2043848"/>
                    <a:ext cx="291622" cy="103852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94" name="Forma libre 593"/>
                  <p:cNvSpPr/>
                  <p:nvPr/>
                </p:nvSpPr>
                <p:spPr>
                  <a:xfrm rot="6509267">
                    <a:off x="4771868" y="1564127"/>
                    <a:ext cx="711130" cy="479934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95" name="Forma libre 594"/>
                  <p:cNvSpPr/>
                  <p:nvPr/>
                </p:nvSpPr>
                <p:spPr>
                  <a:xfrm rot="1305273">
                    <a:off x="5285998" y="1669576"/>
                    <a:ext cx="186068" cy="48946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96" name="Forma libre 595"/>
                  <p:cNvSpPr/>
                  <p:nvPr/>
                </p:nvSpPr>
                <p:spPr>
                  <a:xfrm rot="16653313">
                    <a:off x="5133729" y="1604224"/>
                    <a:ext cx="150238" cy="67786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97" name="Forma libre 596"/>
                  <p:cNvSpPr/>
                  <p:nvPr/>
                </p:nvSpPr>
                <p:spPr>
                  <a:xfrm rot="1305273">
                    <a:off x="5175987" y="1781109"/>
                    <a:ext cx="258005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98" name="Forma libre 597"/>
                  <p:cNvSpPr/>
                  <p:nvPr/>
                </p:nvSpPr>
                <p:spPr>
                  <a:xfrm rot="16653313">
                    <a:off x="4982665" y="1658078"/>
                    <a:ext cx="201601" cy="98708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599" name="Forma libre 598"/>
                  <p:cNvSpPr/>
                  <p:nvPr/>
                </p:nvSpPr>
                <p:spPr>
                  <a:xfrm rot="1305273">
                    <a:off x="5030720" y="1894340"/>
                    <a:ext cx="322596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00" name="Forma libre 599"/>
                  <p:cNvSpPr/>
                  <p:nvPr/>
                </p:nvSpPr>
                <p:spPr>
                  <a:xfrm rot="16653313">
                    <a:off x="4965168" y="1851633"/>
                    <a:ext cx="47484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01" name="Forma libre 600"/>
                  <p:cNvSpPr/>
                  <p:nvPr/>
                </p:nvSpPr>
                <p:spPr>
                  <a:xfrm rot="1305273">
                    <a:off x="4907915" y="1988609"/>
                    <a:ext cx="322596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02" name="Forma libre 601"/>
                  <p:cNvSpPr/>
                  <p:nvPr/>
                </p:nvSpPr>
                <p:spPr>
                  <a:xfrm rot="6509267">
                    <a:off x="4786528" y="2358617"/>
                    <a:ext cx="488257" cy="406105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44" name="Forma libre 643"/>
                  <p:cNvSpPr/>
                  <p:nvPr/>
                </p:nvSpPr>
                <p:spPr>
                  <a:xfrm rot="1305273">
                    <a:off x="5119998" y="2483816"/>
                    <a:ext cx="174240" cy="5112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45" name="Forma libre 644"/>
                  <p:cNvSpPr/>
                  <p:nvPr/>
                </p:nvSpPr>
                <p:spPr>
                  <a:xfrm rot="16653313">
                    <a:off x="4966903" y="2422761"/>
                    <a:ext cx="150238" cy="67786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46" name="Forma libre 645"/>
                  <p:cNvSpPr/>
                  <p:nvPr/>
                </p:nvSpPr>
                <p:spPr>
                  <a:xfrm rot="1305273">
                    <a:off x="4979533" y="2593023"/>
                    <a:ext cx="258005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47" name="Forma libre 646"/>
                  <p:cNvSpPr/>
                  <p:nvPr/>
                </p:nvSpPr>
                <p:spPr>
                  <a:xfrm rot="16653313">
                    <a:off x="4832174" y="2487900"/>
                    <a:ext cx="167357" cy="80004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48" name="Forma libre 647"/>
                  <p:cNvSpPr/>
                  <p:nvPr/>
                </p:nvSpPr>
                <p:spPr>
                  <a:xfrm rot="1305273">
                    <a:off x="4837964" y="2681912"/>
                    <a:ext cx="217159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49" name="Forma libre 648"/>
                  <p:cNvSpPr/>
                  <p:nvPr/>
                </p:nvSpPr>
                <p:spPr>
                  <a:xfrm rot="16653313">
                    <a:off x="5102374" y="2373979"/>
                    <a:ext cx="106719" cy="70122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0" name="Forma libre 649"/>
                  <p:cNvSpPr/>
                  <p:nvPr/>
                </p:nvSpPr>
                <p:spPr>
                  <a:xfrm rot="10329862">
                    <a:off x="4011214" y="2315697"/>
                    <a:ext cx="471849" cy="484976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1" name="Forma libre 650"/>
                  <p:cNvSpPr/>
                  <p:nvPr/>
                </p:nvSpPr>
                <p:spPr>
                  <a:xfrm rot="16653313">
                    <a:off x="4107938" y="2415771"/>
                    <a:ext cx="154247" cy="68586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2" name="Forma libre 651"/>
                  <p:cNvSpPr/>
                  <p:nvPr/>
                </p:nvSpPr>
                <p:spPr>
                  <a:xfrm rot="16653313">
                    <a:off x="4218266" y="2477197"/>
                    <a:ext cx="210654" cy="94396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3" name="Forma libre 652"/>
                  <p:cNvSpPr/>
                  <p:nvPr/>
                </p:nvSpPr>
                <p:spPr>
                  <a:xfrm rot="12886853">
                    <a:off x="4011723" y="2457766"/>
                    <a:ext cx="141521" cy="98544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4" name="Forma libre 653"/>
                  <p:cNvSpPr/>
                  <p:nvPr/>
                </p:nvSpPr>
                <p:spPr>
                  <a:xfrm rot="12886853">
                    <a:off x="4080793" y="2535427"/>
                    <a:ext cx="197888" cy="139467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5" name="Forma libre 654"/>
                  <p:cNvSpPr/>
                  <p:nvPr/>
                </p:nvSpPr>
                <p:spPr>
                  <a:xfrm rot="12886853">
                    <a:off x="4179467" y="2628005"/>
                    <a:ext cx="228203" cy="167976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6" name="Forma libre 655"/>
                  <p:cNvSpPr/>
                  <p:nvPr/>
                </p:nvSpPr>
                <p:spPr>
                  <a:xfrm rot="16653313">
                    <a:off x="4330772" y="2578140"/>
                    <a:ext cx="242698" cy="1034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7" name="Forma libre 656"/>
                  <p:cNvSpPr/>
                  <p:nvPr/>
                </p:nvSpPr>
                <p:spPr>
                  <a:xfrm rot="3440852">
                    <a:off x="4215061" y="1529874"/>
                    <a:ext cx="541072" cy="431800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8" name="Forma libre 657"/>
                  <p:cNvSpPr/>
                  <p:nvPr/>
                </p:nvSpPr>
                <p:spPr>
                  <a:xfrm rot="3440852">
                    <a:off x="4558041" y="1512520"/>
                    <a:ext cx="516936" cy="436233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59" name="Forma libre 658"/>
                  <p:cNvSpPr/>
                  <p:nvPr/>
                </p:nvSpPr>
                <p:spPr>
                  <a:xfrm rot="19971604">
                    <a:off x="4467675" y="1609595"/>
                    <a:ext cx="177573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0" name="Forma libre 659"/>
                  <p:cNvSpPr/>
                  <p:nvPr/>
                </p:nvSpPr>
                <p:spPr>
                  <a:xfrm rot="19971604">
                    <a:off x="4461914" y="1767775"/>
                    <a:ext cx="177573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1" name="Forma libre 660"/>
                  <p:cNvSpPr/>
                  <p:nvPr/>
                </p:nvSpPr>
                <p:spPr>
                  <a:xfrm rot="19971604">
                    <a:off x="4428840" y="1907570"/>
                    <a:ext cx="241557" cy="64545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2" name="Forma libre 661"/>
                  <p:cNvSpPr/>
                  <p:nvPr/>
                </p:nvSpPr>
                <p:spPr>
                  <a:xfrm rot="2192885" flipV="1">
                    <a:off x="4347979" y="1644133"/>
                    <a:ext cx="160077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3" name="Forma libre 662"/>
                  <p:cNvSpPr/>
                  <p:nvPr/>
                </p:nvSpPr>
                <p:spPr>
                  <a:xfrm rot="3638907">
                    <a:off x="4259592" y="1824333"/>
                    <a:ext cx="255449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4" name="Forma libre 663"/>
                  <p:cNvSpPr/>
                  <p:nvPr/>
                </p:nvSpPr>
                <p:spPr>
                  <a:xfrm rot="19971604">
                    <a:off x="4809727" y="1573390"/>
                    <a:ext cx="177573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5" name="Forma libre 664"/>
                  <p:cNvSpPr/>
                  <p:nvPr/>
                </p:nvSpPr>
                <p:spPr>
                  <a:xfrm rot="19971604">
                    <a:off x="4782231" y="1727917"/>
                    <a:ext cx="238021" cy="57004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6" name="Forma libre 665"/>
                  <p:cNvSpPr/>
                  <p:nvPr/>
                </p:nvSpPr>
                <p:spPr>
                  <a:xfrm rot="19971604">
                    <a:off x="4753975" y="1884789"/>
                    <a:ext cx="256904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7" name="Forma libre 666"/>
                  <p:cNvSpPr/>
                  <p:nvPr/>
                </p:nvSpPr>
                <p:spPr>
                  <a:xfrm rot="2192885" flipV="1">
                    <a:off x="4690031" y="1607928"/>
                    <a:ext cx="160077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8" name="Forma libre 667"/>
                  <p:cNvSpPr/>
                  <p:nvPr/>
                </p:nvSpPr>
                <p:spPr>
                  <a:xfrm rot="3638907">
                    <a:off x="4612667" y="1769283"/>
                    <a:ext cx="212208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69" name="Forma libre 668"/>
                  <p:cNvSpPr/>
                  <p:nvPr/>
                </p:nvSpPr>
                <p:spPr>
                  <a:xfrm rot="18430554">
                    <a:off x="3576786" y="3053599"/>
                    <a:ext cx="936727" cy="609793"/>
                  </a:xfrm>
                  <a:custGeom>
                    <a:avLst/>
                    <a:gdLst>
                      <a:gd name="connsiteX0" fmla="*/ 724080 w 731659"/>
                      <a:gd name="connsiteY0" fmla="*/ 537115 h 622191"/>
                      <a:gd name="connsiteX1" fmla="*/ 663120 w 731659"/>
                      <a:gd name="connsiteY1" fmla="*/ 300895 h 622191"/>
                      <a:gd name="connsiteX2" fmla="*/ 525960 w 731659"/>
                      <a:gd name="connsiteY2" fmla="*/ 171355 h 622191"/>
                      <a:gd name="connsiteX3" fmla="*/ 327840 w 731659"/>
                      <a:gd name="connsiteY3" fmla="*/ 49435 h 622191"/>
                      <a:gd name="connsiteX4" fmla="*/ 15420 w 731659"/>
                      <a:gd name="connsiteY4" fmla="*/ 18955 h 622191"/>
                      <a:gd name="connsiteX5" fmla="*/ 68760 w 731659"/>
                      <a:gd name="connsiteY5" fmla="*/ 331375 h 622191"/>
                      <a:gd name="connsiteX6" fmla="*/ 251640 w 731659"/>
                      <a:gd name="connsiteY6" fmla="*/ 529495 h 622191"/>
                      <a:gd name="connsiteX7" fmla="*/ 495480 w 731659"/>
                      <a:gd name="connsiteY7" fmla="*/ 620935 h 622191"/>
                      <a:gd name="connsiteX8" fmla="*/ 724080 w 731659"/>
                      <a:gd name="connsiteY8" fmla="*/ 537115 h 622191"/>
                      <a:gd name="connsiteX0" fmla="*/ 724080 w 731659"/>
                      <a:gd name="connsiteY0" fmla="*/ 535817 h 620893"/>
                      <a:gd name="connsiteX1" fmla="*/ 663120 w 731659"/>
                      <a:gd name="connsiteY1" fmla="*/ 299597 h 620893"/>
                      <a:gd name="connsiteX2" fmla="*/ 525960 w 731659"/>
                      <a:gd name="connsiteY2" fmla="*/ 124337 h 620893"/>
                      <a:gd name="connsiteX3" fmla="*/ 327840 w 731659"/>
                      <a:gd name="connsiteY3" fmla="*/ 48137 h 620893"/>
                      <a:gd name="connsiteX4" fmla="*/ 15420 w 731659"/>
                      <a:gd name="connsiteY4" fmla="*/ 17657 h 620893"/>
                      <a:gd name="connsiteX5" fmla="*/ 68760 w 731659"/>
                      <a:gd name="connsiteY5" fmla="*/ 330077 h 620893"/>
                      <a:gd name="connsiteX6" fmla="*/ 251640 w 731659"/>
                      <a:gd name="connsiteY6" fmla="*/ 528197 h 620893"/>
                      <a:gd name="connsiteX7" fmla="*/ 495480 w 731659"/>
                      <a:gd name="connsiteY7" fmla="*/ 619637 h 620893"/>
                      <a:gd name="connsiteX8" fmla="*/ 724080 w 731659"/>
                      <a:gd name="connsiteY8" fmla="*/ 535817 h 62089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731659" h="620893">
                        <a:moveTo>
                          <a:pt x="724080" y="535817"/>
                        </a:moveTo>
                        <a:cubicBezTo>
                          <a:pt x="752020" y="482477"/>
                          <a:pt x="696140" y="368177"/>
                          <a:pt x="663120" y="299597"/>
                        </a:cubicBezTo>
                        <a:cubicBezTo>
                          <a:pt x="630100" y="231017"/>
                          <a:pt x="581840" y="166247"/>
                          <a:pt x="525960" y="124337"/>
                        </a:cubicBezTo>
                        <a:cubicBezTo>
                          <a:pt x="470080" y="82427"/>
                          <a:pt x="412930" y="65917"/>
                          <a:pt x="327840" y="48137"/>
                        </a:cubicBezTo>
                        <a:cubicBezTo>
                          <a:pt x="242750" y="30357"/>
                          <a:pt x="58600" y="-29333"/>
                          <a:pt x="15420" y="17657"/>
                        </a:cubicBezTo>
                        <a:cubicBezTo>
                          <a:pt x="-27760" y="64647"/>
                          <a:pt x="29390" y="244987"/>
                          <a:pt x="68760" y="330077"/>
                        </a:cubicBezTo>
                        <a:cubicBezTo>
                          <a:pt x="108130" y="415167"/>
                          <a:pt x="180520" y="479937"/>
                          <a:pt x="251640" y="528197"/>
                        </a:cubicBezTo>
                        <a:cubicBezTo>
                          <a:pt x="322760" y="576457"/>
                          <a:pt x="415470" y="610747"/>
                          <a:pt x="495480" y="619637"/>
                        </a:cubicBezTo>
                        <a:cubicBezTo>
                          <a:pt x="575490" y="628527"/>
                          <a:pt x="696140" y="589157"/>
                          <a:pt x="724080" y="535817"/>
                        </a:cubicBezTo>
                        <a:close/>
                      </a:path>
                    </a:pathLst>
                  </a:custGeom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6">
                      <a:shade val="50000"/>
                    </a:schemeClr>
                  </a:lnRef>
                  <a:fillRef idx="1">
                    <a:schemeClr val="accent6"/>
                  </a:fillRef>
                  <a:effectRef idx="0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0" name="Forma libre 669"/>
                  <p:cNvSpPr/>
                  <p:nvPr/>
                </p:nvSpPr>
                <p:spPr>
                  <a:xfrm rot="13577051" flipV="1">
                    <a:off x="4773911" y="3003456"/>
                    <a:ext cx="936727" cy="609793"/>
                  </a:xfrm>
                  <a:custGeom>
                    <a:avLst/>
                    <a:gdLst>
                      <a:gd name="connsiteX0" fmla="*/ 724080 w 731659"/>
                      <a:gd name="connsiteY0" fmla="*/ 537115 h 622191"/>
                      <a:gd name="connsiteX1" fmla="*/ 663120 w 731659"/>
                      <a:gd name="connsiteY1" fmla="*/ 300895 h 622191"/>
                      <a:gd name="connsiteX2" fmla="*/ 525960 w 731659"/>
                      <a:gd name="connsiteY2" fmla="*/ 171355 h 622191"/>
                      <a:gd name="connsiteX3" fmla="*/ 327840 w 731659"/>
                      <a:gd name="connsiteY3" fmla="*/ 49435 h 622191"/>
                      <a:gd name="connsiteX4" fmla="*/ 15420 w 731659"/>
                      <a:gd name="connsiteY4" fmla="*/ 18955 h 622191"/>
                      <a:gd name="connsiteX5" fmla="*/ 68760 w 731659"/>
                      <a:gd name="connsiteY5" fmla="*/ 331375 h 622191"/>
                      <a:gd name="connsiteX6" fmla="*/ 251640 w 731659"/>
                      <a:gd name="connsiteY6" fmla="*/ 529495 h 622191"/>
                      <a:gd name="connsiteX7" fmla="*/ 495480 w 731659"/>
                      <a:gd name="connsiteY7" fmla="*/ 620935 h 622191"/>
                      <a:gd name="connsiteX8" fmla="*/ 724080 w 731659"/>
                      <a:gd name="connsiteY8" fmla="*/ 537115 h 622191"/>
                      <a:gd name="connsiteX0" fmla="*/ 724080 w 731659"/>
                      <a:gd name="connsiteY0" fmla="*/ 535817 h 620893"/>
                      <a:gd name="connsiteX1" fmla="*/ 663120 w 731659"/>
                      <a:gd name="connsiteY1" fmla="*/ 299597 h 620893"/>
                      <a:gd name="connsiteX2" fmla="*/ 525960 w 731659"/>
                      <a:gd name="connsiteY2" fmla="*/ 124337 h 620893"/>
                      <a:gd name="connsiteX3" fmla="*/ 327840 w 731659"/>
                      <a:gd name="connsiteY3" fmla="*/ 48137 h 620893"/>
                      <a:gd name="connsiteX4" fmla="*/ 15420 w 731659"/>
                      <a:gd name="connsiteY4" fmla="*/ 17657 h 620893"/>
                      <a:gd name="connsiteX5" fmla="*/ 68760 w 731659"/>
                      <a:gd name="connsiteY5" fmla="*/ 330077 h 620893"/>
                      <a:gd name="connsiteX6" fmla="*/ 251640 w 731659"/>
                      <a:gd name="connsiteY6" fmla="*/ 528197 h 620893"/>
                      <a:gd name="connsiteX7" fmla="*/ 495480 w 731659"/>
                      <a:gd name="connsiteY7" fmla="*/ 619637 h 620893"/>
                      <a:gd name="connsiteX8" fmla="*/ 724080 w 731659"/>
                      <a:gd name="connsiteY8" fmla="*/ 535817 h 62089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</a:cxnLst>
                    <a:rect l="l" t="t" r="r" b="b"/>
                    <a:pathLst>
                      <a:path w="731659" h="620893">
                        <a:moveTo>
                          <a:pt x="724080" y="535817"/>
                        </a:moveTo>
                        <a:cubicBezTo>
                          <a:pt x="752020" y="482477"/>
                          <a:pt x="696140" y="368177"/>
                          <a:pt x="663120" y="299597"/>
                        </a:cubicBezTo>
                        <a:cubicBezTo>
                          <a:pt x="630100" y="231017"/>
                          <a:pt x="581840" y="166247"/>
                          <a:pt x="525960" y="124337"/>
                        </a:cubicBezTo>
                        <a:cubicBezTo>
                          <a:pt x="470080" y="82427"/>
                          <a:pt x="412930" y="65917"/>
                          <a:pt x="327840" y="48137"/>
                        </a:cubicBezTo>
                        <a:cubicBezTo>
                          <a:pt x="242750" y="30357"/>
                          <a:pt x="58600" y="-29333"/>
                          <a:pt x="15420" y="17657"/>
                        </a:cubicBezTo>
                        <a:cubicBezTo>
                          <a:pt x="-27760" y="64647"/>
                          <a:pt x="29390" y="244987"/>
                          <a:pt x="68760" y="330077"/>
                        </a:cubicBezTo>
                        <a:cubicBezTo>
                          <a:pt x="108130" y="415167"/>
                          <a:pt x="180520" y="479937"/>
                          <a:pt x="251640" y="528197"/>
                        </a:cubicBezTo>
                        <a:cubicBezTo>
                          <a:pt x="322760" y="576457"/>
                          <a:pt x="415470" y="610747"/>
                          <a:pt x="495480" y="619637"/>
                        </a:cubicBezTo>
                        <a:cubicBezTo>
                          <a:pt x="575490" y="628527"/>
                          <a:pt x="696140" y="589157"/>
                          <a:pt x="724080" y="535817"/>
                        </a:cubicBezTo>
                        <a:close/>
                      </a:path>
                    </a:pathLst>
                  </a:custGeom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6">
                      <a:shade val="50000"/>
                    </a:schemeClr>
                  </a:lnRef>
                  <a:fillRef idx="1">
                    <a:schemeClr val="accent6"/>
                  </a:fillRef>
                  <a:effectRef idx="0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1" name="Forma libre 670"/>
                  <p:cNvSpPr/>
                  <p:nvPr/>
                </p:nvSpPr>
                <p:spPr>
                  <a:xfrm rot="18024260">
                    <a:off x="3604761" y="3054533"/>
                    <a:ext cx="863914" cy="587331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2" name="Forma libre 671"/>
                  <p:cNvSpPr/>
                  <p:nvPr/>
                </p:nvSpPr>
                <p:spPr>
                  <a:xfrm rot="21236938">
                    <a:off x="4783975" y="3075890"/>
                    <a:ext cx="947773" cy="413818"/>
                  </a:xfrm>
                  <a:custGeom>
                    <a:avLst/>
                    <a:gdLst>
                      <a:gd name="connsiteX0" fmla="*/ 701040 w 701040"/>
                      <a:gd name="connsiteY0" fmla="*/ 518160 h 518160"/>
                      <a:gd name="connsiteX1" fmla="*/ 497840 w 701040"/>
                      <a:gd name="connsiteY1" fmla="*/ 370840 h 518160"/>
                      <a:gd name="connsiteX2" fmla="*/ 304800 w 701040"/>
                      <a:gd name="connsiteY2" fmla="*/ 223520 h 518160"/>
                      <a:gd name="connsiteX3" fmla="*/ 111760 w 701040"/>
                      <a:gd name="connsiteY3" fmla="*/ 81280 h 518160"/>
                      <a:gd name="connsiteX4" fmla="*/ 0 w 701040"/>
                      <a:gd name="connsiteY4" fmla="*/ 0 h 518160"/>
                      <a:gd name="connsiteX5" fmla="*/ 0 w 701040"/>
                      <a:gd name="connsiteY5" fmla="*/ 0 h 51816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</a:cxnLst>
                    <a:rect l="l" t="t" r="r" b="b"/>
                    <a:pathLst>
                      <a:path w="701040" h="518160">
                        <a:moveTo>
                          <a:pt x="701040" y="518160"/>
                        </a:moveTo>
                        <a:lnTo>
                          <a:pt x="497840" y="370840"/>
                        </a:lnTo>
                        <a:cubicBezTo>
                          <a:pt x="431800" y="321733"/>
                          <a:pt x="369147" y="271780"/>
                          <a:pt x="304800" y="223520"/>
                        </a:cubicBezTo>
                        <a:cubicBezTo>
                          <a:pt x="240453" y="175260"/>
                          <a:pt x="111760" y="81280"/>
                          <a:pt x="111760" y="81280"/>
                        </a:cubicBezTo>
                        <a:lnTo>
                          <a:pt x="0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9050"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4" name="Forma libre 673"/>
                  <p:cNvSpPr/>
                  <p:nvPr/>
                </p:nvSpPr>
                <p:spPr>
                  <a:xfrm rot="17696783">
                    <a:off x="3720157" y="3510566"/>
                    <a:ext cx="224701" cy="72500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5" name="Forma libre 674"/>
                  <p:cNvSpPr/>
                  <p:nvPr/>
                </p:nvSpPr>
                <p:spPr>
                  <a:xfrm rot="2344901">
                    <a:off x="3735082" y="3310397"/>
                    <a:ext cx="224701" cy="72500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6" name="Forma libre 675"/>
                  <p:cNvSpPr/>
                  <p:nvPr/>
                </p:nvSpPr>
                <p:spPr>
                  <a:xfrm rot="17696783">
                    <a:off x="3866324" y="3459486"/>
                    <a:ext cx="278645" cy="103325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7" name="Forma libre 676"/>
                  <p:cNvSpPr/>
                  <p:nvPr/>
                </p:nvSpPr>
                <p:spPr>
                  <a:xfrm rot="2344901">
                    <a:off x="3883585" y="3218731"/>
                    <a:ext cx="259411" cy="50967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8" name="Forma libre 677"/>
                  <p:cNvSpPr/>
                  <p:nvPr/>
                </p:nvSpPr>
                <p:spPr>
                  <a:xfrm rot="17696783">
                    <a:off x="4021873" y="3393237"/>
                    <a:ext cx="278645" cy="103325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79" name="Forma libre 678"/>
                  <p:cNvSpPr/>
                  <p:nvPr/>
                </p:nvSpPr>
                <p:spPr>
                  <a:xfrm rot="2344901">
                    <a:off x="4014026" y="3134497"/>
                    <a:ext cx="285609" cy="53732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0" name="Forma libre 679"/>
                  <p:cNvSpPr/>
                  <p:nvPr/>
                </p:nvSpPr>
                <p:spPr>
                  <a:xfrm rot="17696783">
                    <a:off x="4179713" y="3308132"/>
                    <a:ext cx="249931" cy="97546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1" name="Forma libre 680"/>
                  <p:cNvSpPr/>
                  <p:nvPr/>
                </p:nvSpPr>
                <p:spPr>
                  <a:xfrm rot="2344901">
                    <a:off x="4197041" y="3072253"/>
                    <a:ext cx="247365" cy="58570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2" name="Forma libre 681"/>
                  <p:cNvSpPr/>
                  <p:nvPr/>
                </p:nvSpPr>
                <p:spPr>
                  <a:xfrm rot="17696783">
                    <a:off x="4326126" y="3225191"/>
                    <a:ext cx="186157" cy="72801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3" name="Forma libre 682"/>
                  <p:cNvSpPr/>
                  <p:nvPr/>
                </p:nvSpPr>
                <p:spPr>
                  <a:xfrm rot="2344901" flipV="1">
                    <a:off x="5420407" y="3422568"/>
                    <a:ext cx="239839" cy="4571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4" name="Forma libre 683"/>
                  <p:cNvSpPr/>
                  <p:nvPr/>
                </p:nvSpPr>
                <p:spPr>
                  <a:xfrm rot="7544013" flipV="1">
                    <a:off x="5404410" y="3247344"/>
                    <a:ext cx="166589" cy="80312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5" name="Forma libre 684"/>
                  <p:cNvSpPr/>
                  <p:nvPr/>
                </p:nvSpPr>
                <p:spPr>
                  <a:xfrm rot="2344901" flipV="1">
                    <a:off x="5199619" y="3398410"/>
                    <a:ext cx="356596" cy="92554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6" name="Forma libre 685"/>
                  <p:cNvSpPr/>
                  <p:nvPr/>
                </p:nvSpPr>
                <p:spPr>
                  <a:xfrm rot="7544013" flipV="1">
                    <a:off x="5219910" y="3151252"/>
                    <a:ext cx="215894" cy="103299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7" name="Forma libre 686"/>
                  <p:cNvSpPr/>
                  <p:nvPr/>
                </p:nvSpPr>
                <p:spPr>
                  <a:xfrm rot="2344901" flipV="1">
                    <a:off x="4964249" y="3339954"/>
                    <a:ext cx="437983" cy="129488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8" name="Forma libre 687"/>
                  <p:cNvSpPr/>
                  <p:nvPr/>
                </p:nvSpPr>
                <p:spPr>
                  <a:xfrm rot="7544013" flipV="1">
                    <a:off x="5052546" y="3086803"/>
                    <a:ext cx="269933" cy="112871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89" name="Forma libre 688"/>
                  <p:cNvSpPr/>
                  <p:nvPr/>
                </p:nvSpPr>
                <p:spPr>
                  <a:xfrm rot="2344901" flipV="1">
                    <a:off x="4786919" y="3284404"/>
                    <a:ext cx="437983" cy="129488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  <p:sp>
                <p:nvSpPr>
                  <p:cNvPr id="690" name="Forma libre 689"/>
                  <p:cNvSpPr/>
                  <p:nvPr/>
                </p:nvSpPr>
                <p:spPr>
                  <a:xfrm rot="7544013" flipV="1">
                    <a:off x="4911302" y="3036719"/>
                    <a:ext cx="280347" cy="127343"/>
                  </a:xfrm>
                  <a:custGeom>
                    <a:avLst/>
                    <a:gdLst>
                      <a:gd name="connsiteX0" fmla="*/ 0 w 193040"/>
                      <a:gd name="connsiteY0" fmla="*/ 66040 h 66040"/>
                      <a:gd name="connsiteX1" fmla="*/ 193040 w 193040"/>
                      <a:gd name="connsiteY1" fmla="*/ 0 h 660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</a:cxnLst>
                    <a:rect l="l" t="t" r="r" b="b"/>
                    <a:pathLst>
                      <a:path w="193040" h="66040">
                        <a:moveTo>
                          <a:pt x="0" y="66040"/>
                        </a:moveTo>
                        <a:lnTo>
                          <a:pt x="193040" y="0"/>
                        </a:lnTo>
                      </a:path>
                    </a:pathLst>
                  </a:custGeom>
                  <a:noFill/>
                  <a:ln>
                    <a:solidFill>
                      <a:schemeClr val="accent6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C"/>
                  </a:p>
                </p:txBody>
              </p:sp>
            </p:grpSp>
          </p:grpSp>
          <p:grpSp>
            <p:nvGrpSpPr>
              <p:cNvPr id="691" name="Grupo 690"/>
              <p:cNvGrpSpPr/>
              <p:nvPr/>
            </p:nvGrpSpPr>
            <p:grpSpPr>
              <a:xfrm flipH="1">
                <a:off x="4726612" y="2326629"/>
                <a:ext cx="283883" cy="770950"/>
                <a:chOff x="557332" y="4953000"/>
                <a:chExt cx="323273" cy="930345"/>
              </a:xfrm>
            </p:grpSpPr>
            <p:sp>
              <p:nvSpPr>
                <p:cNvPr id="692" name="Cilindro 691"/>
                <p:cNvSpPr/>
                <p:nvPr/>
              </p:nvSpPr>
              <p:spPr>
                <a:xfrm>
                  <a:off x="557332" y="5323620"/>
                  <a:ext cx="323273" cy="554183"/>
                </a:xfrm>
                <a:prstGeom prst="can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693" name="Rectángulo redondeado 692"/>
                <p:cNvSpPr/>
                <p:nvPr/>
              </p:nvSpPr>
              <p:spPr>
                <a:xfrm>
                  <a:off x="557332" y="5218326"/>
                  <a:ext cx="323273" cy="665019"/>
                </a:xfrm>
                <a:prstGeom prst="round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694" name="Cilindro 693"/>
                <p:cNvSpPr/>
                <p:nvPr/>
              </p:nvSpPr>
              <p:spPr>
                <a:xfrm>
                  <a:off x="601937" y="5112566"/>
                  <a:ext cx="234061" cy="120996"/>
                </a:xfrm>
                <a:prstGeom prst="can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695" name="Cilindro 694"/>
                <p:cNvSpPr/>
                <p:nvPr/>
              </p:nvSpPr>
              <p:spPr>
                <a:xfrm>
                  <a:off x="623653" y="5038436"/>
                  <a:ext cx="190542" cy="100830"/>
                </a:xfrm>
                <a:prstGeom prst="can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696" name="Cilindro 695"/>
                <p:cNvSpPr/>
                <p:nvPr/>
              </p:nvSpPr>
              <p:spPr>
                <a:xfrm>
                  <a:off x="654831" y="4953000"/>
                  <a:ext cx="127490" cy="108989"/>
                </a:xfrm>
                <a:prstGeom prst="can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697" name="Elipse 696"/>
                <p:cNvSpPr/>
                <p:nvPr/>
              </p:nvSpPr>
              <p:spPr>
                <a:xfrm>
                  <a:off x="673205" y="4971011"/>
                  <a:ext cx="45719" cy="45719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</p:grpSp>
          <p:cxnSp>
            <p:nvCxnSpPr>
              <p:cNvPr id="33" name="Conector recto 32"/>
              <p:cNvCxnSpPr/>
              <p:nvPr/>
            </p:nvCxnSpPr>
            <p:spPr>
              <a:xfrm flipV="1">
                <a:off x="4936573" y="2285797"/>
                <a:ext cx="423392" cy="83304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8" name="Conector recto 697"/>
              <p:cNvCxnSpPr/>
              <p:nvPr/>
            </p:nvCxnSpPr>
            <p:spPr>
              <a:xfrm>
                <a:off x="4942152" y="2371520"/>
                <a:ext cx="363182" cy="2975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9" name="Conector recto 698"/>
              <p:cNvCxnSpPr/>
              <p:nvPr/>
            </p:nvCxnSpPr>
            <p:spPr>
              <a:xfrm>
                <a:off x="4938962" y="2370269"/>
                <a:ext cx="370359" cy="173793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0" name="Conector recto 699"/>
              <p:cNvCxnSpPr/>
              <p:nvPr/>
            </p:nvCxnSpPr>
            <p:spPr>
              <a:xfrm>
                <a:off x="4942463" y="2374240"/>
                <a:ext cx="304216" cy="268208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1" name="Conector recto 700"/>
              <p:cNvCxnSpPr/>
              <p:nvPr/>
            </p:nvCxnSpPr>
            <p:spPr>
              <a:xfrm>
                <a:off x="4946179" y="2374240"/>
                <a:ext cx="356580" cy="86354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2" name="Conector recto 701"/>
              <p:cNvCxnSpPr/>
              <p:nvPr/>
            </p:nvCxnSpPr>
            <p:spPr>
              <a:xfrm>
                <a:off x="4942591" y="2372944"/>
                <a:ext cx="334809" cy="221239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3" name="Conector recto 702"/>
              <p:cNvCxnSpPr/>
              <p:nvPr/>
            </p:nvCxnSpPr>
            <p:spPr>
              <a:xfrm flipV="1">
                <a:off x="4954321" y="2345616"/>
                <a:ext cx="379646" cy="23321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mc:AlternateContent xmlns:mc="http://schemas.openxmlformats.org/markup-compatibility/2006" xmlns:p14="http://schemas.microsoft.com/office/powerpoint/2010/main">
            <mc:Choice Requires="p14">
              <p:contentPart p14:bwMode="auto" r:id="rId2">
                <p14:nvContentPartPr>
                  <p14:cNvPr id="705" name="Entrada de lápiz 704"/>
                  <p14:cNvContentPartPr/>
                  <p14:nvPr/>
                </p14:nvContentPartPr>
                <p14:xfrm>
                  <a:off x="5330551" y="2337892"/>
                  <a:ext cx="544488" cy="362741"/>
                </p14:xfrm>
              </p:contentPart>
            </mc:Choice>
            <mc:Fallback xmlns="">
              <p:pic>
                <p:nvPicPr>
                  <p:cNvPr id="705" name="Entrada de lápiz 704"/>
                  <p:cNvPicPr/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5302121" y="2309463"/>
                    <a:ext cx="601348" cy="419599"/>
                  </a:xfrm>
                  <a:prstGeom prst="rect">
                    <a:avLst/>
                  </a:prstGeom>
                </p:spPr>
              </p:pic>
            </mc:Fallback>
          </mc:AlternateContent>
          <p:cxnSp>
            <p:nvCxnSpPr>
              <p:cNvPr id="71" name="Conector recto 70"/>
              <p:cNvCxnSpPr>
                <a:endCxn id="393" idx="0"/>
              </p:cNvCxnSpPr>
              <p:nvPr/>
            </p:nvCxnSpPr>
            <p:spPr>
              <a:xfrm flipV="1">
                <a:off x="5824166" y="2308746"/>
                <a:ext cx="1831839" cy="32110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ector recto 73"/>
              <p:cNvCxnSpPr/>
              <p:nvPr/>
            </p:nvCxnSpPr>
            <p:spPr>
              <a:xfrm>
                <a:off x="5818728" y="2621475"/>
                <a:ext cx="1341868" cy="59459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mc:AlternateContent xmlns:mc="http://schemas.openxmlformats.org/markup-compatibility/2006" xmlns:p14="http://schemas.microsoft.com/office/powerpoint/2010/main">
            <mc:Choice Requires="p14">
              <p:contentPart p14:bwMode="auto" r:id="rId5">
                <p14:nvContentPartPr>
                  <p14:cNvPr id="711" name="Entrada de lápiz 710"/>
                  <p14:cNvContentPartPr/>
                  <p14:nvPr/>
                </p14:nvContentPartPr>
                <p14:xfrm>
                  <a:off x="4651537" y="4660602"/>
                  <a:ext cx="544488" cy="362741"/>
                </p14:xfrm>
              </p:contentPart>
            </mc:Choice>
            <mc:Fallback xmlns="">
              <p:pic>
                <p:nvPicPr>
                  <p:cNvPr id="711" name="Entrada de lápiz 710"/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4623088" y="4632173"/>
                    <a:ext cx="601386" cy="419599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7">
                <p14:nvContentPartPr>
                  <p14:cNvPr id="712" name="Entrada de lápiz 711"/>
                  <p14:cNvContentPartPr/>
                  <p14:nvPr/>
                </p14:nvContentPartPr>
                <p14:xfrm>
                  <a:off x="5244715" y="4873047"/>
                  <a:ext cx="544488" cy="362741"/>
                </p14:xfrm>
              </p:contentPart>
            </mc:Choice>
            <mc:Fallback xmlns="">
              <p:pic>
                <p:nvPicPr>
                  <p:cNvPr id="712" name="Entrada de lápiz 711"/>
                  <p:cNvPicPr/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5216266" y="4844618"/>
                    <a:ext cx="601386" cy="419599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9">
                <p14:nvContentPartPr>
                  <p14:cNvPr id="713" name="Entrada de lápiz 712"/>
                  <p14:cNvContentPartPr/>
                  <p14:nvPr/>
                </p14:nvContentPartPr>
                <p14:xfrm>
                  <a:off x="5935652" y="4853236"/>
                  <a:ext cx="544488" cy="362741"/>
                </p14:xfrm>
              </p:contentPart>
            </mc:Choice>
            <mc:Fallback xmlns="">
              <p:pic>
                <p:nvPicPr>
                  <p:cNvPr id="713" name="Entrada de lápiz 712"/>
                  <p:cNvPicPr/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5907203" y="4824807"/>
                    <a:ext cx="601386" cy="419599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0">
                <p14:nvContentPartPr>
                  <p14:cNvPr id="714" name="Entrada de lápiz 713"/>
                  <p14:cNvContentPartPr/>
                  <p14:nvPr/>
                </p14:nvContentPartPr>
                <p14:xfrm>
                  <a:off x="6545561" y="4668883"/>
                  <a:ext cx="544488" cy="362741"/>
                </p14:xfrm>
              </p:contentPart>
            </mc:Choice>
            <mc:Fallback xmlns="">
              <p:pic>
                <p:nvPicPr>
                  <p:cNvPr id="714" name="Entrada de lápiz 713"/>
                  <p:cNvPicPr/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6517131" y="4640454"/>
                    <a:ext cx="601348" cy="419599"/>
                  </a:xfrm>
                  <a:prstGeom prst="rect">
                    <a:avLst/>
                  </a:prstGeom>
                </p:spPr>
              </p:pic>
            </mc:Fallback>
          </mc:AlternateContent>
          <mc:AlternateContent xmlns:mc="http://schemas.openxmlformats.org/markup-compatibility/2006" xmlns:p14="http://schemas.microsoft.com/office/powerpoint/2010/main">
            <mc:Choice Requires="p14">
              <p:contentPart p14:bwMode="auto" r:id="rId11">
                <p14:nvContentPartPr>
                  <p14:cNvPr id="715" name="Entrada de lápiz 714"/>
                  <p14:cNvContentPartPr/>
                  <p14:nvPr/>
                </p14:nvContentPartPr>
                <p14:xfrm>
                  <a:off x="7126811" y="4493928"/>
                  <a:ext cx="544488" cy="362741"/>
                </p14:xfrm>
              </p:contentPart>
            </mc:Choice>
            <mc:Fallback xmlns="">
              <p:pic>
                <p:nvPicPr>
                  <p:cNvPr id="715" name="Entrada de lápiz 714"/>
                  <p:cNvPicPr/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7098362" y="4465499"/>
                    <a:ext cx="601386" cy="419599"/>
                  </a:xfrm>
                  <a:prstGeom prst="rect">
                    <a:avLst/>
                  </a:prstGeom>
                </p:spPr>
              </p:pic>
            </mc:Fallback>
          </mc:AlternateContent>
          <p:sp>
            <p:nvSpPr>
              <p:cNvPr id="710" name="CuadroTexto 709"/>
              <p:cNvSpPr txBox="1"/>
              <p:nvPr/>
            </p:nvSpPr>
            <p:spPr>
              <a:xfrm>
                <a:off x="3882280" y="3134475"/>
                <a:ext cx="13059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C" sz="1200" dirty="0"/>
                  <a:t>Foliar application</a:t>
                </a:r>
              </a:p>
            </p:txBody>
          </p:sp>
          <p:sp>
            <p:nvSpPr>
              <p:cNvPr id="717" name="CuadroTexto 716"/>
              <p:cNvSpPr txBox="1"/>
              <p:nvPr/>
            </p:nvSpPr>
            <p:spPr>
              <a:xfrm>
                <a:off x="4848072" y="3740493"/>
                <a:ext cx="13167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C" sz="1200" dirty="0"/>
                  <a:t>Soil application</a:t>
                </a:r>
              </a:p>
            </p:txBody>
          </p:sp>
          <p:cxnSp>
            <p:nvCxnSpPr>
              <p:cNvPr id="718" name="Conector recto 717"/>
              <p:cNvCxnSpPr/>
              <p:nvPr/>
            </p:nvCxnSpPr>
            <p:spPr>
              <a:xfrm flipH="1">
                <a:off x="7664265" y="3114143"/>
                <a:ext cx="525253" cy="1554063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0" name="Conector recto 719"/>
              <p:cNvCxnSpPr/>
              <p:nvPr/>
            </p:nvCxnSpPr>
            <p:spPr>
              <a:xfrm flipH="1" flipV="1">
                <a:off x="7130064" y="3142663"/>
                <a:ext cx="541237" cy="1500103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54" name="Grupo 753"/>
              <p:cNvGrpSpPr/>
              <p:nvPr/>
            </p:nvGrpSpPr>
            <p:grpSpPr>
              <a:xfrm>
                <a:off x="4380444" y="3833620"/>
                <a:ext cx="904873" cy="788843"/>
                <a:chOff x="8689287" y="2204546"/>
                <a:chExt cx="1758585" cy="1118817"/>
              </a:xfrm>
            </p:grpSpPr>
            <p:cxnSp>
              <p:nvCxnSpPr>
                <p:cNvPr id="725" name="Conector recto 724"/>
                <p:cNvCxnSpPr/>
                <p:nvPr/>
              </p:nvCxnSpPr>
              <p:spPr>
                <a:xfrm flipH="1" flipV="1">
                  <a:off x="9114306" y="2224147"/>
                  <a:ext cx="281901" cy="136031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9" name="Conector recto 728"/>
                <p:cNvCxnSpPr/>
                <p:nvPr/>
              </p:nvCxnSpPr>
              <p:spPr>
                <a:xfrm flipH="1">
                  <a:off x="8689287" y="2204546"/>
                  <a:ext cx="482064" cy="515379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1" name="Conector recto 730"/>
                <p:cNvCxnSpPr/>
                <p:nvPr/>
              </p:nvCxnSpPr>
              <p:spPr>
                <a:xfrm>
                  <a:off x="8710138" y="2673304"/>
                  <a:ext cx="190930" cy="111304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3" name="Rectángulo redondeado 722"/>
                <p:cNvSpPr/>
                <p:nvPr/>
              </p:nvSpPr>
              <p:spPr>
                <a:xfrm rot="2960353">
                  <a:off x="9045846" y="2176982"/>
                  <a:ext cx="544408" cy="1171603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cxnSp>
              <p:nvCxnSpPr>
                <p:cNvPr id="747" name="Conector recto 746"/>
                <p:cNvCxnSpPr/>
                <p:nvPr/>
              </p:nvCxnSpPr>
              <p:spPr>
                <a:xfrm flipH="1" flipV="1">
                  <a:off x="9571975" y="2625858"/>
                  <a:ext cx="681296" cy="459042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9" name="Conector recto 748"/>
                <p:cNvCxnSpPr/>
                <p:nvPr/>
              </p:nvCxnSpPr>
              <p:spPr>
                <a:xfrm flipH="1" flipV="1">
                  <a:off x="9426103" y="2927974"/>
                  <a:ext cx="661952" cy="40294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8" name="Triángulo isósceles 747"/>
                <p:cNvSpPr/>
                <p:nvPr/>
              </p:nvSpPr>
              <p:spPr>
                <a:xfrm rot="18732099">
                  <a:off x="10002964" y="2923042"/>
                  <a:ext cx="464820" cy="335821"/>
                </a:xfrm>
                <a:prstGeom prst="triangle">
                  <a:avLst/>
                </a:prstGeom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753" name="Elipse 752"/>
                <p:cNvSpPr/>
                <p:nvPr/>
              </p:nvSpPr>
              <p:spPr>
                <a:xfrm>
                  <a:off x="10263520" y="3160337"/>
                  <a:ext cx="45720" cy="45719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757" name="Elipse 756"/>
                <p:cNvSpPr/>
                <p:nvPr/>
              </p:nvSpPr>
              <p:spPr>
                <a:xfrm>
                  <a:off x="10304795" y="3127164"/>
                  <a:ext cx="45720" cy="45719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758" name="Elipse 757"/>
                <p:cNvSpPr/>
                <p:nvPr/>
              </p:nvSpPr>
              <p:spPr>
                <a:xfrm>
                  <a:off x="10353475" y="3091255"/>
                  <a:ext cx="45720" cy="45719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759" name="Elipse 758"/>
                <p:cNvSpPr/>
                <p:nvPr/>
              </p:nvSpPr>
              <p:spPr>
                <a:xfrm>
                  <a:off x="10402152" y="3050574"/>
                  <a:ext cx="45720" cy="45719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760" name="Elipse 759"/>
                <p:cNvSpPr/>
                <p:nvPr/>
              </p:nvSpPr>
              <p:spPr>
                <a:xfrm>
                  <a:off x="10214842" y="3201775"/>
                  <a:ext cx="45720" cy="45719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  <p:sp>
              <p:nvSpPr>
                <p:cNvPr id="761" name="Elipse 760"/>
                <p:cNvSpPr/>
                <p:nvPr/>
              </p:nvSpPr>
              <p:spPr>
                <a:xfrm>
                  <a:off x="10173567" y="3240283"/>
                  <a:ext cx="45720" cy="45719"/>
                </a:xfrm>
                <a:prstGeom prst="ellipse">
                  <a:avLst/>
                </a:prstGeom>
                <a:solidFill>
                  <a:schemeClr val="bg1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C"/>
                </a:p>
              </p:txBody>
            </p:sp>
          </p:grpSp>
          <p:sp>
            <p:nvSpPr>
              <p:cNvPr id="763" name="Lágrima 762"/>
              <p:cNvSpPr/>
              <p:nvPr/>
            </p:nvSpPr>
            <p:spPr>
              <a:xfrm rot="15900000">
                <a:off x="5286153" y="4532244"/>
                <a:ext cx="76221" cy="79314"/>
              </a:xfrm>
              <a:prstGeom prst="teardrop">
                <a:avLst>
                  <a:gd name="adj" fmla="val 132000"/>
                </a:avLst>
              </a:prstGeom>
              <a:solidFill>
                <a:schemeClr val="accent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sp>
            <p:nvSpPr>
              <p:cNvPr id="764" name="Lágrima 763"/>
              <p:cNvSpPr/>
              <p:nvPr/>
            </p:nvSpPr>
            <p:spPr>
              <a:xfrm rot="18931067">
                <a:off x="5315104" y="4704920"/>
                <a:ext cx="76221" cy="79314"/>
              </a:xfrm>
              <a:prstGeom prst="teardrop">
                <a:avLst>
                  <a:gd name="adj" fmla="val 132000"/>
                </a:avLst>
              </a:prstGeom>
              <a:solidFill>
                <a:schemeClr val="accent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</p:grpSp>
        <p:grpSp>
          <p:nvGrpSpPr>
            <p:cNvPr id="392" name="Grupo 391"/>
            <p:cNvGrpSpPr/>
            <p:nvPr/>
          </p:nvGrpSpPr>
          <p:grpSpPr>
            <a:xfrm>
              <a:off x="7073136" y="2308746"/>
              <a:ext cx="1165738" cy="1165738"/>
              <a:chOff x="6807963" y="2374891"/>
              <a:chExt cx="1165738" cy="1165738"/>
            </a:xfrm>
            <a:solidFill>
              <a:schemeClr val="accent4">
                <a:lumMod val="40000"/>
                <a:lumOff val="60000"/>
              </a:schemeClr>
            </a:solidFill>
          </p:grpSpPr>
          <p:sp>
            <p:nvSpPr>
              <p:cNvPr id="393" name="Elipse 392"/>
              <p:cNvSpPr/>
              <p:nvPr/>
            </p:nvSpPr>
            <p:spPr>
              <a:xfrm>
                <a:off x="6807963" y="2374891"/>
                <a:ext cx="1165738" cy="1165738"/>
              </a:xfrm>
              <a:prstGeom prst="ellips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s-EC"/>
              </a:p>
            </p:txBody>
          </p:sp>
          <p:grpSp>
            <p:nvGrpSpPr>
              <p:cNvPr id="394" name="Grupo 393"/>
              <p:cNvGrpSpPr/>
              <p:nvPr/>
            </p:nvGrpSpPr>
            <p:grpSpPr>
              <a:xfrm>
                <a:off x="6863301" y="2537414"/>
                <a:ext cx="994598" cy="783572"/>
                <a:chOff x="6302606" y="3669374"/>
                <a:chExt cx="994598" cy="783572"/>
              </a:xfrm>
              <a:grpFill/>
            </p:grpSpPr>
            <p:sp>
              <p:nvSpPr>
                <p:cNvPr id="395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630386" y="3986874"/>
                  <a:ext cx="182563" cy="104775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6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6447823" y="3985287"/>
                  <a:ext cx="182563" cy="106363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7" name="Line 166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447823" y="3775736"/>
                  <a:ext cx="1588" cy="209550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8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447823" y="3669374"/>
                  <a:ext cx="182563" cy="106363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399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6630386" y="3669374"/>
                  <a:ext cx="182563" cy="106363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00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812949" y="3775736"/>
                  <a:ext cx="1588" cy="211138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1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996571" y="3990040"/>
                  <a:ext cx="182563" cy="104775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2" name="Line 165"/>
                <p:cNvSpPr>
                  <a:spLocks noChangeAspect="1" noChangeShapeType="1"/>
                </p:cNvSpPr>
                <p:nvPr/>
              </p:nvSpPr>
              <p:spPr bwMode="auto">
                <a:xfrm flipH="1" flipV="1">
                  <a:off x="6814008" y="3988453"/>
                  <a:ext cx="182563" cy="106363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5" name="Line 167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814008" y="3677620"/>
                  <a:ext cx="182563" cy="106363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6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6992761" y="3681430"/>
                  <a:ext cx="182563" cy="106363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37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180150" y="3783982"/>
                  <a:ext cx="1588" cy="211138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1" name="Line 168"/>
                <p:cNvSpPr>
                  <a:spLocks noChangeAspect="1" noChangeShapeType="1"/>
                </p:cNvSpPr>
                <p:nvPr/>
              </p:nvSpPr>
              <p:spPr bwMode="auto">
                <a:xfrm>
                  <a:off x="6624834" y="4309903"/>
                  <a:ext cx="182563" cy="106363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2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6622766" y="4089720"/>
                  <a:ext cx="1588" cy="211138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43" name="Line 163"/>
                <p:cNvSpPr>
                  <a:spLocks noChangeAspect="1" noChangeShapeType="1"/>
                </p:cNvSpPr>
                <p:nvPr/>
              </p:nvSpPr>
              <p:spPr bwMode="auto">
                <a:xfrm flipH="1">
                  <a:off x="6815278" y="4307834"/>
                  <a:ext cx="182563" cy="104775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1" name="Line 169"/>
                <p:cNvSpPr>
                  <a:spLocks noChangeAspect="1" noChangeShapeType="1"/>
                </p:cNvSpPr>
                <p:nvPr/>
              </p:nvSpPr>
              <p:spPr bwMode="auto">
                <a:xfrm flipV="1">
                  <a:off x="7001651" y="4096395"/>
                  <a:ext cx="0" cy="211439"/>
                </a:xfrm>
                <a:prstGeom prst="line">
                  <a:avLst/>
                </a:prstGeom>
                <a:grpFill/>
                <a:ln w="11113" cap="rnd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54" name="Freeform 180"/>
                <p:cNvSpPr>
                  <a:spLocks noChangeAspect="1"/>
                </p:cNvSpPr>
                <p:nvPr/>
              </p:nvSpPr>
              <p:spPr bwMode="auto">
                <a:xfrm rot="11640000">
                  <a:off x="6302606" y="3967030"/>
                  <a:ext cx="128588" cy="193675"/>
                </a:xfrm>
                <a:custGeom>
                  <a:avLst/>
                  <a:gdLst/>
                  <a:ahLst/>
                  <a:cxnLst>
                    <a:cxn ang="0">
                      <a:pos x="93" y="0"/>
                    </a:cxn>
                    <a:cxn ang="0">
                      <a:pos x="134" y="24"/>
                    </a:cxn>
                    <a:cxn ang="0">
                      <a:pos x="9" y="201"/>
                    </a:cxn>
                    <a:cxn ang="0">
                      <a:pos x="3" y="203"/>
                    </a:cxn>
                    <a:cxn ang="0">
                      <a:pos x="0" y="200"/>
                    </a:cxn>
                    <a:cxn ang="0">
                      <a:pos x="93" y="0"/>
                    </a:cxn>
                  </a:cxnLst>
                  <a:rect l="0" t="0" r="r" b="b"/>
                  <a:pathLst>
                    <a:path w="134" h="203">
                      <a:moveTo>
                        <a:pt x="93" y="0"/>
                      </a:moveTo>
                      <a:lnTo>
                        <a:pt x="134" y="24"/>
                      </a:lnTo>
                      <a:lnTo>
                        <a:pt x="9" y="201"/>
                      </a:lnTo>
                      <a:lnTo>
                        <a:pt x="3" y="203"/>
                      </a:lnTo>
                      <a:lnTo>
                        <a:pt x="0" y="200"/>
                      </a:lnTo>
                      <a:lnTo>
                        <a:pt x="93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2" name="Freeform 180"/>
                <p:cNvSpPr>
                  <a:spLocks noChangeAspect="1"/>
                </p:cNvSpPr>
                <p:nvPr/>
              </p:nvSpPr>
              <p:spPr bwMode="auto">
                <a:xfrm rot="6120000">
                  <a:off x="7019748" y="4291814"/>
                  <a:ext cx="128588" cy="193675"/>
                </a:xfrm>
                <a:custGeom>
                  <a:avLst/>
                  <a:gdLst/>
                  <a:ahLst/>
                  <a:cxnLst>
                    <a:cxn ang="0">
                      <a:pos x="93" y="0"/>
                    </a:cxn>
                    <a:cxn ang="0">
                      <a:pos x="134" y="24"/>
                    </a:cxn>
                    <a:cxn ang="0">
                      <a:pos x="9" y="201"/>
                    </a:cxn>
                    <a:cxn ang="0">
                      <a:pos x="3" y="203"/>
                    </a:cxn>
                    <a:cxn ang="0">
                      <a:pos x="0" y="200"/>
                    </a:cxn>
                    <a:cxn ang="0">
                      <a:pos x="93" y="0"/>
                    </a:cxn>
                  </a:cxnLst>
                  <a:rect l="0" t="0" r="r" b="b"/>
                  <a:pathLst>
                    <a:path w="134" h="203">
                      <a:moveTo>
                        <a:pt x="93" y="0"/>
                      </a:moveTo>
                      <a:lnTo>
                        <a:pt x="134" y="24"/>
                      </a:lnTo>
                      <a:lnTo>
                        <a:pt x="9" y="201"/>
                      </a:lnTo>
                      <a:lnTo>
                        <a:pt x="3" y="203"/>
                      </a:lnTo>
                      <a:lnTo>
                        <a:pt x="0" y="200"/>
                      </a:lnTo>
                      <a:lnTo>
                        <a:pt x="93" y="0"/>
                      </a:lnTo>
                      <a:close/>
                    </a:path>
                  </a:pathLst>
                </a:custGeom>
                <a:solidFill>
                  <a:schemeClr val="tx1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467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6522420" y="3739610"/>
                  <a:ext cx="84138" cy="153988"/>
                </a:xfrm>
                <a:prstGeom prst="rect">
                  <a:avLst/>
                </a:prstGeom>
                <a:grp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69" name="Rectangle 157"/>
                <p:cNvSpPr>
                  <a:spLocks noChangeAspect="1" noChangeArrowheads="1"/>
                </p:cNvSpPr>
                <p:nvPr/>
              </p:nvSpPr>
              <p:spPr bwMode="auto">
                <a:xfrm>
                  <a:off x="6654163" y="3822688"/>
                  <a:ext cx="84138" cy="153988"/>
                </a:xfrm>
                <a:prstGeom prst="rect">
                  <a:avLst/>
                </a:prstGeom>
                <a:grp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O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472" name="Conector recto 471"/>
                <p:cNvCxnSpPr>
                  <a:stCxn id="398" idx="0"/>
                  <a:endCxn id="467" idx="1"/>
                </p:cNvCxnSpPr>
                <p:nvPr/>
              </p:nvCxnSpPr>
              <p:spPr>
                <a:xfrm>
                  <a:off x="6447823" y="3775737"/>
                  <a:ext cx="74597" cy="40867"/>
                </a:xfrm>
                <a:prstGeom prst="line">
                  <a:avLst/>
                </a:prstGeom>
                <a:grpFill/>
                <a:ln>
                  <a:prstDash val="sysDot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75" name="Conector recto 474"/>
                <p:cNvCxnSpPr/>
                <p:nvPr/>
              </p:nvCxnSpPr>
              <p:spPr>
                <a:xfrm>
                  <a:off x="6577363" y="3847873"/>
                  <a:ext cx="74597" cy="40867"/>
                </a:xfrm>
                <a:prstGeom prst="line">
                  <a:avLst/>
                </a:prstGeom>
                <a:grpFill/>
                <a:ln>
                  <a:prstDash val="sysDot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77" name="Conector recto 476"/>
                <p:cNvCxnSpPr/>
                <p:nvPr/>
              </p:nvCxnSpPr>
              <p:spPr>
                <a:xfrm>
                  <a:off x="6722143" y="3934233"/>
                  <a:ext cx="74597" cy="40867"/>
                </a:xfrm>
                <a:prstGeom prst="line">
                  <a:avLst/>
                </a:prstGeom>
                <a:grpFill/>
                <a:ln>
                  <a:prstDash val="sysDot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84" name="Conector recto 483"/>
                <p:cNvCxnSpPr/>
                <p:nvPr/>
              </p:nvCxnSpPr>
              <p:spPr>
                <a:xfrm>
                  <a:off x="7008655" y="4104921"/>
                  <a:ext cx="181699" cy="90368"/>
                </a:xfrm>
                <a:prstGeom prst="line">
                  <a:avLst/>
                </a:prstGeom>
                <a:grpFill/>
                <a:ln>
                  <a:prstDash val="sysDot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85" name="Rectangle 158"/>
                <p:cNvSpPr>
                  <a:spLocks noChangeAspect="1" noChangeArrowheads="1"/>
                </p:cNvSpPr>
                <p:nvPr/>
              </p:nvSpPr>
              <p:spPr bwMode="auto">
                <a:xfrm>
                  <a:off x="7217829" y="4146870"/>
                  <a:ext cx="79375" cy="153988"/>
                </a:xfrm>
                <a:prstGeom prst="rect">
                  <a:avLst/>
                </a:prstGeom>
                <a:grp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prstTxWarp prst="textNoShape">
                    <a:avLst/>
                  </a:prstTxWarp>
                  <a:spAutoFit/>
                </a:bodyPr>
                <a:lstStyle/>
                <a:p>
                  <a:pPr eaLnBrk="1" hangingPunct="1"/>
                  <a:r>
                    <a:rPr lang="en-US" sz="1000" dirty="0">
                      <a:ea typeface="Arial" charset="0"/>
                      <a:cs typeface="Arial" charset="0"/>
                    </a:rPr>
                    <a:t>H</a:t>
                  </a:r>
                  <a:endParaRPr lang="en-US" dirty="0">
                    <a:ea typeface="Arial" charset="0"/>
                    <a:cs typeface="Arial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0728592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41</TotalTime>
  <Words>81</Words>
  <Application>Microsoft Office PowerPoint</Application>
  <PresentationFormat>Widescreen</PresentationFormat>
  <Paragraphs>6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Sangeetha Nanda Gopal</cp:lastModifiedBy>
  <cp:revision>118</cp:revision>
  <dcterms:created xsi:type="dcterms:W3CDTF">2022-11-22T10:30:00Z</dcterms:created>
  <dcterms:modified xsi:type="dcterms:W3CDTF">2023-05-08T13:35:18Z</dcterms:modified>
</cp:coreProperties>
</file>